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ppt/theme/themeOverride9.xml" ContentType="application/vnd.openxmlformats-officedocument.themeOverride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theme/themeOverride10.xml" ContentType="application/vnd.openxmlformats-officedocument.themeOverride+xml"/>
  <Override PartName="/ppt/drawings/drawing10.xml" ContentType="application/vnd.openxmlformats-officedocument.drawingml.chartshapes+xml"/>
  <Override PartName="/ppt/charts/chart11.xml" ContentType="application/vnd.openxmlformats-officedocument.drawingml.chart+xml"/>
  <Override PartName="/ppt/theme/themeOverride11.xml" ContentType="application/vnd.openxmlformats-officedocument.themeOverride+xml"/>
  <Override PartName="/ppt/drawings/drawing1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2.xml" ContentType="application/vnd.ms-office.chartstyle+xml"/>
  <Override PartName="/ppt/charts/colors12.xml" ContentType="application/vnd.ms-office.chartcolorstyle+xml"/>
  <Override PartName="/ppt/charts/style13.xml" ContentType="application/vnd.ms-office.chartstyle+xml"/>
  <Override PartName="/ppt/charts/colors13.xml" ContentType="application/vnd.ms-office.chartcolorstyle+xml"/>
  <Override PartName="/ppt/charts/style14.xml" ContentType="application/vnd.ms-office.chartstyle+xml"/>
  <Override PartName="/ppt/charts/colors14.xml" ContentType="application/vnd.ms-office.chartcolorstyle+xml"/>
  <Override PartName="/ppt/charts/style15.xml" ContentType="application/vnd.ms-office.chartstyle+xml"/>
  <Override PartName="/ppt/charts/colors15.xml" ContentType="application/vnd.ms-office.chartcolorstyle+xml"/>
  <Override PartName="/ppt/charts/style16.xml" ContentType="application/vnd.ms-office.chartstyle+xml"/>
  <Override PartName="/ppt/charts/colors16.xml" ContentType="application/vnd.ms-office.chartcolorstyle+xml"/>
  <Override PartName="/ppt/charts/style17.xml" ContentType="application/vnd.ms-office.chartstyle+xml"/>
  <Override PartName="/ppt/charts/colors17.xml" ContentType="application/vnd.ms-office.chartcolorstyle+xml"/>
  <Override PartName="/ppt/charts/style18.xml" ContentType="application/vnd.ms-office.chartstyle+xml"/>
  <Override PartName="/ppt/charts/colors18.xml" ContentType="application/vnd.ms-office.chartcolorstyle+xml"/>
  <Override PartName="/ppt/charts/style19.xml" ContentType="application/vnd.ms-office.chartstyle+xml"/>
  <Override PartName="/ppt/charts/colors19.xml" ContentType="application/vnd.ms-office.chartcolorstyle+xml"/>
  <Override PartName="/ppt/charts/style20.xml" ContentType="application/vnd.ms-office.chartstyle+xml"/>
  <Override PartName="/ppt/charts/colors20.xml" ContentType="application/vnd.ms-office.chartcolorstyle+xml"/>
  <Override PartName="/ppt/charts/style21.xml" ContentType="application/vnd.ms-office.chartstyle+xml"/>
  <Override PartName="/ppt/charts/colors21.xml" ContentType="application/vnd.ms-office.chartcolorstyle+xml"/>
  <Override PartName="/ppt/charts/style22.xml" ContentType="application/vnd.ms-office.chartstyle+xml"/>
  <Override PartName="/ppt/charts/colors22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76" r:id="rId3"/>
    <p:sldId id="275" r:id="rId4"/>
    <p:sldId id="274" r:id="rId5"/>
    <p:sldId id="273" r:id="rId6"/>
    <p:sldId id="272" r:id="rId7"/>
    <p:sldId id="271" r:id="rId8"/>
    <p:sldId id="268" r:id="rId9"/>
    <p:sldId id="270" r:id="rId10"/>
    <p:sldId id="269" r:id="rId11"/>
    <p:sldId id="266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481" autoAdjust="0"/>
    <p:restoredTop sz="94660"/>
  </p:normalViewPr>
  <p:slideViewPr>
    <p:cSldViewPr snapToGrid="0">
      <p:cViewPr>
        <p:scale>
          <a:sx n="125" d="100"/>
          <a:sy n="125" d="100"/>
        </p:scale>
        <p:origin x="-784" y="-19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printerSettings" Target="printerSettings/printerSettings1.bin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4" Type="http://schemas.microsoft.com/office/2011/relationships/chartStyle" Target="style12.xml"/><Relationship Id="rId5" Type="http://schemas.microsoft.com/office/2011/relationships/chartColorStyle" Target="colors12.xml"/><Relationship Id="rId1" Type="http://schemas.openxmlformats.org/officeDocument/2006/relationships/themeOverride" Target="../theme/themeOverride1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0.xml"/><Relationship Id="rId4" Type="http://schemas.microsoft.com/office/2011/relationships/chartStyle" Target="style21.xml"/><Relationship Id="rId5" Type="http://schemas.microsoft.com/office/2011/relationships/chartColorStyle" Target="colors21.xml"/><Relationship Id="rId1" Type="http://schemas.openxmlformats.org/officeDocument/2006/relationships/themeOverride" Target="../theme/themeOverride10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1.xml"/><Relationship Id="rId4" Type="http://schemas.microsoft.com/office/2011/relationships/chartStyle" Target="style22.xml"/><Relationship Id="rId5" Type="http://schemas.microsoft.com/office/2011/relationships/chartColorStyle" Target="colors22.xml"/><Relationship Id="rId1" Type="http://schemas.openxmlformats.org/officeDocument/2006/relationships/themeOverride" Target="../theme/themeOverride11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4" Type="http://schemas.microsoft.com/office/2011/relationships/chartStyle" Target="style13.xml"/><Relationship Id="rId5" Type="http://schemas.microsoft.com/office/2011/relationships/chartColorStyle" Target="colors13.xml"/><Relationship Id="rId1" Type="http://schemas.openxmlformats.org/officeDocument/2006/relationships/themeOverride" Target="../theme/themeOverride2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3.xml"/><Relationship Id="rId4" Type="http://schemas.microsoft.com/office/2011/relationships/chartStyle" Target="style14.xml"/><Relationship Id="rId5" Type="http://schemas.microsoft.com/office/2011/relationships/chartColorStyle" Target="colors14.xml"/><Relationship Id="rId1" Type="http://schemas.openxmlformats.org/officeDocument/2006/relationships/themeOverride" Target="../theme/themeOverride3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4.xml"/><Relationship Id="rId4" Type="http://schemas.microsoft.com/office/2011/relationships/chartStyle" Target="style15.xml"/><Relationship Id="rId5" Type="http://schemas.microsoft.com/office/2011/relationships/chartColorStyle" Target="colors15.xml"/><Relationship Id="rId1" Type="http://schemas.openxmlformats.org/officeDocument/2006/relationships/themeOverride" Target="../theme/themeOverride4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5.xml"/><Relationship Id="rId4" Type="http://schemas.microsoft.com/office/2011/relationships/chartStyle" Target="style16.xml"/><Relationship Id="rId5" Type="http://schemas.microsoft.com/office/2011/relationships/chartColorStyle" Target="colors16.xml"/><Relationship Id="rId1" Type="http://schemas.openxmlformats.org/officeDocument/2006/relationships/themeOverride" Target="../theme/themeOverride5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6.xml"/><Relationship Id="rId4" Type="http://schemas.microsoft.com/office/2011/relationships/chartStyle" Target="style17.xml"/><Relationship Id="rId5" Type="http://schemas.microsoft.com/office/2011/relationships/chartColorStyle" Target="colors17.xml"/><Relationship Id="rId1" Type="http://schemas.openxmlformats.org/officeDocument/2006/relationships/themeOverride" Target="../theme/themeOverride6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7.xml"/><Relationship Id="rId4" Type="http://schemas.microsoft.com/office/2011/relationships/chartStyle" Target="style18.xml"/><Relationship Id="rId5" Type="http://schemas.microsoft.com/office/2011/relationships/chartColorStyle" Target="colors18.xml"/><Relationship Id="rId1" Type="http://schemas.openxmlformats.org/officeDocument/2006/relationships/themeOverride" Target="../theme/themeOverride7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8.xml"/><Relationship Id="rId4" Type="http://schemas.microsoft.com/office/2011/relationships/chartStyle" Target="style19.xml"/><Relationship Id="rId5" Type="http://schemas.microsoft.com/office/2011/relationships/chartColorStyle" Target="colors19.xml"/><Relationship Id="rId1" Type="http://schemas.openxmlformats.org/officeDocument/2006/relationships/themeOverride" Target="../theme/themeOverride8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9.xml"/><Relationship Id="rId4" Type="http://schemas.microsoft.com/office/2011/relationships/chartStyle" Target="style20.xml"/><Relationship Id="rId5" Type="http://schemas.microsoft.com/office/2011/relationships/chartColorStyle" Target="colors20.xml"/><Relationship Id="rId1" Type="http://schemas.openxmlformats.org/officeDocument/2006/relationships/themeOverride" Target="../theme/themeOverride9.xml"/><Relationship Id="rId2" Type="http://schemas.openxmlformats.org/officeDocument/2006/relationships/oleObject" Target="file:///C:\Users\Admin\Desktop\last\sira_dataase\combined_species_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terfect species'!$AA$1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F$2:$AF$19</c:f>
                <c:numCache>
                  <c:formatCode>General</c:formatCode>
                  <c:ptCount val="18"/>
                  <c:pt idx="0">
                    <c:v>1801.896818168624</c:v>
                  </c:pt>
                  <c:pt idx="1">
                    <c:v>33866.70169689059</c:v>
                  </c:pt>
                  <c:pt idx="2">
                    <c:v>66773.1292423505</c:v>
                  </c:pt>
                  <c:pt idx="3">
                    <c:v>4228.043348681453</c:v>
                  </c:pt>
                  <c:pt idx="4">
                    <c:v>75189.4594265672</c:v>
                  </c:pt>
                  <c:pt idx="5">
                    <c:v>8065.055408881432</c:v>
                  </c:pt>
                  <c:pt idx="6">
                    <c:v>5299.598496194766</c:v>
                  </c:pt>
                  <c:pt idx="7">
                    <c:v>1655.09813393485</c:v>
                  </c:pt>
                  <c:pt idx="8">
                    <c:v>137427.3426443373</c:v>
                  </c:pt>
                  <c:pt idx="9">
                    <c:v>4513.62414615366</c:v>
                  </c:pt>
                  <c:pt idx="10">
                    <c:v>32956.6879886758</c:v>
                  </c:pt>
                  <c:pt idx="11">
                    <c:v>10477.06677735832</c:v>
                  </c:pt>
                  <c:pt idx="12">
                    <c:v>68520.75311961157</c:v>
                  </c:pt>
                  <c:pt idx="13">
                    <c:v>19994.4172703427</c:v>
                  </c:pt>
                  <c:pt idx="14">
                    <c:v>19356.52220158944</c:v>
                  </c:pt>
                  <c:pt idx="15">
                    <c:v>2991.597325919583</c:v>
                  </c:pt>
                  <c:pt idx="16">
                    <c:v>2269.198946754884</c:v>
                  </c:pt>
                  <c:pt idx="17">
                    <c:v>3892.645317479992</c:v>
                  </c:pt>
                </c:numCache>
              </c:numRef>
            </c:plus>
            <c:minus>
              <c:numRef>
                <c:f>'Interfect species'!$AF$2:$AF$19</c:f>
                <c:numCache>
                  <c:formatCode>General</c:formatCode>
                  <c:ptCount val="18"/>
                  <c:pt idx="0">
                    <c:v>1801.896818168624</c:v>
                  </c:pt>
                  <c:pt idx="1">
                    <c:v>33866.70169689059</c:v>
                  </c:pt>
                  <c:pt idx="2">
                    <c:v>66773.1292423505</c:v>
                  </c:pt>
                  <c:pt idx="3">
                    <c:v>4228.043348681453</c:v>
                  </c:pt>
                  <c:pt idx="4">
                    <c:v>75189.4594265672</c:v>
                  </c:pt>
                  <c:pt idx="5">
                    <c:v>8065.055408881432</c:v>
                  </c:pt>
                  <c:pt idx="6">
                    <c:v>5299.598496194766</c:v>
                  </c:pt>
                  <c:pt idx="7">
                    <c:v>1655.09813393485</c:v>
                  </c:pt>
                  <c:pt idx="8">
                    <c:v>137427.3426443373</c:v>
                  </c:pt>
                  <c:pt idx="9">
                    <c:v>4513.62414615366</c:v>
                  </c:pt>
                  <c:pt idx="10">
                    <c:v>32956.6879886758</c:v>
                  </c:pt>
                  <c:pt idx="11">
                    <c:v>10477.06677735832</c:v>
                  </c:pt>
                  <c:pt idx="12">
                    <c:v>68520.75311961157</c:v>
                  </c:pt>
                  <c:pt idx="13">
                    <c:v>19994.4172703427</c:v>
                  </c:pt>
                  <c:pt idx="14">
                    <c:v>19356.52220158944</c:v>
                  </c:pt>
                  <c:pt idx="15">
                    <c:v>2991.597325919583</c:v>
                  </c:pt>
                  <c:pt idx="16">
                    <c:v>2269.198946754884</c:v>
                  </c:pt>
                  <c:pt idx="17">
                    <c:v>3892.6453174799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Z$2:$Z$19</c:f>
              <c:strCache>
                <c:ptCount val="18"/>
                <c:pt idx="0">
                  <c:v>Cer d16:1_20:1</c:v>
                </c:pt>
                <c:pt idx="1">
                  <c:v>Cer d16:1_24:1A</c:v>
                </c:pt>
                <c:pt idx="2">
                  <c:v>Cer d16:1_24:1B</c:v>
                </c:pt>
                <c:pt idx="3">
                  <c:v>Cer d16:1_25:2</c:v>
                </c:pt>
                <c:pt idx="4">
                  <c:v>Cer d16:1_26:2</c:v>
                </c:pt>
                <c:pt idx="5">
                  <c:v>Cer d18:0_16:0A</c:v>
                </c:pt>
                <c:pt idx="6">
                  <c:v>Cer d18:0_16:0B</c:v>
                </c:pt>
                <c:pt idx="7">
                  <c:v>Cer d18:0_24:0</c:v>
                </c:pt>
                <c:pt idx="8">
                  <c:v>Cer d18:1_16:0</c:v>
                </c:pt>
                <c:pt idx="9">
                  <c:v>Cer d18:1_17:0</c:v>
                </c:pt>
                <c:pt idx="10">
                  <c:v>Cer d18:1_18:0B</c:v>
                </c:pt>
                <c:pt idx="11">
                  <c:v>Cer d18:1_20:0</c:v>
                </c:pt>
                <c:pt idx="12">
                  <c:v>Cer d18:1_22:0</c:v>
                </c:pt>
                <c:pt idx="13">
                  <c:v>Cer d18:1_23:1A</c:v>
                </c:pt>
                <c:pt idx="14">
                  <c:v>Cer d18:1_23:1B</c:v>
                </c:pt>
                <c:pt idx="15">
                  <c:v>Cer d18:1_24:3</c:v>
                </c:pt>
                <c:pt idx="16">
                  <c:v>Cer d18:1_25:0A</c:v>
                </c:pt>
                <c:pt idx="17">
                  <c:v>Cer d18:1_25:0B</c:v>
                </c:pt>
              </c:strCache>
            </c:strRef>
          </c:cat>
          <c:val>
            <c:numRef>
              <c:f>'Interfect species'!$AA$2:$AA$19</c:f>
              <c:numCache>
                <c:formatCode>General</c:formatCode>
                <c:ptCount val="18"/>
                <c:pt idx="0">
                  <c:v>34034.8010457357</c:v>
                </c:pt>
                <c:pt idx="1">
                  <c:v>254574.9905772725</c:v>
                </c:pt>
                <c:pt idx="2">
                  <c:v>98714.388988388</c:v>
                </c:pt>
                <c:pt idx="3">
                  <c:v>45545.23365676342</c:v>
                </c:pt>
                <c:pt idx="4">
                  <c:v>701937.920136144</c:v>
                </c:pt>
                <c:pt idx="5">
                  <c:v>72588.21943410234</c:v>
                </c:pt>
                <c:pt idx="6">
                  <c:v>41802.29223632815</c:v>
                </c:pt>
                <c:pt idx="7">
                  <c:v>8501.407020568846</c:v>
                </c:pt>
                <c:pt idx="8">
                  <c:v>633076.467122396</c:v>
                </c:pt>
                <c:pt idx="9">
                  <c:v>29748.6605430589</c:v>
                </c:pt>
                <c:pt idx="10">
                  <c:v>134932.927368164</c:v>
                </c:pt>
                <c:pt idx="11">
                  <c:v>51321.72212055592</c:v>
                </c:pt>
                <c:pt idx="12">
                  <c:v>334283.7326463625</c:v>
                </c:pt>
                <c:pt idx="13">
                  <c:v>156691.8027727515</c:v>
                </c:pt>
                <c:pt idx="14">
                  <c:v>156963.1562044277</c:v>
                </c:pt>
                <c:pt idx="15">
                  <c:v>29090.32889811197</c:v>
                </c:pt>
                <c:pt idx="16">
                  <c:v>11592.24300130209</c:v>
                </c:pt>
                <c:pt idx="17">
                  <c:v>15053.47195434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E96-4BAB-B1A0-4757F4C566B5}"/>
            </c:ext>
          </c:extLst>
        </c:ser>
        <c:ser>
          <c:idx val="1"/>
          <c:order val="1"/>
          <c:tx>
            <c:strRef>
              <c:f>'Interfect species'!$AB$1</c:f>
              <c:strCache>
                <c:ptCount val="1"/>
                <c:pt idx="0">
                  <c:v>INTERFER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2:$AH$19</c:f>
                <c:numCache>
                  <c:formatCode>General</c:formatCode>
                  <c:ptCount val="18"/>
                  <c:pt idx="0">
                    <c:v>2390.948375990308</c:v>
                  </c:pt>
                  <c:pt idx="1">
                    <c:v>19031.66930707665</c:v>
                  </c:pt>
                  <c:pt idx="2">
                    <c:v>6007.475925954544</c:v>
                  </c:pt>
                  <c:pt idx="3">
                    <c:v>2652.593917237268</c:v>
                  </c:pt>
                  <c:pt idx="4">
                    <c:v>53514.70060207463</c:v>
                  </c:pt>
                  <c:pt idx="5">
                    <c:v>17032.06445542114</c:v>
                  </c:pt>
                  <c:pt idx="6">
                    <c:v>5019.851389007641</c:v>
                  </c:pt>
                  <c:pt idx="7">
                    <c:v>3331.513657749836</c:v>
                  </c:pt>
                  <c:pt idx="8">
                    <c:v>66165.63482137742</c:v>
                  </c:pt>
                  <c:pt idx="9">
                    <c:v>7293.193344570413</c:v>
                  </c:pt>
                  <c:pt idx="10">
                    <c:v>27395.80759644218</c:v>
                  </c:pt>
                  <c:pt idx="11">
                    <c:v>11808.94577643739</c:v>
                  </c:pt>
                  <c:pt idx="12">
                    <c:v>87557.14026791832</c:v>
                  </c:pt>
                  <c:pt idx="13">
                    <c:v>11060.81258889322</c:v>
                  </c:pt>
                  <c:pt idx="14">
                    <c:v>10911.68042163166</c:v>
                  </c:pt>
                  <c:pt idx="15">
                    <c:v>2723.836679962584</c:v>
                  </c:pt>
                  <c:pt idx="16">
                    <c:v>3927.083460424046</c:v>
                  </c:pt>
                  <c:pt idx="17">
                    <c:v>6832.057994021076</c:v>
                  </c:pt>
                </c:numCache>
              </c:numRef>
            </c:plus>
            <c:minus>
              <c:numRef>
                <c:f>'Interfect species'!$AH$2:$AH$19</c:f>
                <c:numCache>
                  <c:formatCode>General</c:formatCode>
                  <c:ptCount val="18"/>
                  <c:pt idx="0">
                    <c:v>2390.948375990308</c:v>
                  </c:pt>
                  <c:pt idx="1">
                    <c:v>19031.66930707665</c:v>
                  </c:pt>
                  <c:pt idx="2">
                    <c:v>6007.475925954544</c:v>
                  </c:pt>
                  <c:pt idx="3">
                    <c:v>2652.593917237268</c:v>
                  </c:pt>
                  <c:pt idx="4">
                    <c:v>53514.70060207463</c:v>
                  </c:pt>
                  <c:pt idx="5">
                    <c:v>17032.06445542114</c:v>
                  </c:pt>
                  <c:pt idx="6">
                    <c:v>5019.851389007641</c:v>
                  </c:pt>
                  <c:pt idx="7">
                    <c:v>3331.513657749836</c:v>
                  </c:pt>
                  <c:pt idx="8">
                    <c:v>66165.63482137742</c:v>
                  </c:pt>
                  <c:pt idx="9">
                    <c:v>7293.193344570413</c:v>
                  </c:pt>
                  <c:pt idx="10">
                    <c:v>27395.80759644218</c:v>
                  </c:pt>
                  <c:pt idx="11">
                    <c:v>11808.94577643739</c:v>
                  </c:pt>
                  <c:pt idx="12">
                    <c:v>87557.14026791832</c:v>
                  </c:pt>
                  <c:pt idx="13">
                    <c:v>11060.81258889322</c:v>
                  </c:pt>
                  <c:pt idx="14">
                    <c:v>10911.68042163166</c:v>
                  </c:pt>
                  <c:pt idx="15">
                    <c:v>2723.836679962584</c:v>
                  </c:pt>
                  <c:pt idx="16">
                    <c:v>3927.083460424046</c:v>
                  </c:pt>
                  <c:pt idx="17">
                    <c:v>6832.0579940210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Z$2:$Z$19</c:f>
              <c:strCache>
                <c:ptCount val="18"/>
                <c:pt idx="0">
                  <c:v>Cer d16:1_20:1</c:v>
                </c:pt>
                <c:pt idx="1">
                  <c:v>Cer d16:1_24:1A</c:v>
                </c:pt>
                <c:pt idx="2">
                  <c:v>Cer d16:1_24:1B</c:v>
                </c:pt>
                <c:pt idx="3">
                  <c:v>Cer d16:1_25:2</c:v>
                </c:pt>
                <c:pt idx="4">
                  <c:v>Cer d16:1_26:2</c:v>
                </c:pt>
                <c:pt idx="5">
                  <c:v>Cer d18:0_16:0A</c:v>
                </c:pt>
                <c:pt idx="6">
                  <c:v>Cer d18:0_16:0B</c:v>
                </c:pt>
                <c:pt idx="7">
                  <c:v>Cer d18:0_24:0</c:v>
                </c:pt>
                <c:pt idx="8">
                  <c:v>Cer d18:1_16:0</c:v>
                </c:pt>
                <c:pt idx="9">
                  <c:v>Cer d18:1_17:0</c:v>
                </c:pt>
                <c:pt idx="10">
                  <c:v>Cer d18:1_18:0B</c:v>
                </c:pt>
                <c:pt idx="11">
                  <c:v>Cer d18:1_20:0</c:v>
                </c:pt>
                <c:pt idx="12">
                  <c:v>Cer d18:1_22:0</c:v>
                </c:pt>
                <c:pt idx="13">
                  <c:v>Cer d18:1_23:1A</c:v>
                </c:pt>
                <c:pt idx="14">
                  <c:v>Cer d18:1_23:1B</c:v>
                </c:pt>
                <c:pt idx="15">
                  <c:v>Cer d18:1_24:3</c:v>
                </c:pt>
                <c:pt idx="16">
                  <c:v>Cer d18:1_25:0A</c:v>
                </c:pt>
                <c:pt idx="17">
                  <c:v>Cer d18:1_25:0B</c:v>
                </c:pt>
              </c:strCache>
            </c:strRef>
          </c:cat>
          <c:val>
            <c:numRef>
              <c:f>'Interfect species'!$AB$2:$AB$19</c:f>
              <c:numCache>
                <c:formatCode>General</c:formatCode>
                <c:ptCount val="18"/>
                <c:pt idx="0">
                  <c:v>38878.61853027345</c:v>
                </c:pt>
                <c:pt idx="1">
                  <c:v>222531.8655531433</c:v>
                </c:pt>
                <c:pt idx="2">
                  <c:v>63716.22080336483</c:v>
                </c:pt>
                <c:pt idx="3">
                  <c:v>37880.22392950347</c:v>
                </c:pt>
                <c:pt idx="4">
                  <c:v>580406.1407100968</c:v>
                </c:pt>
                <c:pt idx="5">
                  <c:v>94436.5791651407</c:v>
                </c:pt>
                <c:pt idx="6">
                  <c:v>40941.02490234377</c:v>
                </c:pt>
                <c:pt idx="7">
                  <c:v>15558.70658874512</c:v>
                </c:pt>
                <c:pt idx="8">
                  <c:v>904883.1997070316</c:v>
                </c:pt>
                <c:pt idx="9">
                  <c:v>38187.52296067987</c:v>
                </c:pt>
                <c:pt idx="10">
                  <c:v>188489.4532877603</c:v>
                </c:pt>
                <c:pt idx="11">
                  <c:v>57006.05618528341</c:v>
                </c:pt>
                <c:pt idx="12">
                  <c:v>367108.494597751</c:v>
                </c:pt>
                <c:pt idx="13">
                  <c:v>131714.1382026077</c:v>
                </c:pt>
                <c:pt idx="14">
                  <c:v>133411.311218324</c:v>
                </c:pt>
                <c:pt idx="15">
                  <c:v>27509.10493977865</c:v>
                </c:pt>
                <c:pt idx="16">
                  <c:v>24969.09871419274</c:v>
                </c:pt>
                <c:pt idx="17">
                  <c:v>24358.70296223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E96-4BAB-B1A0-4757F4C566B5}"/>
            </c:ext>
          </c:extLst>
        </c:ser>
        <c:ser>
          <c:idx val="2"/>
          <c:order val="2"/>
          <c:tx>
            <c:strRef>
              <c:f>'Interfect species'!$AC$1</c:f>
              <c:strCache>
                <c:ptCount val="1"/>
                <c:pt idx="0">
                  <c:v>INTERFERin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2:$AH$19</c:f>
                <c:numCache>
                  <c:formatCode>General</c:formatCode>
                  <c:ptCount val="18"/>
                  <c:pt idx="0">
                    <c:v>2390.948375990308</c:v>
                  </c:pt>
                  <c:pt idx="1">
                    <c:v>19031.66930707665</c:v>
                  </c:pt>
                  <c:pt idx="2">
                    <c:v>6007.475925954544</c:v>
                  </c:pt>
                  <c:pt idx="3">
                    <c:v>2652.593917237268</c:v>
                  </c:pt>
                  <c:pt idx="4">
                    <c:v>53514.70060207463</c:v>
                  </c:pt>
                  <c:pt idx="5">
                    <c:v>17032.06445542114</c:v>
                  </c:pt>
                  <c:pt idx="6">
                    <c:v>5019.851389007641</c:v>
                  </c:pt>
                  <c:pt idx="7">
                    <c:v>3331.513657749836</c:v>
                  </c:pt>
                  <c:pt idx="8">
                    <c:v>66165.63482137742</c:v>
                  </c:pt>
                  <c:pt idx="9">
                    <c:v>7293.193344570413</c:v>
                  </c:pt>
                  <c:pt idx="10">
                    <c:v>27395.80759644218</c:v>
                  </c:pt>
                  <c:pt idx="11">
                    <c:v>11808.94577643739</c:v>
                  </c:pt>
                  <c:pt idx="12">
                    <c:v>87557.14026791832</c:v>
                  </c:pt>
                  <c:pt idx="13">
                    <c:v>11060.81258889322</c:v>
                  </c:pt>
                  <c:pt idx="14">
                    <c:v>10911.68042163166</c:v>
                  </c:pt>
                  <c:pt idx="15">
                    <c:v>2723.836679962584</c:v>
                  </c:pt>
                  <c:pt idx="16">
                    <c:v>3927.083460424046</c:v>
                  </c:pt>
                  <c:pt idx="17">
                    <c:v>6832.057994021076</c:v>
                  </c:pt>
                </c:numCache>
              </c:numRef>
            </c:plus>
            <c:minus>
              <c:numRef>
                <c:f>'Interfect species'!$AH$2:$AH$19</c:f>
                <c:numCache>
                  <c:formatCode>General</c:formatCode>
                  <c:ptCount val="18"/>
                  <c:pt idx="0">
                    <c:v>2390.948375990308</c:v>
                  </c:pt>
                  <c:pt idx="1">
                    <c:v>19031.66930707665</c:v>
                  </c:pt>
                  <c:pt idx="2">
                    <c:v>6007.475925954544</c:v>
                  </c:pt>
                  <c:pt idx="3">
                    <c:v>2652.593917237268</c:v>
                  </c:pt>
                  <c:pt idx="4">
                    <c:v>53514.70060207463</c:v>
                  </c:pt>
                  <c:pt idx="5">
                    <c:v>17032.06445542114</c:v>
                  </c:pt>
                  <c:pt idx="6">
                    <c:v>5019.851389007641</c:v>
                  </c:pt>
                  <c:pt idx="7">
                    <c:v>3331.513657749836</c:v>
                  </c:pt>
                  <c:pt idx="8">
                    <c:v>66165.63482137742</c:v>
                  </c:pt>
                  <c:pt idx="9">
                    <c:v>7293.193344570413</c:v>
                  </c:pt>
                  <c:pt idx="10">
                    <c:v>27395.80759644218</c:v>
                  </c:pt>
                  <c:pt idx="11">
                    <c:v>11808.94577643739</c:v>
                  </c:pt>
                  <c:pt idx="12">
                    <c:v>87557.14026791832</c:v>
                  </c:pt>
                  <c:pt idx="13">
                    <c:v>11060.81258889322</c:v>
                  </c:pt>
                  <c:pt idx="14">
                    <c:v>10911.68042163166</c:v>
                  </c:pt>
                  <c:pt idx="15">
                    <c:v>2723.836679962584</c:v>
                  </c:pt>
                  <c:pt idx="16">
                    <c:v>3927.083460424046</c:v>
                  </c:pt>
                  <c:pt idx="17">
                    <c:v>6832.0579940210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Z$2:$Z$19</c:f>
              <c:strCache>
                <c:ptCount val="18"/>
                <c:pt idx="0">
                  <c:v>Cer d16:1_20:1</c:v>
                </c:pt>
                <c:pt idx="1">
                  <c:v>Cer d16:1_24:1A</c:v>
                </c:pt>
                <c:pt idx="2">
                  <c:v>Cer d16:1_24:1B</c:v>
                </c:pt>
                <c:pt idx="3">
                  <c:v>Cer d16:1_25:2</c:v>
                </c:pt>
                <c:pt idx="4">
                  <c:v>Cer d16:1_26:2</c:v>
                </c:pt>
                <c:pt idx="5">
                  <c:v>Cer d18:0_16:0A</c:v>
                </c:pt>
                <c:pt idx="6">
                  <c:v>Cer d18:0_16:0B</c:v>
                </c:pt>
                <c:pt idx="7">
                  <c:v>Cer d18:0_24:0</c:v>
                </c:pt>
                <c:pt idx="8">
                  <c:v>Cer d18:1_16:0</c:v>
                </c:pt>
                <c:pt idx="9">
                  <c:v>Cer d18:1_17:0</c:v>
                </c:pt>
                <c:pt idx="10">
                  <c:v>Cer d18:1_18:0B</c:v>
                </c:pt>
                <c:pt idx="11">
                  <c:v>Cer d18:1_20:0</c:v>
                </c:pt>
                <c:pt idx="12">
                  <c:v>Cer d18:1_22:0</c:v>
                </c:pt>
                <c:pt idx="13">
                  <c:v>Cer d18:1_23:1A</c:v>
                </c:pt>
                <c:pt idx="14">
                  <c:v>Cer d18:1_23:1B</c:v>
                </c:pt>
                <c:pt idx="15">
                  <c:v>Cer d18:1_24:3</c:v>
                </c:pt>
                <c:pt idx="16">
                  <c:v>Cer d18:1_25:0A</c:v>
                </c:pt>
                <c:pt idx="17">
                  <c:v>Cer d18:1_25:0B</c:v>
                </c:pt>
              </c:strCache>
            </c:strRef>
          </c:cat>
          <c:val>
            <c:numRef>
              <c:f>'Interfect species'!$AC$2:$AC$19</c:f>
              <c:numCache>
                <c:formatCode>General</c:formatCode>
                <c:ptCount val="18"/>
                <c:pt idx="0">
                  <c:v>46422.67427571616</c:v>
                </c:pt>
                <c:pt idx="1">
                  <c:v>193943.8024250892</c:v>
                </c:pt>
                <c:pt idx="2">
                  <c:v>67425.31109068618</c:v>
                </c:pt>
                <c:pt idx="3">
                  <c:v>32917.96456360682</c:v>
                </c:pt>
                <c:pt idx="4">
                  <c:v>468726.1490705329</c:v>
                </c:pt>
                <c:pt idx="5">
                  <c:v>122318.8656336466</c:v>
                </c:pt>
                <c:pt idx="6">
                  <c:v>39493.42346191408</c:v>
                </c:pt>
                <c:pt idx="7">
                  <c:v>15918.76727803548</c:v>
                </c:pt>
                <c:pt idx="8">
                  <c:v>999377.6855468749</c:v>
                </c:pt>
                <c:pt idx="9">
                  <c:v>51427.41894458822</c:v>
                </c:pt>
                <c:pt idx="10">
                  <c:v>231791.6950276693</c:v>
                </c:pt>
                <c:pt idx="11">
                  <c:v>68151.31035579192</c:v>
                </c:pt>
                <c:pt idx="12">
                  <c:v>423628.858188359</c:v>
                </c:pt>
                <c:pt idx="13">
                  <c:v>119451.661035937</c:v>
                </c:pt>
                <c:pt idx="14">
                  <c:v>119540.7766658254</c:v>
                </c:pt>
                <c:pt idx="15">
                  <c:v>23973.84815470377</c:v>
                </c:pt>
                <c:pt idx="16">
                  <c:v>26852.4656575521</c:v>
                </c:pt>
                <c:pt idx="17">
                  <c:v>25469.47949218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E96-4BAB-B1A0-4757F4C566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43942072"/>
        <c:axId val="-2143938424"/>
      </c:barChart>
      <c:catAx>
        <c:axId val="-2143942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43938424"/>
        <c:crosses val="autoZero"/>
        <c:auto val="1"/>
        <c:lblAlgn val="ctr"/>
        <c:lblOffset val="100"/>
        <c:noMultiLvlLbl val="0"/>
      </c:catAx>
      <c:valAx>
        <c:axId val="-21439384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>
            <c:manualLayout>
              <c:xMode val="edge"/>
              <c:yMode val="edge"/>
              <c:x val="0.0139617477721827"/>
              <c:y val="0.381532215936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439420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terfect species'!$Z$255</c:f>
              <c:strCache>
                <c:ptCount val="1"/>
                <c:pt idx="0">
                  <c:v>INTERFERi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F$256:$AF$260</c:f>
                <c:numCache>
                  <c:formatCode>General</c:formatCode>
                  <c:ptCount val="5"/>
                  <c:pt idx="0">
                    <c:v>7865.001434950022</c:v>
                  </c:pt>
                  <c:pt idx="1">
                    <c:v>2223.67736813703</c:v>
                  </c:pt>
                  <c:pt idx="2">
                    <c:v>6326.861717395973</c:v>
                  </c:pt>
                  <c:pt idx="3">
                    <c:v>13612.5223657602</c:v>
                  </c:pt>
                  <c:pt idx="4">
                    <c:v>4051.755385966337</c:v>
                  </c:pt>
                </c:numCache>
              </c:numRef>
            </c:plus>
            <c:minus>
              <c:numRef>
                <c:f>'Interfect species'!$AF$256:$AF$260</c:f>
                <c:numCache>
                  <c:formatCode>General</c:formatCode>
                  <c:ptCount val="5"/>
                  <c:pt idx="0">
                    <c:v>7865.001434950022</c:v>
                  </c:pt>
                  <c:pt idx="1">
                    <c:v>2223.67736813703</c:v>
                  </c:pt>
                  <c:pt idx="2">
                    <c:v>6326.861717395973</c:v>
                  </c:pt>
                  <c:pt idx="3">
                    <c:v>13612.5223657602</c:v>
                  </c:pt>
                  <c:pt idx="4">
                    <c:v>4051.7553859663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256:$Y$260</c:f>
              <c:strCache>
                <c:ptCount val="5"/>
                <c:pt idx="0">
                  <c:v>DG(36:2)</c:v>
                </c:pt>
                <c:pt idx="1">
                  <c:v>DG(36:1)</c:v>
                </c:pt>
                <c:pt idx="2">
                  <c:v>DG(34:2)</c:v>
                </c:pt>
                <c:pt idx="3">
                  <c:v>DG(34:1)</c:v>
                </c:pt>
                <c:pt idx="4">
                  <c:v>DG(32:1)</c:v>
                </c:pt>
              </c:strCache>
            </c:strRef>
          </c:cat>
          <c:val>
            <c:numRef>
              <c:f>'Interfect species'!$Z$256:$Z$260</c:f>
              <c:numCache>
                <c:formatCode>General</c:formatCode>
                <c:ptCount val="5"/>
                <c:pt idx="0">
                  <c:v>63357.22926839196</c:v>
                </c:pt>
                <c:pt idx="1">
                  <c:v>20388.48427073163</c:v>
                </c:pt>
                <c:pt idx="2">
                  <c:v>41183.01519775389</c:v>
                </c:pt>
                <c:pt idx="3">
                  <c:v>157372.7431030273</c:v>
                </c:pt>
                <c:pt idx="4">
                  <c:v>70186.5732955932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53A-401B-83C3-FED383A12C3D}"/>
            </c:ext>
          </c:extLst>
        </c:ser>
        <c:ser>
          <c:idx val="1"/>
          <c:order val="1"/>
          <c:tx>
            <c:strRef>
              <c:f>'Interfect species'!$AA$255</c:f>
              <c:strCache>
                <c:ptCount val="1"/>
                <c:pt idx="0">
                  <c:v>INTERFERin+N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G$256:$AG$260</c:f>
                <c:numCache>
                  <c:formatCode>General</c:formatCode>
                  <c:ptCount val="5"/>
                  <c:pt idx="0">
                    <c:v>11405.82359552232</c:v>
                  </c:pt>
                  <c:pt idx="1">
                    <c:v>2253.197666802888</c:v>
                  </c:pt>
                  <c:pt idx="2">
                    <c:v>7705.887477259113</c:v>
                  </c:pt>
                  <c:pt idx="3">
                    <c:v>19685.59421916016</c:v>
                  </c:pt>
                  <c:pt idx="4">
                    <c:v>3151.754477229094</c:v>
                  </c:pt>
                </c:numCache>
              </c:numRef>
            </c:plus>
            <c:minus>
              <c:numRef>
                <c:f>'Interfect species'!$AG$256:$AG$260</c:f>
                <c:numCache>
                  <c:formatCode>General</c:formatCode>
                  <c:ptCount val="5"/>
                  <c:pt idx="0">
                    <c:v>11405.82359552232</c:v>
                  </c:pt>
                  <c:pt idx="1">
                    <c:v>2253.197666802888</c:v>
                  </c:pt>
                  <c:pt idx="2">
                    <c:v>7705.887477259113</c:v>
                  </c:pt>
                  <c:pt idx="3">
                    <c:v>19685.59421916016</c:v>
                  </c:pt>
                  <c:pt idx="4">
                    <c:v>3151.7544772290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256:$Y$260</c:f>
              <c:strCache>
                <c:ptCount val="5"/>
                <c:pt idx="0">
                  <c:v>DG(36:2)</c:v>
                </c:pt>
                <c:pt idx="1">
                  <c:v>DG(36:1)</c:v>
                </c:pt>
                <c:pt idx="2">
                  <c:v>DG(34:2)</c:v>
                </c:pt>
                <c:pt idx="3">
                  <c:v>DG(34:1)</c:v>
                </c:pt>
                <c:pt idx="4">
                  <c:v>DG(32:1)</c:v>
                </c:pt>
              </c:strCache>
            </c:strRef>
          </c:cat>
          <c:val>
            <c:numRef>
              <c:f>'Interfect species'!$AA$256:$AA$260</c:f>
              <c:numCache>
                <c:formatCode>General</c:formatCode>
                <c:ptCount val="5"/>
                <c:pt idx="0">
                  <c:v>65210.79441324871</c:v>
                </c:pt>
                <c:pt idx="1">
                  <c:v>20267.47642517092</c:v>
                </c:pt>
                <c:pt idx="2">
                  <c:v>58428.7841796875</c:v>
                </c:pt>
                <c:pt idx="3">
                  <c:v>154359.1176350912</c:v>
                </c:pt>
                <c:pt idx="4">
                  <c:v>79681.401992797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53A-401B-83C3-FED383A12C3D}"/>
            </c:ext>
          </c:extLst>
        </c:ser>
        <c:ser>
          <c:idx val="2"/>
          <c:order val="2"/>
          <c:tx>
            <c:strRef>
              <c:f>'Interfect species'!$AB$255</c:f>
              <c:strCache>
                <c:ptCount val="1"/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256:$AH$260</c:f>
                <c:numCache>
                  <c:formatCode>General</c:formatCode>
                  <c:ptCount val="5"/>
                  <c:pt idx="0">
                    <c:v>8440.748978783323</c:v>
                  </c:pt>
                  <c:pt idx="1">
                    <c:v>2077.400047505341</c:v>
                  </c:pt>
                  <c:pt idx="2">
                    <c:v>8661.03526857214</c:v>
                  </c:pt>
                  <c:pt idx="3">
                    <c:v>21465.96213955126</c:v>
                  </c:pt>
                  <c:pt idx="4">
                    <c:v>11551.51309893535</c:v>
                  </c:pt>
                </c:numCache>
              </c:numRef>
            </c:plus>
            <c:minus>
              <c:numRef>
                <c:f>'Interfect species'!$AH$256:$AH$260</c:f>
                <c:numCache>
                  <c:formatCode>General</c:formatCode>
                  <c:ptCount val="5"/>
                  <c:pt idx="0">
                    <c:v>8440.748978783323</c:v>
                  </c:pt>
                  <c:pt idx="1">
                    <c:v>2077.400047505341</c:v>
                  </c:pt>
                  <c:pt idx="2">
                    <c:v>8661.03526857214</c:v>
                  </c:pt>
                  <c:pt idx="3">
                    <c:v>21465.96213955126</c:v>
                  </c:pt>
                  <c:pt idx="4">
                    <c:v>11551.513098935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256:$Y$260</c:f>
              <c:strCache>
                <c:ptCount val="5"/>
                <c:pt idx="0">
                  <c:v>DG(36:2)</c:v>
                </c:pt>
                <c:pt idx="1">
                  <c:v>DG(36:1)</c:v>
                </c:pt>
                <c:pt idx="2">
                  <c:v>DG(34:2)</c:v>
                </c:pt>
                <c:pt idx="3">
                  <c:v>DG(34:1)</c:v>
                </c:pt>
                <c:pt idx="4">
                  <c:v>DG(32:1)</c:v>
                </c:pt>
              </c:strCache>
            </c:strRef>
          </c:cat>
          <c:val>
            <c:numRef>
              <c:f>'Interfect species'!$AB$256:$AB$260</c:f>
              <c:numCache>
                <c:formatCode>General</c:formatCode>
                <c:ptCount val="5"/>
                <c:pt idx="0">
                  <c:v>56169.03607177737</c:v>
                </c:pt>
                <c:pt idx="1">
                  <c:v>18116.24364217122</c:v>
                </c:pt>
                <c:pt idx="2">
                  <c:v>50593.5160522461</c:v>
                </c:pt>
                <c:pt idx="3">
                  <c:v>138087.2218322757</c:v>
                </c:pt>
                <c:pt idx="4">
                  <c:v>71990.271252950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53A-401B-83C3-FED383A12C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081126072"/>
        <c:axId val="2080734200"/>
      </c:barChart>
      <c:catAx>
        <c:axId val="2081126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734200"/>
        <c:crosses val="autoZero"/>
        <c:auto val="1"/>
        <c:lblAlgn val="ctr"/>
        <c:lblOffset val="100"/>
        <c:noMultiLvlLbl val="0"/>
      </c:catAx>
      <c:valAx>
        <c:axId val="20807342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11260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terfect species'!$Z$212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F$213:$AF$247</c:f>
                <c:numCache>
                  <c:formatCode>General</c:formatCode>
                  <c:ptCount val="35"/>
                  <c:pt idx="0">
                    <c:v>15443.25029405805</c:v>
                  </c:pt>
                  <c:pt idx="1">
                    <c:v>62132.8319850029</c:v>
                  </c:pt>
                  <c:pt idx="2">
                    <c:v>25057.6063258844</c:v>
                  </c:pt>
                  <c:pt idx="3">
                    <c:v>1810.578190698898</c:v>
                  </c:pt>
                  <c:pt idx="4">
                    <c:v>116977.8458927957</c:v>
                  </c:pt>
                  <c:pt idx="5">
                    <c:v>111547.4441402135</c:v>
                  </c:pt>
                  <c:pt idx="6">
                    <c:v>14969.58182461823</c:v>
                  </c:pt>
                  <c:pt idx="7">
                    <c:v>3433.358856558147</c:v>
                  </c:pt>
                  <c:pt idx="8">
                    <c:v>8178.634292827416</c:v>
                  </c:pt>
                  <c:pt idx="9">
                    <c:v>2780.991365443246</c:v>
                  </c:pt>
                  <c:pt idx="10">
                    <c:v>2206.546636244136</c:v>
                  </c:pt>
                  <c:pt idx="11">
                    <c:v>16487.68655862729</c:v>
                  </c:pt>
                  <c:pt idx="12">
                    <c:v>213667.7917190835</c:v>
                  </c:pt>
                  <c:pt idx="13">
                    <c:v>55033.1159333349</c:v>
                  </c:pt>
                  <c:pt idx="14">
                    <c:v>2866.324762750767</c:v>
                  </c:pt>
                  <c:pt idx="15">
                    <c:v>4988.68654568109</c:v>
                  </c:pt>
                  <c:pt idx="16">
                    <c:v>5553.588103676425</c:v>
                  </c:pt>
                  <c:pt idx="17">
                    <c:v>1961.67100953114</c:v>
                  </c:pt>
                  <c:pt idx="18">
                    <c:v>23203.57551271649</c:v>
                  </c:pt>
                  <c:pt idx="19">
                    <c:v>101746.1971817403</c:v>
                  </c:pt>
                  <c:pt idx="20">
                    <c:v>6699.490871670671</c:v>
                  </c:pt>
                  <c:pt idx="21">
                    <c:v>3888.213644556849</c:v>
                  </c:pt>
                  <c:pt idx="22">
                    <c:v>1195.633651478121</c:v>
                  </c:pt>
                  <c:pt idx="23">
                    <c:v>1205.569498002265</c:v>
                  </c:pt>
                  <c:pt idx="24">
                    <c:v>2642.430143913891</c:v>
                  </c:pt>
                  <c:pt idx="25">
                    <c:v>8752.125152354006</c:v>
                  </c:pt>
                  <c:pt idx="26">
                    <c:v>5986.072127174842</c:v>
                  </c:pt>
                  <c:pt idx="27">
                    <c:v>1107.308081189831</c:v>
                  </c:pt>
                  <c:pt idx="28">
                    <c:v>3179.08355456772</c:v>
                  </c:pt>
                  <c:pt idx="29">
                    <c:v>910.2440559389852</c:v>
                  </c:pt>
                  <c:pt idx="30">
                    <c:v>1773.892605654439</c:v>
                  </c:pt>
                  <c:pt idx="31">
                    <c:v>1306.001335904245</c:v>
                  </c:pt>
                  <c:pt idx="32">
                    <c:v>1602.706351326746</c:v>
                  </c:pt>
                  <c:pt idx="33">
                    <c:v>742.4400878077113</c:v>
                  </c:pt>
                  <c:pt idx="34">
                    <c:v>1950.100546121985</c:v>
                  </c:pt>
                </c:numCache>
              </c:numRef>
            </c:plus>
            <c:minus>
              <c:numRef>
                <c:f>'Interfect species'!$AF$213:$AF$247</c:f>
                <c:numCache>
                  <c:formatCode>General</c:formatCode>
                  <c:ptCount val="35"/>
                  <c:pt idx="0">
                    <c:v>15443.25029405805</c:v>
                  </c:pt>
                  <c:pt idx="1">
                    <c:v>62132.8319850029</c:v>
                  </c:pt>
                  <c:pt idx="2">
                    <c:v>25057.6063258844</c:v>
                  </c:pt>
                  <c:pt idx="3">
                    <c:v>1810.578190698898</c:v>
                  </c:pt>
                  <c:pt idx="4">
                    <c:v>116977.8458927957</c:v>
                  </c:pt>
                  <c:pt idx="5">
                    <c:v>111547.4441402135</c:v>
                  </c:pt>
                  <c:pt idx="6">
                    <c:v>14969.58182461823</c:v>
                  </c:pt>
                  <c:pt idx="7">
                    <c:v>3433.358856558147</c:v>
                  </c:pt>
                  <c:pt idx="8">
                    <c:v>8178.634292827416</c:v>
                  </c:pt>
                  <c:pt idx="9">
                    <c:v>2780.991365443246</c:v>
                  </c:pt>
                  <c:pt idx="10">
                    <c:v>2206.546636244136</c:v>
                  </c:pt>
                  <c:pt idx="11">
                    <c:v>16487.68655862729</c:v>
                  </c:pt>
                  <c:pt idx="12">
                    <c:v>213667.7917190835</c:v>
                  </c:pt>
                  <c:pt idx="13">
                    <c:v>55033.1159333349</c:v>
                  </c:pt>
                  <c:pt idx="14">
                    <c:v>2866.324762750767</c:v>
                  </c:pt>
                  <c:pt idx="15">
                    <c:v>4988.68654568109</c:v>
                  </c:pt>
                  <c:pt idx="16">
                    <c:v>5553.588103676425</c:v>
                  </c:pt>
                  <c:pt idx="17">
                    <c:v>1961.67100953114</c:v>
                  </c:pt>
                  <c:pt idx="18">
                    <c:v>23203.57551271649</c:v>
                  </c:pt>
                  <c:pt idx="19">
                    <c:v>101746.1971817403</c:v>
                  </c:pt>
                  <c:pt idx="20">
                    <c:v>6699.490871670671</c:v>
                  </c:pt>
                  <c:pt idx="21">
                    <c:v>3888.213644556849</c:v>
                  </c:pt>
                  <c:pt idx="22">
                    <c:v>1195.633651478121</c:v>
                  </c:pt>
                  <c:pt idx="23">
                    <c:v>1205.569498002265</c:v>
                  </c:pt>
                  <c:pt idx="24">
                    <c:v>2642.430143913891</c:v>
                  </c:pt>
                  <c:pt idx="25">
                    <c:v>8752.125152354006</c:v>
                  </c:pt>
                  <c:pt idx="26">
                    <c:v>5986.072127174842</c:v>
                  </c:pt>
                  <c:pt idx="27">
                    <c:v>1107.308081189831</c:v>
                  </c:pt>
                  <c:pt idx="28">
                    <c:v>3179.08355456772</c:v>
                  </c:pt>
                  <c:pt idx="29">
                    <c:v>910.2440559389852</c:v>
                  </c:pt>
                  <c:pt idx="30">
                    <c:v>1773.892605654439</c:v>
                  </c:pt>
                  <c:pt idx="31">
                    <c:v>1306.001335904245</c:v>
                  </c:pt>
                  <c:pt idx="32">
                    <c:v>1602.706351326746</c:v>
                  </c:pt>
                  <c:pt idx="33">
                    <c:v>742.4400878077113</c:v>
                  </c:pt>
                  <c:pt idx="34">
                    <c:v>1950.1005461219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213:$Y$247</c:f>
              <c:strCache>
                <c:ptCount val="35"/>
                <c:pt idx="0">
                  <c:v>TG 46:1</c:v>
                </c:pt>
                <c:pt idx="1">
                  <c:v>TG 48:1</c:v>
                </c:pt>
                <c:pt idx="2">
                  <c:v>TG 48:2</c:v>
                </c:pt>
                <c:pt idx="3">
                  <c:v>TG 48:3</c:v>
                </c:pt>
                <c:pt idx="4">
                  <c:v>TG 50:1</c:v>
                </c:pt>
                <c:pt idx="5">
                  <c:v>TG 50:2</c:v>
                </c:pt>
                <c:pt idx="6">
                  <c:v>TG 50:3</c:v>
                </c:pt>
                <c:pt idx="7">
                  <c:v>TG 51:1</c:v>
                </c:pt>
                <c:pt idx="8">
                  <c:v>TG 51:2</c:v>
                </c:pt>
                <c:pt idx="9">
                  <c:v>TG 51:3</c:v>
                </c:pt>
                <c:pt idx="10">
                  <c:v>TG 52:0</c:v>
                </c:pt>
                <c:pt idx="11">
                  <c:v>TG 52:1</c:v>
                </c:pt>
                <c:pt idx="12">
                  <c:v>TG 52:2</c:v>
                </c:pt>
                <c:pt idx="13">
                  <c:v>TG 52:3</c:v>
                </c:pt>
                <c:pt idx="14">
                  <c:v>TG 52:4</c:v>
                </c:pt>
                <c:pt idx="15">
                  <c:v>TG 53:2</c:v>
                </c:pt>
                <c:pt idx="16">
                  <c:v>TG 53:3</c:v>
                </c:pt>
                <c:pt idx="17">
                  <c:v>TG 54:1</c:v>
                </c:pt>
                <c:pt idx="18">
                  <c:v>TG 54:2</c:v>
                </c:pt>
                <c:pt idx="19">
                  <c:v>TG 54:3</c:v>
                </c:pt>
                <c:pt idx="20">
                  <c:v>TG 54:4</c:v>
                </c:pt>
                <c:pt idx="21">
                  <c:v>TG 54:5</c:v>
                </c:pt>
                <c:pt idx="22">
                  <c:v>TG 54:6</c:v>
                </c:pt>
                <c:pt idx="23">
                  <c:v>TG 54:7</c:v>
                </c:pt>
                <c:pt idx="24">
                  <c:v>TG 55:3</c:v>
                </c:pt>
                <c:pt idx="25">
                  <c:v>TG 56:3</c:v>
                </c:pt>
                <c:pt idx="26">
                  <c:v>TG 56:6</c:v>
                </c:pt>
                <c:pt idx="27">
                  <c:v>TG 56:7A</c:v>
                </c:pt>
                <c:pt idx="28">
                  <c:v>TG 56:7B</c:v>
                </c:pt>
                <c:pt idx="29">
                  <c:v>TG 56:8</c:v>
                </c:pt>
                <c:pt idx="30">
                  <c:v>TG 58:3</c:v>
                </c:pt>
                <c:pt idx="31">
                  <c:v>TG 58:6</c:v>
                </c:pt>
                <c:pt idx="32">
                  <c:v>TG 58:8</c:v>
                </c:pt>
                <c:pt idx="33">
                  <c:v>TG 58:9</c:v>
                </c:pt>
                <c:pt idx="34">
                  <c:v>TG 60:3</c:v>
                </c:pt>
              </c:strCache>
            </c:strRef>
          </c:cat>
          <c:val>
            <c:numRef>
              <c:f>'Interfect species'!$Z$213:$Z$247</c:f>
              <c:numCache>
                <c:formatCode>General</c:formatCode>
                <c:ptCount val="35"/>
                <c:pt idx="0">
                  <c:v>68781.11573572573</c:v>
                </c:pt>
                <c:pt idx="1">
                  <c:v>253600.2130275305</c:v>
                </c:pt>
                <c:pt idx="2">
                  <c:v>110219.7763704872</c:v>
                </c:pt>
                <c:pt idx="3">
                  <c:v>11856.05468750001</c:v>
                </c:pt>
                <c:pt idx="4">
                  <c:v>461485.0277918527</c:v>
                </c:pt>
                <c:pt idx="5">
                  <c:v>415524.4008035432</c:v>
                </c:pt>
                <c:pt idx="6">
                  <c:v>63896.82708764628</c:v>
                </c:pt>
                <c:pt idx="7">
                  <c:v>16137.66314317915</c:v>
                </c:pt>
                <c:pt idx="8">
                  <c:v>37875.31226288962</c:v>
                </c:pt>
                <c:pt idx="9">
                  <c:v>10420.00084187469</c:v>
                </c:pt>
                <c:pt idx="10">
                  <c:v>14141.53051757815</c:v>
                </c:pt>
                <c:pt idx="11">
                  <c:v>63546.28982128559</c:v>
                </c:pt>
                <c:pt idx="12">
                  <c:v>761021.7557538046</c:v>
                </c:pt>
                <c:pt idx="13">
                  <c:v>202965.7173756722</c:v>
                </c:pt>
                <c:pt idx="14">
                  <c:v>13274.5949910482</c:v>
                </c:pt>
                <c:pt idx="15">
                  <c:v>20000.30735112885</c:v>
                </c:pt>
                <c:pt idx="16">
                  <c:v>20281.63812043098</c:v>
                </c:pt>
                <c:pt idx="17">
                  <c:v>6879.886515291225</c:v>
                </c:pt>
                <c:pt idx="18">
                  <c:v>80771.89788293251</c:v>
                </c:pt>
                <c:pt idx="19">
                  <c:v>324718.1391221899</c:v>
                </c:pt>
                <c:pt idx="20">
                  <c:v>30004.3528846593</c:v>
                </c:pt>
                <c:pt idx="21">
                  <c:v>18312.60518391932</c:v>
                </c:pt>
                <c:pt idx="22">
                  <c:v>6928.9013671875</c:v>
                </c:pt>
                <c:pt idx="23">
                  <c:v>5697.563130696614</c:v>
                </c:pt>
                <c:pt idx="24">
                  <c:v>8837.633600870765</c:v>
                </c:pt>
                <c:pt idx="25">
                  <c:v>30710.08902017283</c:v>
                </c:pt>
                <c:pt idx="26">
                  <c:v>21556.26265462242</c:v>
                </c:pt>
                <c:pt idx="27">
                  <c:v>5428.74126180013</c:v>
                </c:pt>
                <c:pt idx="28">
                  <c:v>14735.46796671548</c:v>
                </c:pt>
                <c:pt idx="29">
                  <c:v>4443.959411621095</c:v>
                </c:pt>
                <c:pt idx="30">
                  <c:v>6454.14870198568</c:v>
                </c:pt>
                <c:pt idx="31">
                  <c:v>4903.431172688803</c:v>
                </c:pt>
                <c:pt idx="32">
                  <c:v>8396.203206380218</c:v>
                </c:pt>
                <c:pt idx="33">
                  <c:v>3285.018074035643</c:v>
                </c:pt>
                <c:pt idx="34">
                  <c:v>5695.3960038272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2C0-427E-B74D-9809FB70EBCC}"/>
            </c:ext>
          </c:extLst>
        </c:ser>
        <c:ser>
          <c:idx val="1"/>
          <c:order val="1"/>
          <c:tx>
            <c:strRef>
              <c:f>'Interfect species'!$AA$212</c:f>
              <c:strCache>
                <c:ptCount val="1"/>
                <c:pt idx="0">
                  <c:v>INTERFER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G$213:$AG$247</c:f>
                <c:numCache>
                  <c:formatCode>General</c:formatCode>
                  <c:ptCount val="35"/>
                  <c:pt idx="0">
                    <c:v>14198.29768191603</c:v>
                  </c:pt>
                  <c:pt idx="1">
                    <c:v>54122.42954876537</c:v>
                  </c:pt>
                  <c:pt idx="2">
                    <c:v>31049.73833875425</c:v>
                  </c:pt>
                  <c:pt idx="3">
                    <c:v>4387.368163820433</c:v>
                  </c:pt>
                  <c:pt idx="4">
                    <c:v>87665.33622742782</c:v>
                  </c:pt>
                  <c:pt idx="5">
                    <c:v>101038.7247062126</c:v>
                  </c:pt>
                  <c:pt idx="6">
                    <c:v>21105.66724967622</c:v>
                  </c:pt>
                  <c:pt idx="7">
                    <c:v>2372.730490463577</c:v>
                  </c:pt>
                  <c:pt idx="8">
                    <c:v>5857.4673680028</c:v>
                  </c:pt>
                  <c:pt idx="9">
                    <c:v>2038.687832459996</c:v>
                  </c:pt>
                  <c:pt idx="10">
                    <c:v>769.4218506358917</c:v>
                  </c:pt>
                  <c:pt idx="11">
                    <c:v>9950.230599910668</c:v>
                  </c:pt>
                  <c:pt idx="12">
                    <c:v>173771.5092821293</c:v>
                  </c:pt>
                  <c:pt idx="13">
                    <c:v>68739.68874340898</c:v>
                  </c:pt>
                  <c:pt idx="14">
                    <c:v>4747.834617494523</c:v>
                  </c:pt>
                  <c:pt idx="15">
                    <c:v>3474.82494911538</c:v>
                  </c:pt>
                  <c:pt idx="16">
                    <c:v>4896.256352527043</c:v>
                  </c:pt>
                  <c:pt idx="17">
                    <c:v>1198.827696561949</c:v>
                  </c:pt>
                  <c:pt idx="18">
                    <c:v>19115.27100308205</c:v>
                  </c:pt>
                  <c:pt idx="19">
                    <c:v>99123.4039922013</c:v>
                  </c:pt>
                  <c:pt idx="20">
                    <c:v>11402.99702889227</c:v>
                  </c:pt>
                  <c:pt idx="21">
                    <c:v>2416.651797202743</c:v>
                  </c:pt>
                  <c:pt idx="22">
                    <c:v>1086.947775865218</c:v>
                  </c:pt>
                  <c:pt idx="23">
                    <c:v>955.8175832962021</c:v>
                  </c:pt>
                  <c:pt idx="24">
                    <c:v>2305.89056092663</c:v>
                  </c:pt>
                  <c:pt idx="25">
                    <c:v>8838.153635163955</c:v>
                  </c:pt>
                  <c:pt idx="26">
                    <c:v>3386.626186639612</c:v>
                  </c:pt>
                  <c:pt idx="27">
                    <c:v>902.580093104471</c:v>
                  </c:pt>
                  <c:pt idx="28">
                    <c:v>1596.634208039736</c:v>
                  </c:pt>
                  <c:pt idx="29">
                    <c:v>739.0911214355576</c:v>
                  </c:pt>
                  <c:pt idx="30">
                    <c:v>1334.44866813954</c:v>
                  </c:pt>
                  <c:pt idx="31">
                    <c:v>1028.646605583537</c:v>
                  </c:pt>
                  <c:pt idx="32">
                    <c:v>1564.099100315291</c:v>
                  </c:pt>
                  <c:pt idx="33">
                    <c:v>283.3820499833438</c:v>
                  </c:pt>
                  <c:pt idx="34">
                    <c:v>1451.000761900641</c:v>
                  </c:pt>
                </c:numCache>
              </c:numRef>
            </c:plus>
            <c:minus>
              <c:numRef>
                <c:f>'Interfect species'!$AG$213:$AG$247</c:f>
                <c:numCache>
                  <c:formatCode>General</c:formatCode>
                  <c:ptCount val="35"/>
                  <c:pt idx="0">
                    <c:v>14198.29768191603</c:v>
                  </c:pt>
                  <c:pt idx="1">
                    <c:v>54122.42954876537</c:v>
                  </c:pt>
                  <c:pt idx="2">
                    <c:v>31049.73833875425</c:v>
                  </c:pt>
                  <c:pt idx="3">
                    <c:v>4387.368163820433</c:v>
                  </c:pt>
                  <c:pt idx="4">
                    <c:v>87665.33622742782</c:v>
                  </c:pt>
                  <c:pt idx="5">
                    <c:v>101038.7247062126</c:v>
                  </c:pt>
                  <c:pt idx="6">
                    <c:v>21105.66724967622</c:v>
                  </c:pt>
                  <c:pt idx="7">
                    <c:v>2372.730490463577</c:v>
                  </c:pt>
                  <c:pt idx="8">
                    <c:v>5857.4673680028</c:v>
                  </c:pt>
                  <c:pt idx="9">
                    <c:v>2038.687832459996</c:v>
                  </c:pt>
                  <c:pt idx="10">
                    <c:v>769.4218506358917</c:v>
                  </c:pt>
                  <c:pt idx="11">
                    <c:v>9950.230599910668</c:v>
                  </c:pt>
                  <c:pt idx="12">
                    <c:v>173771.5092821293</c:v>
                  </c:pt>
                  <c:pt idx="13">
                    <c:v>68739.68874340898</c:v>
                  </c:pt>
                  <c:pt idx="14">
                    <c:v>4747.834617494523</c:v>
                  </c:pt>
                  <c:pt idx="15">
                    <c:v>3474.82494911538</c:v>
                  </c:pt>
                  <c:pt idx="16">
                    <c:v>4896.256352527043</c:v>
                  </c:pt>
                  <c:pt idx="17">
                    <c:v>1198.827696561949</c:v>
                  </c:pt>
                  <c:pt idx="18">
                    <c:v>19115.27100308205</c:v>
                  </c:pt>
                  <c:pt idx="19">
                    <c:v>99123.4039922013</c:v>
                  </c:pt>
                  <c:pt idx="20">
                    <c:v>11402.99702889227</c:v>
                  </c:pt>
                  <c:pt idx="21">
                    <c:v>2416.651797202743</c:v>
                  </c:pt>
                  <c:pt idx="22">
                    <c:v>1086.947775865218</c:v>
                  </c:pt>
                  <c:pt idx="23">
                    <c:v>955.8175832962021</c:v>
                  </c:pt>
                  <c:pt idx="24">
                    <c:v>2305.89056092663</c:v>
                  </c:pt>
                  <c:pt idx="25">
                    <c:v>8838.153635163955</c:v>
                  </c:pt>
                  <c:pt idx="26">
                    <c:v>3386.626186639612</c:v>
                  </c:pt>
                  <c:pt idx="27">
                    <c:v>902.580093104471</c:v>
                  </c:pt>
                  <c:pt idx="28">
                    <c:v>1596.634208039736</c:v>
                  </c:pt>
                  <c:pt idx="29">
                    <c:v>739.0911214355576</c:v>
                  </c:pt>
                  <c:pt idx="30">
                    <c:v>1334.44866813954</c:v>
                  </c:pt>
                  <c:pt idx="31">
                    <c:v>1028.646605583537</c:v>
                  </c:pt>
                  <c:pt idx="32">
                    <c:v>1564.099100315291</c:v>
                  </c:pt>
                  <c:pt idx="33">
                    <c:v>283.3820499833438</c:v>
                  </c:pt>
                  <c:pt idx="34">
                    <c:v>1451.0007619006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213:$Y$247</c:f>
              <c:strCache>
                <c:ptCount val="35"/>
                <c:pt idx="0">
                  <c:v>TG 46:1</c:v>
                </c:pt>
                <c:pt idx="1">
                  <c:v>TG 48:1</c:v>
                </c:pt>
                <c:pt idx="2">
                  <c:v>TG 48:2</c:v>
                </c:pt>
                <c:pt idx="3">
                  <c:v>TG 48:3</c:v>
                </c:pt>
                <c:pt idx="4">
                  <c:v>TG 50:1</c:v>
                </c:pt>
                <c:pt idx="5">
                  <c:v>TG 50:2</c:v>
                </c:pt>
                <c:pt idx="6">
                  <c:v>TG 50:3</c:v>
                </c:pt>
                <c:pt idx="7">
                  <c:v>TG 51:1</c:v>
                </c:pt>
                <c:pt idx="8">
                  <c:v>TG 51:2</c:v>
                </c:pt>
                <c:pt idx="9">
                  <c:v>TG 51:3</c:v>
                </c:pt>
                <c:pt idx="10">
                  <c:v>TG 52:0</c:v>
                </c:pt>
                <c:pt idx="11">
                  <c:v>TG 52:1</c:v>
                </c:pt>
                <c:pt idx="12">
                  <c:v>TG 52:2</c:v>
                </c:pt>
                <c:pt idx="13">
                  <c:v>TG 52:3</c:v>
                </c:pt>
                <c:pt idx="14">
                  <c:v>TG 52:4</c:v>
                </c:pt>
                <c:pt idx="15">
                  <c:v>TG 53:2</c:v>
                </c:pt>
                <c:pt idx="16">
                  <c:v>TG 53:3</c:v>
                </c:pt>
                <c:pt idx="17">
                  <c:v>TG 54:1</c:v>
                </c:pt>
                <c:pt idx="18">
                  <c:v>TG 54:2</c:v>
                </c:pt>
                <c:pt idx="19">
                  <c:v>TG 54:3</c:v>
                </c:pt>
                <c:pt idx="20">
                  <c:v>TG 54:4</c:v>
                </c:pt>
                <c:pt idx="21">
                  <c:v>TG 54:5</c:v>
                </c:pt>
                <c:pt idx="22">
                  <c:v>TG 54:6</c:v>
                </c:pt>
                <c:pt idx="23">
                  <c:v>TG 54:7</c:v>
                </c:pt>
                <c:pt idx="24">
                  <c:v>TG 55:3</c:v>
                </c:pt>
                <c:pt idx="25">
                  <c:v>TG 56:3</c:v>
                </c:pt>
                <c:pt idx="26">
                  <c:v>TG 56:6</c:v>
                </c:pt>
                <c:pt idx="27">
                  <c:v>TG 56:7A</c:v>
                </c:pt>
                <c:pt idx="28">
                  <c:v>TG 56:7B</c:v>
                </c:pt>
                <c:pt idx="29">
                  <c:v>TG 56:8</c:v>
                </c:pt>
                <c:pt idx="30">
                  <c:v>TG 58:3</c:v>
                </c:pt>
                <c:pt idx="31">
                  <c:v>TG 58:6</c:v>
                </c:pt>
                <c:pt idx="32">
                  <c:v>TG 58:8</c:v>
                </c:pt>
                <c:pt idx="33">
                  <c:v>TG 58:9</c:v>
                </c:pt>
                <c:pt idx="34">
                  <c:v>TG 60:3</c:v>
                </c:pt>
              </c:strCache>
            </c:strRef>
          </c:cat>
          <c:val>
            <c:numRef>
              <c:f>'Interfect species'!$AA$213:$AA$247</c:f>
              <c:numCache>
                <c:formatCode>General</c:formatCode>
                <c:ptCount val="35"/>
                <c:pt idx="0">
                  <c:v>75045.8158448428</c:v>
                </c:pt>
                <c:pt idx="1">
                  <c:v>277928.5188726824</c:v>
                </c:pt>
                <c:pt idx="2">
                  <c:v>136390.5211422225</c:v>
                </c:pt>
                <c:pt idx="3">
                  <c:v>17803.45370229086</c:v>
                </c:pt>
                <c:pt idx="4">
                  <c:v>496107.0037145636</c:v>
                </c:pt>
                <c:pt idx="5">
                  <c:v>491516.4257132841</c:v>
                </c:pt>
                <c:pt idx="6">
                  <c:v>86320.51855781223</c:v>
                </c:pt>
                <c:pt idx="7">
                  <c:v>16377.72428621615</c:v>
                </c:pt>
                <c:pt idx="8">
                  <c:v>39093.60943173175</c:v>
                </c:pt>
                <c:pt idx="9">
                  <c:v>11634.75302046701</c:v>
                </c:pt>
                <c:pt idx="10">
                  <c:v>13912.38960774741</c:v>
                </c:pt>
                <c:pt idx="11">
                  <c:v>73506.38902721969</c:v>
                </c:pt>
                <c:pt idx="12">
                  <c:v>829914.4317436917</c:v>
                </c:pt>
                <c:pt idx="13">
                  <c:v>252991.8295535977</c:v>
                </c:pt>
                <c:pt idx="14">
                  <c:v>16847.58723958335</c:v>
                </c:pt>
                <c:pt idx="15">
                  <c:v>19553.87074856168</c:v>
                </c:pt>
                <c:pt idx="16">
                  <c:v>21555.64126650196</c:v>
                </c:pt>
                <c:pt idx="17">
                  <c:v>7944.669599119105</c:v>
                </c:pt>
                <c:pt idx="18">
                  <c:v>91203.0393942428</c:v>
                </c:pt>
                <c:pt idx="19">
                  <c:v>372273.2845483924</c:v>
                </c:pt>
                <c:pt idx="20">
                  <c:v>36569.92947961866</c:v>
                </c:pt>
                <c:pt idx="21">
                  <c:v>20450.83760579432</c:v>
                </c:pt>
                <c:pt idx="22">
                  <c:v>7653.17138671875</c:v>
                </c:pt>
                <c:pt idx="23">
                  <c:v>6879.090881347656</c:v>
                </c:pt>
                <c:pt idx="24">
                  <c:v>9554.9148050944</c:v>
                </c:pt>
                <c:pt idx="25">
                  <c:v>34837.64165427602</c:v>
                </c:pt>
                <c:pt idx="26">
                  <c:v>23873.77152506513</c:v>
                </c:pt>
                <c:pt idx="27">
                  <c:v>6166.026021321617</c:v>
                </c:pt>
                <c:pt idx="28">
                  <c:v>16069.7894897461</c:v>
                </c:pt>
                <c:pt idx="29">
                  <c:v>5723.558186848958</c:v>
                </c:pt>
                <c:pt idx="30">
                  <c:v>7828.737927754722</c:v>
                </c:pt>
                <c:pt idx="31">
                  <c:v>5270.772298177087</c:v>
                </c:pt>
                <c:pt idx="32">
                  <c:v>9336.000386556</c:v>
                </c:pt>
                <c:pt idx="33">
                  <c:v>3434.158589680988</c:v>
                </c:pt>
                <c:pt idx="34">
                  <c:v>7189.2299384663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2C0-427E-B74D-9809FB70EBCC}"/>
            </c:ext>
          </c:extLst>
        </c:ser>
        <c:ser>
          <c:idx val="2"/>
          <c:order val="2"/>
          <c:tx>
            <c:strRef>
              <c:f>'Interfect species'!$AB$212</c:f>
              <c:strCache>
                <c:ptCount val="1"/>
                <c:pt idx="0">
                  <c:v>INTERFERin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213:$AH$247</c:f>
                <c:numCache>
                  <c:formatCode>General</c:formatCode>
                  <c:ptCount val="35"/>
                  <c:pt idx="0">
                    <c:v>6824.399605001</c:v>
                  </c:pt>
                  <c:pt idx="1">
                    <c:v>35113.2534953781</c:v>
                  </c:pt>
                  <c:pt idx="2">
                    <c:v>16079.19057890402</c:v>
                  </c:pt>
                  <c:pt idx="3">
                    <c:v>1818.958321132541</c:v>
                  </c:pt>
                  <c:pt idx="4">
                    <c:v>72355.86354355662</c:v>
                  </c:pt>
                  <c:pt idx="5">
                    <c:v>53959.22651898807</c:v>
                  </c:pt>
                  <c:pt idx="6">
                    <c:v>9381.87307741873</c:v>
                  </c:pt>
                  <c:pt idx="7">
                    <c:v>2094.358709380242</c:v>
                  </c:pt>
                  <c:pt idx="8">
                    <c:v>3918.425028595123</c:v>
                  </c:pt>
                  <c:pt idx="9">
                    <c:v>1164.307055126316</c:v>
                  </c:pt>
                  <c:pt idx="10">
                    <c:v>886.8370979316812</c:v>
                  </c:pt>
                  <c:pt idx="11">
                    <c:v>10334.0964067225</c:v>
                  </c:pt>
                  <c:pt idx="12">
                    <c:v>95882.0588905063</c:v>
                  </c:pt>
                  <c:pt idx="13">
                    <c:v>30636.7445967093</c:v>
                  </c:pt>
                  <c:pt idx="14">
                    <c:v>1338.657714570502</c:v>
                  </c:pt>
                  <c:pt idx="15">
                    <c:v>2046.225508877178</c:v>
                  </c:pt>
                  <c:pt idx="16">
                    <c:v>2962.839480528977</c:v>
                  </c:pt>
                  <c:pt idx="17">
                    <c:v>855.5264617738662</c:v>
                  </c:pt>
                  <c:pt idx="18">
                    <c:v>11060.47485223249</c:v>
                  </c:pt>
                  <c:pt idx="19">
                    <c:v>48153.9907472077</c:v>
                  </c:pt>
                  <c:pt idx="20">
                    <c:v>3212.494488702314</c:v>
                  </c:pt>
                  <c:pt idx="21">
                    <c:v>1167.66124856548</c:v>
                  </c:pt>
                  <c:pt idx="22">
                    <c:v>1463.687086335731</c:v>
                  </c:pt>
                  <c:pt idx="23">
                    <c:v>615.4514940330122</c:v>
                  </c:pt>
                  <c:pt idx="24">
                    <c:v>1246.896705770033</c:v>
                  </c:pt>
                  <c:pt idx="25">
                    <c:v>5385.229886179193</c:v>
                  </c:pt>
                  <c:pt idx="26">
                    <c:v>2472.787265241121</c:v>
                  </c:pt>
                  <c:pt idx="27">
                    <c:v>586.6112017929196</c:v>
                  </c:pt>
                  <c:pt idx="28">
                    <c:v>1759.949185178606</c:v>
                  </c:pt>
                  <c:pt idx="29">
                    <c:v>577.7395521613698</c:v>
                  </c:pt>
                  <c:pt idx="30">
                    <c:v>1191.449763193946</c:v>
                  </c:pt>
                  <c:pt idx="31">
                    <c:v>465.4650222074019</c:v>
                  </c:pt>
                  <c:pt idx="32">
                    <c:v>777.7297644975965</c:v>
                  </c:pt>
                  <c:pt idx="33">
                    <c:v>341.6126487000558</c:v>
                  </c:pt>
                  <c:pt idx="34">
                    <c:v>816.3241320388246</c:v>
                  </c:pt>
                </c:numCache>
              </c:numRef>
            </c:plus>
            <c:minus>
              <c:numRef>
                <c:f>'Interfect species'!$AH$213:$AH$247</c:f>
                <c:numCache>
                  <c:formatCode>General</c:formatCode>
                  <c:ptCount val="35"/>
                  <c:pt idx="0">
                    <c:v>6824.399605001</c:v>
                  </c:pt>
                  <c:pt idx="1">
                    <c:v>35113.2534953781</c:v>
                  </c:pt>
                  <c:pt idx="2">
                    <c:v>16079.19057890402</c:v>
                  </c:pt>
                  <c:pt idx="3">
                    <c:v>1818.958321132541</c:v>
                  </c:pt>
                  <c:pt idx="4">
                    <c:v>72355.86354355662</c:v>
                  </c:pt>
                  <c:pt idx="5">
                    <c:v>53959.22651898807</c:v>
                  </c:pt>
                  <c:pt idx="6">
                    <c:v>9381.87307741873</c:v>
                  </c:pt>
                  <c:pt idx="7">
                    <c:v>2094.358709380242</c:v>
                  </c:pt>
                  <c:pt idx="8">
                    <c:v>3918.425028595123</c:v>
                  </c:pt>
                  <c:pt idx="9">
                    <c:v>1164.307055126316</c:v>
                  </c:pt>
                  <c:pt idx="10">
                    <c:v>886.8370979316812</c:v>
                  </c:pt>
                  <c:pt idx="11">
                    <c:v>10334.0964067225</c:v>
                  </c:pt>
                  <c:pt idx="12">
                    <c:v>95882.0588905063</c:v>
                  </c:pt>
                  <c:pt idx="13">
                    <c:v>30636.7445967093</c:v>
                  </c:pt>
                  <c:pt idx="14">
                    <c:v>1338.657714570502</c:v>
                  </c:pt>
                  <c:pt idx="15">
                    <c:v>2046.225508877178</c:v>
                  </c:pt>
                  <c:pt idx="16">
                    <c:v>2962.839480528977</c:v>
                  </c:pt>
                  <c:pt idx="17">
                    <c:v>855.5264617738662</c:v>
                  </c:pt>
                  <c:pt idx="18">
                    <c:v>11060.47485223249</c:v>
                  </c:pt>
                  <c:pt idx="19">
                    <c:v>48153.9907472077</c:v>
                  </c:pt>
                  <c:pt idx="20">
                    <c:v>3212.494488702314</c:v>
                  </c:pt>
                  <c:pt idx="21">
                    <c:v>1167.66124856548</c:v>
                  </c:pt>
                  <c:pt idx="22">
                    <c:v>1463.687086335731</c:v>
                  </c:pt>
                  <c:pt idx="23">
                    <c:v>615.4514940330122</c:v>
                  </c:pt>
                  <c:pt idx="24">
                    <c:v>1246.896705770033</c:v>
                  </c:pt>
                  <c:pt idx="25">
                    <c:v>5385.229886179193</c:v>
                  </c:pt>
                  <c:pt idx="26">
                    <c:v>2472.787265241121</c:v>
                  </c:pt>
                  <c:pt idx="27">
                    <c:v>586.6112017929196</c:v>
                  </c:pt>
                  <c:pt idx="28">
                    <c:v>1759.949185178606</c:v>
                  </c:pt>
                  <c:pt idx="29">
                    <c:v>577.7395521613698</c:v>
                  </c:pt>
                  <c:pt idx="30">
                    <c:v>1191.449763193946</c:v>
                  </c:pt>
                  <c:pt idx="31">
                    <c:v>465.4650222074019</c:v>
                  </c:pt>
                  <c:pt idx="32">
                    <c:v>777.7297644975965</c:v>
                  </c:pt>
                  <c:pt idx="33">
                    <c:v>341.6126487000558</c:v>
                  </c:pt>
                  <c:pt idx="34">
                    <c:v>816.32413203882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213:$Y$247</c:f>
              <c:strCache>
                <c:ptCount val="35"/>
                <c:pt idx="0">
                  <c:v>TG 46:1</c:v>
                </c:pt>
                <c:pt idx="1">
                  <c:v>TG 48:1</c:v>
                </c:pt>
                <c:pt idx="2">
                  <c:v>TG 48:2</c:v>
                </c:pt>
                <c:pt idx="3">
                  <c:v>TG 48:3</c:v>
                </c:pt>
                <c:pt idx="4">
                  <c:v>TG 50:1</c:v>
                </c:pt>
                <c:pt idx="5">
                  <c:v>TG 50:2</c:v>
                </c:pt>
                <c:pt idx="6">
                  <c:v>TG 50:3</c:v>
                </c:pt>
                <c:pt idx="7">
                  <c:v>TG 51:1</c:v>
                </c:pt>
                <c:pt idx="8">
                  <c:v>TG 51:2</c:v>
                </c:pt>
                <c:pt idx="9">
                  <c:v>TG 51:3</c:v>
                </c:pt>
                <c:pt idx="10">
                  <c:v>TG 52:0</c:v>
                </c:pt>
                <c:pt idx="11">
                  <c:v>TG 52:1</c:v>
                </c:pt>
                <c:pt idx="12">
                  <c:v>TG 52:2</c:v>
                </c:pt>
                <c:pt idx="13">
                  <c:v>TG 52:3</c:v>
                </c:pt>
                <c:pt idx="14">
                  <c:v>TG 52:4</c:v>
                </c:pt>
                <c:pt idx="15">
                  <c:v>TG 53:2</c:v>
                </c:pt>
                <c:pt idx="16">
                  <c:v>TG 53:3</c:v>
                </c:pt>
                <c:pt idx="17">
                  <c:v>TG 54:1</c:v>
                </c:pt>
                <c:pt idx="18">
                  <c:v>TG 54:2</c:v>
                </c:pt>
                <c:pt idx="19">
                  <c:v>TG 54:3</c:v>
                </c:pt>
                <c:pt idx="20">
                  <c:v>TG 54:4</c:v>
                </c:pt>
                <c:pt idx="21">
                  <c:v>TG 54:5</c:v>
                </c:pt>
                <c:pt idx="22">
                  <c:v>TG 54:6</c:v>
                </c:pt>
                <c:pt idx="23">
                  <c:v>TG 54:7</c:v>
                </c:pt>
                <c:pt idx="24">
                  <c:v>TG 55:3</c:v>
                </c:pt>
                <c:pt idx="25">
                  <c:v>TG 56:3</c:v>
                </c:pt>
                <c:pt idx="26">
                  <c:v>TG 56:6</c:v>
                </c:pt>
                <c:pt idx="27">
                  <c:v>TG 56:7A</c:v>
                </c:pt>
                <c:pt idx="28">
                  <c:v>TG 56:7B</c:v>
                </c:pt>
                <c:pt idx="29">
                  <c:v>TG 56:8</c:v>
                </c:pt>
                <c:pt idx="30">
                  <c:v>TG 58:3</c:v>
                </c:pt>
                <c:pt idx="31">
                  <c:v>TG 58:6</c:v>
                </c:pt>
                <c:pt idx="32">
                  <c:v>TG 58:8</c:v>
                </c:pt>
                <c:pt idx="33">
                  <c:v>TG 58:9</c:v>
                </c:pt>
                <c:pt idx="34">
                  <c:v>TG 60:3</c:v>
                </c:pt>
              </c:strCache>
            </c:strRef>
          </c:cat>
          <c:val>
            <c:numRef>
              <c:f>'Interfect species'!$AB$213:$AB$247</c:f>
              <c:numCache>
                <c:formatCode>General</c:formatCode>
                <c:ptCount val="35"/>
                <c:pt idx="0">
                  <c:v>54227.28499889242</c:v>
                </c:pt>
                <c:pt idx="1">
                  <c:v>210682.8126025643</c:v>
                </c:pt>
                <c:pt idx="2">
                  <c:v>90745.58756753795</c:v>
                </c:pt>
                <c:pt idx="3">
                  <c:v>11841.74103546142</c:v>
                </c:pt>
                <c:pt idx="4">
                  <c:v>414203.3017873568</c:v>
                </c:pt>
                <c:pt idx="5">
                  <c:v>332399.1217627073</c:v>
                </c:pt>
                <c:pt idx="6">
                  <c:v>57155.72445892036</c:v>
                </c:pt>
                <c:pt idx="7">
                  <c:v>15003.80213212213</c:v>
                </c:pt>
                <c:pt idx="8">
                  <c:v>30526.25087774449</c:v>
                </c:pt>
                <c:pt idx="9">
                  <c:v>8689.41239930027</c:v>
                </c:pt>
                <c:pt idx="10">
                  <c:v>16479.44352213545</c:v>
                </c:pt>
                <c:pt idx="11">
                  <c:v>69973.83755349135</c:v>
                </c:pt>
                <c:pt idx="12">
                  <c:v>595580.5770082562</c:v>
                </c:pt>
                <c:pt idx="13">
                  <c:v>164156.9965675829</c:v>
                </c:pt>
                <c:pt idx="14">
                  <c:v>12224.03751627605</c:v>
                </c:pt>
                <c:pt idx="15">
                  <c:v>16034.515279296</c:v>
                </c:pt>
                <c:pt idx="16">
                  <c:v>15522.38751631253</c:v>
                </c:pt>
                <c:pt idx="17">
                  <c:v>8737.9475708185</c:v>
                </c:pt>
                <c:pt idx="18">
                  <c:v>71618.81778115685</c:v>
                </c:pt>
                <c:pt idx="19">
                  <c:v>240794.3019074053</c:v>
                </c:pt>
                <c:pt idx="20">
                  <c:v>24854.4039132542</c:v>
                </c:pt>
                <c:pt idx="21">
                  <c:v>19025.71539306642</c:v>
                </c:pt>
                <c:pt idx="22">
                  <c:v>7138.794514973961</c:v>
                </c:pt>
                <c:pt idx="23">
                  <c:v>5973.791168212891</c:v>
                </c:pt>
                <c:pt idx="24">
                  <c:v>6493.149454752605</c:v>
                </c:pt>
                <c:pt idx="25">
                  <c:v>24342.61725675632</c:v>
                </c:pt>
                <c:pt idx="26">
                  <c:v>23390.00606282555</c:v>
                </c:pt>
                <c:pt idx="27">
                  <c:v>5871.298695882163</c:v>
                </c:pt>
                <c:pt idx="28">
                  <c:v>16965.50313822429</c:v>
                </c:pt>
                <c:pt idx="29">
                  <c:v>5294.491353352868</c:v>
                </c:pt>
                <c:pt idx="30">
                  <c:v>5897.001416524251</c:v>
                </c:pt>
                <c:pt idx="31">
                  <c:v>5683.31656901042</c:v>
                </c:pt>
                <c:pt idx="32">
                  <c:v>9291.768961588541</c:v>
                </c:pt>
                <c:pt idx="33">
                  <c:v>3918.733540852867</c:v>
                </c:pt>
                <c:pt idx="34">
                  <c:v>5829.6708120186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2C0-427E-B74D-9809FB70EB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081348760"/>
        <c:axId val="2081342712"/>
      </c:barChart>
      <c:catAx>
        <c:axId val="2081348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1342712"/>
        <c:crosses val="autoZero"/>
        <c:auto val="1"/>
        <c:lblAlgn val="ctr"/>
        <c:lblOffset val="100"/>
        <c:noMultiLvlLbl val="0"/>
      </c:catAx>
      <c:valAx>
        <c:axId val="20813427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13487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terfect species'!$AA$28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G$29:$AG$77</c:f>
                <c:numCache>
                  <c:formatCode>General</c:formatCode>
                  <c:ptCount val="49"/>
                  <c:pt idx="0">
                    <c:v>2184.276928374044</c:v>
                  </c:pt>
                  <c:pt idx="1">
                    <c:v>413257.0304281161</c:v>
                  </c:pt>
                  <c:pt idx="2">
                    <c:v>3516.218991781369</c:v>
                  </c:pt>
                  <c:pt idx="3">
                    <c:v>737148.0632633935</c:v>
                  </c:pt>
                  <c:pt idx="4">
                    <c:v>147546.6192655401</c:v>
                  </c:pt>
                  <c:pt idx="5">
                    <c:v>19117.60122846219</c:v>
                  </c:pt>
                  <c:pt idx="6">
                    <c:v>411729.7820933628</c:v>
                  </c:pt>
                  <c:pt idx="7">
                    <c:v>3944.4103424159</c:v>
                  </c:pt>
                  <c:pt idx="8">
                    <c:v>25816.27645592385</c:v>
                  </c:pt>
                  <c:pt idx="9">
                    <c:v>19762.38288478992</c:v>
                  </c:pt>
                  <c:pt idx="10">
                    <c:v>209034.8150694516</c:v>
                  </c:pt>
                  <c:pt idx="11">
                    <c:v>32537.13870231182</c:v>
                  </c:pt>
                  <c:pt idx="12">
                    <c:v>604590.7068867671</c:v>
                  </c:pt>
                  <c:pt idx="13">
                    <c:v>692066.1765085921</c:v>
                  </c:pt>
                  <c:pt idx="14">
                    <c:v>88723.6092402353</c:v>
                  </c:pt>
                  <c:pt idx="15">
                    <c:v>913.3123530226916</c:v>
                  </c:pt>
                  <c:pt idx="16">
                    <c:v>26097.03674059185</c:v>
                  </c:pt>
                  <c:pt idx="17">
                    <c:v>311496.1359767289</c:v>
                  </c:pt>
                  <c:pt idx="18">
                    <c:v>92127.22311928466</c:v>
                  </c:pt>
                  <c:pt idx="19">
                    <c:v>299284.473512925</c:v>
                  </c:pt>
                  <c:pt idx="20">
                    <c:v>8331.967845591847</c:v>
                  </c:pt>
                  <c:pt idx="21">
                    <c:v>755.2560541922411</c:v>
                  </c:pt>
                  <c:pt idx="22">
                    <c:v>7979.718906001255</c:v>
                  </c:pt>
                  <c:pt idx="23">
                    <c:v>2709.4447193454</c:v>
                  </c:pt>
                  <c:pt idx="24">
                    <c:v>7979.42063808196</c:v>
                  </c:pt>
                  <c:pt idx="25">
                    <c:v>35261.88635553957</c:v>
                  </c:pt>
                  <c:pt idx="26">
                    <c:v>76760.07627749724</c:v>
                  </c:pt>
                  <c:pt idx="27">
                    <c:v>288345.2135677933</c:v>
                  </c:pt>
                  <c:pt idx="28">
                    <c:v>50503.405001221</c:v>
                  </c:pt>
                  <c:pt idx="29">
                    <c:v>35761.32776295527</c:v>
                  </c:pt>
                  <c:pt idx="30">
                    <c:v>18632.85778783976</c:v>
                  </c:pt>
                  <c:pt idx="31">
                    <c:v>489861.5388954869</c:v>
                  </c:pt>
                  <c:pt idx="32">
                    <c:v>489861.5388954869</c:v>
                  </c:pt>
                  <c:pt idx="33">
                    <c:v>697760.2683284231</c:v>
                  </c:pt>
                  <c:pt idx="34">
                    <c:v>341288.8621472091</c:v>
                  </c:pt>
                  <c:pt idx="35">
                    <c:v>427572.6262189615</c:v>
                  </c:pt>
                  <c:pt idx="36">
                    <c:v>3649.297636925854</c:v>
                  </c:pt>
                  <c:pt idx="37">
                    <c:v>31470.51258959593</c:v>
                  </c:pt>
                  <c:pt idx="38">
                    <c:v>23532.7939934579</c:v>
                  </c:pt>
                  <c:pt idx="39">
                    <c:v>1935.460064348566</c:v>
                  </c:pt>
                  <c:pt idx="40">
                    <c:v>1893.055555545185</c:v>
                  </c:pt>
                  <c:pt idx="41">
                    <c:v>28045.996538814</c:v>
                  </c:pt>
                  <c:pt idx="42">
                    <c:v>6503.83020269655</c:v>
                  </c:pt>
                  <c:pt idx="43">
                    <c:v>17864.58044743132</c:v>
                  </c:pt>
                  <c:pt idx="44">
                    <c:v>3820.174688877054</c:v>
                  </c:pt>
                  <c:pt idx="45">
                    <c:v>4457.475554268884</c:v>
                  </c:pt>
                  <c:pt idx="46">
                    <c:v>59487.2011162097</c:v>
                  </c:pt>
                  <c:pt idx="47">
                    <c:v>921.1661780245247</c:v>
                  </c:pt>
                  <c:pt idx="48">
                    <c:v>14149.09251594172</c:v>
                  </c:pt>
                </c:numCache>
              </c:numRef>
            </c:plus>
            <c:minus>
              <c:numRef>
                <c:f>'Interfect species'!$AG$29:$AG$77</c:f>
                <c:numCache>
                  <c:formatCode>General</c:formatCode>
                  <c:ptCount val="49"/>
                  <c:pt idx="0">
                    <c:v>2184.276928374044</c:v>
                  </c:pt>
                  <c:pt idx="1">
                    <c:v>413257.0304281161</c:v>
                  </c:pt>
                  <c:pt idx="2">
                    <c:v>3516.218991781369</c:v>
                  </c:pt>
                  <c:pt idx="3">
                    <c:v>737148.0632633935</c:v>
                  </c:pt>
                  <c:pt idx="4">
                    <c:v>147546.6192655401</c:v>
                  </c:pt>
                  <c:pt idx="5">
                    <c:v>19117.60122846219</c:v>
                  </c:pt>
                  <c:pt idx="6">
                    <c:v>411729.7820933628</c:v>
                  </c:pt>
                  <c:pt idx="7">
                    <c:v>3944.4103424159</c:v>
                  </c:pt>
                  <c:pt idx="8">
                    <c:v>25816.27645592385</c:v>
                  </c:pt>
                  <c:pt idx="9">
                    <c:v>19762.38288478992</c:v>
                  </c:pt>
                  <c:pt idx="10">
                    <c:v>209034.8150694516</c:v>
                  </c:pt>
                  <c:pt idx="11">
                    <c:v>32537.13870231182</c:v>
                  </c:pt>
                  <c:pt idx="12">
                    <c:v>604590.7068867671</c:v>
                  </c:pt>
                  <c:pt idx="13">
                    <c:v>692066.1765085921</c:v>
                  </c:pt>
                  <c:pt idx="14">
                    <c:v>88723.6092402353</c:v>
                  </c:pt>
                  <c:pt idx="15">
                    <c:v>913.3123530226916</c:v>
                  </c:pt>
                  <c:pt idx="16">
                    <c:v>26097.03674059185</c:v>
                  </c:pt>
                  <c:pt idx="17">
                    <c:v>311496.1359767289</c:v>
                  </c:pt>
                  <c:pt idx="18">
                    <c:v>92127.22311928466</c:v>
                  </c:pt>
                  <c:pt idx="19">
                    <c:v>299284.473512925</c:v>
                  </c:pt>
                  <c:pt idx="20">
                    <c:v>8331.967845591847</c:v>
                  </c:pt>
                  <c:pt idx="21">
                    <c:v>755.2560541922411</c:v>
                  </c:pt>
                  <c:pt idx="22">
                    <c:v>7979.718906001255</c:v>
                  </c:pt>
                  <c:pt idx="23">
                    <c:v>2709.4447193454</c:v>
                  </c:pt>
                  <c:pt idx="24">
                    <c:v>7979.42063808196</c:v>
                  </c:pt>
                  <c:pt idx="25">
                    <c:v>35261.88635553957</c:v>
                  </c:pt>
                  <c:pt idx="26">
                    <c:v>76760.07627749724</c:v>
                  </c:pt>
                  <c:pt idx="27">
                    <c:v>288345.2135677933</c:v>
                  </c:pt>
                  <c:pt idx="28">
                    <c:v>50503.405001221</c:v>
                  </c:pt>
                  <c:pt idx="29">
                    <c:v>35761.32776295527</c:v>
                  </c:pt>
                  <c:pt idx="30">
                    <c:v>18632.85778783976</c:v>
                  </c:pt>
                  <c:pt idx="31">
                    <c:v>489861.5388954869</c:v>
                  </c:pt>
                  <c:pt idx="32">
                    <c:v>489861.5388954869</c:v>
                  </c:pt>
                  <c:pt idx="33">
                    <c:v>697760.2683284231</c:v>
                  </c:pt>
                  <c:pt idx="34">
                    <c:v>341288.8621472091</c:v>
                  </c:pt>
                  <c:pt idx="35">
                    <c:v>427572.6262189615</c:v>
                  </c:pt>
                  <c:pt idx="36">
                    <c:v>3649.297636925854</c:v>
                  </c:pt>
                  <c:pt idx="37">
                    <c:v>31470.51258959593</c:v>
                  </c:pt>
                  <c:pt idx="38">
                    <c:v>23532.7939934579</c:v>
                  </c:pt>
                  <c:pt idx="39">
                    <c:v>1935.460064348566</c:v>
                  </c:pt>
                  <c:pt idx="40">
                    <c:v>1893.055555545185</c:v>
                  </c:pt>
                  <c:pt idx="41">
                    <c:v>28045.996538814</c:v>
                  </c:pt>
                  <c:pt idx="42">
                    <c:v>6503.83020269655</c:v>
                  </c:pt>
                  <c:pt idx="43">
                    <c:v>17864.58044743132</c:v>
                  </c:pt>
                  <c:pt idx="44">
                    <c:v>3820.174688877054</c:v>
                  </c:pt>
                  <c:pt idx="45">
                    <c:v>4457.475554268884</c:v>
                  </c:pt>
                  <c:pt idx="46">
                    <c:v>59487.2011162097</c:v>
                  </c:pt>
                  <c:pt idx="47">
                    <c:v>921.1661780245247</c:v>
                  </c:pt>
                  <c:pt idx="48">
                    <c:v>14149.092515941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Z$29:$Z$77</c:f>
              <c:strCache>
                <c:ptCount val="49"/>
                <c:pt idx="0">
                  <c:v>LPE 16:0</c:v>
                </c:pt>
                <c:pt idx="1">
                  <c:v>PE 16:0_16:1</c:v>
                </c:pt>
                <c:pt idx="2">
                  <c:v>PE 16:0_18:0</c:v>
                </c:pt>
                <c:pt idx="3">
                  <c:v>PE 16:0_18:1</c:v>
                </c:pt>
                <c:pt idx="4">
                  <c:v>PE 16:0_20:4</c:v>
                </c:pt>
                <c:pt idx="5">
                  <c:v>PE 16:0_20:5</c:v>
                </c:pt>
                <c:pt idx="6">
                  <c:v>PE 16:1_18:1</c:v>
                </c:pt>
                <c:pt idx="7">
                  <c:v>PE 17:0_20:4</c:v>
                </c:pt>
                <c:pt idx="8">
                  <c:v>PE 18:0_20:2</c:v>
                </c:pt>
                <c:pt idx="9">
                  <c:v>PE 18:0_20:3</c:v>
                </c:pt>
                <c:pt idx="10">
                  <c:v>PE 18:0_20:5</c:v>
                </c:pt>
                <c:pt idx="11">
                  <c:v>PE 18:0_22:5</c:v>
                </c:pt>
                <c:pt idx="12">
                  <c:v>PE 18:0_22:6</c:v>
                </c:pt>
                <c:pt idx="13">
                  <c:v>PE 18:1_18:1</c:v>
                </c:pt>
                <c:pt idx="14">
                  <c:v>PE 18:1_18:2</c:v>
                </c:pt>
                <c:pt idx="15">
                  <c:v>PE 18:1_20:0</c:v>
                </c:pt>
                <c:pt idx="16">
                  <c:v>PE 18:1_20:1</c:v>
                </c:pt>
                <c:pt idx="17">
                  <c:v>PE 18:1_20:3</c:v>
                </c:pt>
                <c:pt idx="18">
                  <c:v>PE 18:1_20:5</c:v>
                </c:pt>
                <c:pt idx="19">
                  <c:v>PE 18:1_22:6</c:v>
                </c:pt>
                <c:pt idx="20">
                  <c:v>PE 20:1_20:3</c:v>
                </c:pt>
                <c:pt idx="21">
                  <c:v>PE 20:5_22:6</c:v>
                </c:pt>
                <c:pt idx="22">
                  <c:v>PE P-14:0_16:1</c:v>
                </c:pt>
                <c:pt idx="23">
                  <c:v>PE P-16:0_12:0 </c:v>
                </c:pt>
                <c:pt idx="24">
                  <c:v>PE P-16:0_14:1</c:v>
                </c:pt>
                <c:pt idx="25">
                  <c:v>PE P-16:0_16:0</c:v>
                </c:pt>
                <c:pt idx="26">
                  <c:v>PE P-16:0_16:1</c:v>
                </c:pt>
                <c:pt idx="27">
                  <c:v>PE P-16:0_18:1</c:v>
                </c:pt>
                <c:pt idx="28">
                  <c:v>PE P-16:0_18:2</c:v>
                </c:pt>
                <c:pt idx="29">
                  <c:v>PE P-16:0_20:3</c:v>
                </c:pt>
                <c:pt idx="30">
                  <c:v>PE P-16:0_20:3</c:v>
                </c:pt>
                <c:pt idx="31">
                  <c:v>PE P-16:0_20:4 A</c:v>
                </c:pt>
                <c:pt idx="32">
                  <c:v>PE P-16:0_20:4 B</c:v>
                </c:pt>
                <c:pt idx="33">
                  <c:v>PE P-16:0_20:5</c:v>
                </c:pt>
                <c:pt idx="34">
                  <c:v>PE P-16:0_22:5</c:v>
                </c:pt>
                <c:pt idx="35">
                  <c:v>PE P-16:0_22:6</c:v>
                </c:pt>
                <c:pt idx="36">
                  <c:v>PE P-17:0_18:1</c:v>
                </c:pt>
                <c:pt idx="37">
                  <c:v>PE P-17:0_20:4</c:v>
                </c:pt>
                <c:pt idx="38">
                  <c:v>PE P-17:0_22:6</c:v>
                </c:pt>
                <c:pt idx="39">
                  <c:v>PE P-18:0_16:0</c:v>
                </c:pt>
                <c:pt idx="40">
                  <c:v>PE P-18:0_16:0</c:v>
                </c:pt>
                <c:pt idx="41">
                  <c:v>PE P-18:0_18:1</c:v>
                </c:pt>
                <c:pt idx="42">
                  <c:v>PE P-18:0_18:1</c:v>
                </c:pt>
                <c:pt idx="43">
                  <c:v>PE P-18:0_20:3</c:v>
                </c:pt>
                <c:pt idx="44">
                  <c:v>PE P-18:0_22:4</c:v>
                </c:pt>
                <c:pt idx="45">
                  <c:v>PE P-18:0_22:5</c:v>
                </c:pt>
                <c:pt idx="46">
                  <c:v>PE P-18:0_22:6</c:v>
                </c:pt>
                <c:pt idx="47">
                  <c:v>PE P-20:0_22:6</c:v>
                </c:pt>
                <c:pt idx="48">
                  <c:v>PE P-32:4</c:v>
                </c:pt>
              </c:strCache>
            </c:strRef>
          </c:cat>
          <c:val>
            <c:numRef>
              <c:f>'Interfect species'!$AA$29:$AA$77</c:f>
              <c:numCache>
                <c:formatCode>General</c:formatCode>
                <c:ptCount val="49"/>
                <c:pt idx="0">
                  <c:v>16338.15492757162</c:v>
                </c:pt>
                <c:pt idx="1">
                  <c:v>1.73064352205404E6</c:v>
                </c:pt>
                <c:pt idx="2">
                  <c:v>104617.9330647787</c:v>
                </c:pt>
                <c:pt idx="3">
                  <c:v>3.28547081835937E6</c:v>
                </c:pt>
                <c:pt idx="4">
                  <c:v>747781.2091471354</c:v>
                </c:pt>
                <c:pt idx="5">
                  <c:v>187387.072591146</c:v>
                </c:pt>
                <c:pt idx="6">
                  <c:v>1.5451203282453E6</c:v>
                </c:pt>
                <c:pt idx="7">
                  <c:v>46534.60660807292</c:v>
                </c:pt>
                <c:pt idx="8">
                  <c:v>111104.6025390625</c:v>
                </c:pt>
                <c:pt idx="9">
                  <c:v>122229.9427083334</c:v>
                </c:pt>
                <c:pt idx="10">
                  <c:v>895808.6521949846</c:v>
                </c:pt>
                <c:pt idx="11">
                  <c:v>242538.6790184791</c:v>
                </c:pt>
                <c:pt idx="12">
                  <c:v>4.4343436532387E6</c:v>
                </c:pt>
                <c:pt idx="13">
                  <c:v>3.73655769821481E6</c:v>
                </c:pt>
                <c:pt idx="14">
                  <c:v>413945.7594904778</c:v>
                </c:pt>
                <c:pt idx="15">
                  <c:v>26304.77189127605</c:v>
                </c:pt>
                <c:pt idx="16">
                  <c:v>96121.81510416681</c:v>
                </c:pt>
                <c:pt idx="17">
                  <c:v>2.26589314863182E6</c:v>
                </c:pt>
                <c:pt idx="18">
                  <c:v>459923.0401882352</c:v>
                </c:pt>
                <c:pt idx="19">
                  <c:v>1.00987816310169E6</c:v>
                </c:pt>
                <c:pt idx="20">
                  <c:v>35145.13069661459</c:v>
                </c:pt>
                <c:pt idx="21">
                  <c:v>6012.51355489095</c:v>
                </c:pt>
                <c:pt idx="22">
                  <c:v>10436.10793558757</c:v>
                </c:pt>
                <c:pt idx="23">
                  <c:v>7094.118489583336</c:v>
                </c:pt>
                <c:pt idx="24">
                  <c:v>9208.379659016924</c:v>
                </c:pt>
                <c:pt idx="25">
                  <c:v>73048.35461425782</c:v>
                </c:pt>
                <c:pt idx="26">
                  <c:v>244696.6805419925</c:v>
                </c:pt>
                <c:pt idx="27">
                  <c:v>1.08641539163606E6</c:v>
                </c:pt>
                <c:pt idx="28">
                  <c:v>175734.8177083333</c:v>
                </c:pt>
                <c:pt idx="29">
                  <c:v>77064.37369791667</c:v>
                </c:pt>
                <c:pt idx="30">
                  <c:v>54849.63460286459</c:v>
                </c:pt>
                <c:pt idx="31">
                  <c:v>2.83415865234375E6</c:v>
                </c:pt>
                <c:pt idx="32">
                  <c:v>2.83415865234375E6</c:v>
                </c:pt>
                <c:pt idx="33">
                  <c:v>3.05723030338542E6</c:v>
                </c:pt>
                <c:pt idx="34">
                  <c:v>1.91244012044271E6</c:v>
                </c:pt>
                <c:pt idx="35">
                  <c:v>2.16093345706138E6</c:v>
                </c:pt>
                <c:pt idx="36">
                  <c:v>56153.07779947917</c:v>
                </c:pt>
                <c:pt idx="37">
                  <c:v>228867.8110351565</c:v>
                </c:pt>
                <c:pt idx="38">
                  <c:v>127448.6168619792</c:v>
                </c:pt>
                <c:pt idx="39">
                  <c:v>16456.90474446618</c:v>
                </c:pt>
                <c:pt idx="40">
                  <c:v>16367.46724446618</c:v>
                </c:pt>
                <c:pt idx="41">
                  <c:v>166117.5030110678</c:v>
                </c:pt>
                <c:pt idx="42">
                  <c:v>22896.76778157553</c:v>
                </c:pt>
                <c:pt idx="43">
                  <c:v>78460.49397786456</c:v>
                </c:pt>
                <c:pt idx="44">
                  <c:v>29726.39306640626</c:v>
                </c:pt>
                <c:pt idx="45">
                  <c:v>76724.7744140625</c:v>
                </c:pt>
                <c:pt idx="46">
                  <c:v>305179.2446670614</c:v>
                </c:pt>
                <c:pt idx="47">
                  <c:v>12486.98472595215</c:v>
                </c:pt>
                <c:pt idx="48">
                  <c:v>15208.210042317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7A4-402C-A809-8F439675AB1F}"/>
            </c:ext>
          </c:extLst>
        </c:ser>
        <c:ser>
          <c:idx val="1"/>
          <c:order val="1"/>
          <c:tx>
            <c:strRef>
              <c:f>'Interfect species'!$AB$28</c:f>
              <c:strCache>
                <c:ptCount val="1"/>
                <c:pt idx="0">
                  <c:v>INTERFER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G$29:$AG$77</c:f>
                <c:numCache>
                  <c:formatCode>General</c:formatCode>
                  <c:ptCount val="49"/>
                  <c:pt idx="0">
                    <c:v>2184.276928374044</c:v>
                  </c:pt>
                  <c:pt idx="1">
                    <c:v>413257.0304281161</c:v>
                  </c:pt>
                  <c:pt idx="2">
                    <c:v>3516.218991781369</c:v>
                  </c:pt>
                  <c:pt idx="3">
                    <c:v>737148.0632633935</c:v>
                  </c:pt>
                  <c:pt idx="4">
                    <c:v>147546.6192655401</c:v>
                  </c:pt>
                  <c:pt idx="5">
                    <c:v>19117.60122846219</c:v>
                  </c:pt>
                  <c:pt idx="6">
                    <c:v>411729.7820933628</c:v>
                  </c:pt>
                  <c:pt idx="7">
                    <c:v>3944.4103424159</c:v>
                  </c:pt>
                  <c:pt idx="8">
                    <c:v>25816.27645592385</c:v>
                  </c:pt>
                  <c:pt idx="9">
                    <c:v>19762.38288478992</c:v>
                  </c:pt>
                  <c:pt idx="10">
                    <c:v>209034.8150694516</c:v>
                  </c:pt>
                  <c:pt idx="11">
                    <c:v>32537.13870231182</c:v>
                  </c:pt>
                  <c:pt idx="12">
                    <c:v>604590.7068867671</c:v>
                  </c:pt>
                  <c:pt idx="13">
                    <c:v>692066.1765085921</c:v>
                  </c:pt>
                  <c:pt idx="14">
                    <c:v>88723.6092402353</c:v>
                  </c:pt>
                  <c:pt idx="15">
                    <c:v>913.3123530226916</c:v>
                  </c:pt>
                  <c:pt idx="16">
                    <c:v>26097.03674059185</c:v>
                  </c:pt>
                  <c:pt idx="17">
                    <c:v>311496.1359767289</c:v>
                  </c:pt>
                  <c:pt idx="18">
                    <c:v>92127.22311928466</c:v>
                  </c:pt>
                  <c:pt idx="19">
                    <c:v>299284.473512925</c:v>
                  </c:pt>
                  <c:pt idx="20">
                    <c:v>8331.967845591847</c:v>
                  </c:pt>
                  <c:pt idx="21">
                    <c:v>755.2560541922411</c:v>
                  </c:pt>
                  <c:pt idx="22">
                    <c:v>7979.718906001255</c:v>
                  </c:pt>
                  <c:pt idx="23">
                    <c:v>2709.4447193454</c:v>
                  </c:pt>
                  <c:pt idx="24">
                    <c:v>7979.42063808196</c:v>
                  </c:pt>
                  <c:pt idx="25">
                    <c:v>35261.88635553957</c:v>
                  </c:pt>
                  <c:pt idx="26">
                    <c:v>76760.07627749724</c:v>
                  </c:pt>
                  <c:pt idx="27">
                    <c:v>288345.2135677933</c:v>
                  </c:pt>
                  <c:pt idx="28">
                    <c:v>50503.405001221</c:v>
                  </c:pt>
                  <c:pt idx="29">
                    <c:v>35761.32776295527</c:v>
                  </c:pt>
                  <c:pt idx="30">
                    <c:v>18632.85778783976</c:v>
                  </c:pt>
                  <c:pt idx="31">
                    <c:v>489861.5388954869</c:v>
                  </c:pt>
                  <c:pt idx="32">
                    <c:v>489861.5388954869</c:v>
                  </c:pt>
                  <c:pt idx="33">
                    <c:v>697760.2683284231</c:v>
                  </c:pt>
                  <c:pt idx="34">
                    <c:v>341288.8621472091</c:v>
                  </c:pt>
                  <c:pt idx="35">
                    <c:v>427572.6262189615</c:v>
                  </c:pt>
                  <c:pt idx="36">
                    <c:v>3649.297636925854</c:v>
                  </c:pt>
                  <c:pt idx="37">
                    <c:v>31470.51258959593</c:v>
                  </c:pt>
                  <c:pt idx="38">
                    <c:v>23532.7939934579</c:v>
                  </c:pt>
                  <c:pt idx="39">
                    <c:v>1935.460064348566</c:v>
                  </c:pt>
                  <c:pt idx="40">
                    <c:v>1893.055555545185</c:v>
                  </c:pt>
                  <c:pt idx="41">
                    <c:v>28045.996538814</c:v>
                  </c:pt>
                  <c:pt idx="42">
                    <c:v>6503.83020269655</c:v>
                  </c:pt>
                  <c:pt idx="43">
                    <c:v>17864.58044743132</c:v>
                  </c:pt>
                  <c:pt idx="44">
                    <c:v>3820.174688877054</c:v>
                  </c:pt>
                  <c:pt idx="45">
                    <c:v>4457.475554268884</c:v>
                  </c:pt>
                  <c:pt idx="46">
                    <c:v>59487.2011162097</c:v>
                  </c:pt>
                  <c:pt idx="47">
                    <c:v>921.1661780245247</c:v>
                  </c:pt>
                  <c:pt idx="48">
                    <c:v>14149.09251594172</c:v>
                  </c:pt>
                </c:numCache>
              </c:numRef>
            </c:plus>
            <c:minus>
              <c:numRef>
                <c:f>'Interfect species'!$AG$29:$AG$77</c:f>
                <c:numCache>
                  <c:formatCode>General</c:formatCode>
                  <c:ptCount val="49"/>
                  <c:pt idx="0">
                    <c:v>2184.276928374044</c:v>
                  </c:pt>
                  <c:pt idx="1">
                    <c:v>413257.0304281161</c:v>
                  </c:pt>
                  <c:pt idx="2">
                    <c:v>3516.218991781369</c:v>
                  </c:pt>
                  <c:pt idx="3">
                    <c:v>737148.0632633935</c:v>
                  </c:pt>
                  <c:pt idx="4">
                    <c:v>147546.6192655401</c:v>
                  </c:pt>
                  <c:pt idx="5">
                    <c:v>19117.60122846219</c:v>
                  </c:pt>
                  <c:pt idx="6">
                    <c:v>411729.7820933628</c:v>
                  </c:pt>
                  <c:pt idx="7">
                    <c:v>3944.4103424159</c:v>
                  </c:pt>
                  <c:pt idx="8">
                    <c:v>25816.27645592385</c:v>
                  </c:pt>
                  <c:pt idx="9">
                    <c:v>19762.38288478992</c:v>
                  </c:pt>
                  <c:pt idx="10">
                    <c:v>209034.8150694516</c:v>
                  </c:pt>
                  <c:pt idx="11">
                    <c:v>32537.13870231182</c:v>
                  </c:pt>
                  <c:pt idx="12">
                    <c:v>604590.7068867671</c:v>
                  </c:pt>
                  <c:pt idx="13">
                    <c:v>692066.1765085921</c:v>
                  </c:pt>
                  <c:pt idx="14">
                    <c:v>88723.6092402353</c:v>
                  </c:pt>
                  <c:pt idx="15">
                    <c:v>913.3123530226916</c:v>
                  </c:pt>
                  <c:pt idx="16">
                    <c:v>26097.03674059185</c:v>
                  </c:pt>
                  <c:pt idx="17">
                    <c:v>311496.1359767289</c:v>
                  </c:pt>
                  <c:pt idx="18">
                    <c:v>92127.22311928466</c:v>
                  </c:pt>
                  <c:pt idx="19">
                    <c:v>299284.473512925</c:v>
                  </c:pt>
                  <c:pt idx="20">
                    <c:v>8331.967845591847</c:v>
                  </c:pt>
                  <c:pt idx="21">
                    <c:v>755.2560541922411</c:v>
                  </c:pt>
                  <c:pt idx="22">
                    <c:v>7979.718906001255</c:v>
                  </c:pt>
                  <c:pt idx="23">
                    <c:v>2709.4447193454</c:v>
                  </c:pt>
                  <c:pt idx="24">
                    <c:v>7979.42063808196</c:v>
                  </c:pt>
                  <c:pt idx="25">
                    <c:v>35261.88635553957</c:v>
                  </c:pt>
                  <c:pt idx="26">
                    <c:v>76760.07627749724</c:v>
                  </c:pt>
                  <c:pt idx="27">
                    <c:v>288345.2135677933</c:v>
                  </c:pt>
                  <c:pt idx="28">
                    <c:v>50503.405001221</c:v>
                  </c:pt>
                  <c:pt idx="29">
                    <c:v>35761.32776295527</c:v>
                  </c:pt>
                  <c:pt idx="30">
                    <c:v>18632.85778783976</c:v>
                  </c:pt>
                  <c:pt idx="31">
                    <c:v>489861.5388954869</c:v>
                  </c:pt>
                  <c:pt idx="32">
                    <c:v>489861.5388954869</c:v>
                  </c:pt>
                  <c:pt idx="33">
                    <c:v>697760.2683284231</c:v>
                  </c:pt>
                  <c:pt idx="34">
                    <c:v>341288.8621472091</c:v>
                  </c:pt>
                  <c:pt idx="35">
                    <c:v>427572.6262189615</c:v>
                  </c:pt>
                  <c:pt idx="36">
                    <c:v>3649.297636925854</c:v>
                  </c:pt>
                  <c:pt idx="37">
                    <c:v>31470.51258959593</c:v>
                  </c:pt>
                  <c:pt idx="38">
                    <c:v>23532.7939934579</c:v>
                  </c:pt>
                  <c:pt idx="39">
                    <c:v>1935.460064348566</c:v>
                  </c:pt>
                  <c:pt idx="40">
                    <c:v>1893.055555545185</c:v>
                  </c:pt>
                  <c:pt idx="41">
                    <c:v>28045.996538814</c:v>
                  </c:pt>
                  <c:pt idx="42">
                    <c:v>6503.83020269655</c:v>
                  </c:pt>
                  <c:pt idx="43">
                    <c:v>17864.58044743132</c:v>
                  </c:pt>
                  <c:pt idx="44">
                    <c:v>3820.174688877054</c:v>
                  </c:pt>
                  <c:pt idx="45">
                    <c:v>4457.475554268884</c:v>
                  </c:pt>
                  <c:pt idx="46">
                    <c:v>59487.2011162097</c:v>
                  </c:pt>
                  <c:pt idx="47">
                    <c:v>921.1661780245247</c:v>
                  </c:pt>
                  <c:pt idx="48">
                    <c:v>14149.092515941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Z$29:$Z$77</c:f>
              <c:strCache>
                <c:ptCount val="49"/>
                <c:pt idx="0">
                  <c:v>LPE 16:0</c:v>
                </c:pt>
                <c:pt idx="1">
                  <c:v>PE 16:0_16:1</c:v>
                </c:pt>
                <c:pt idx="2">
                  <c:v>PE 16:0_18:0</c:v>
                </c:pt>
                <c:pt idx="3">
                  <c:v>PE 16:0_18:1</c:v>
                </c:pt>
                <c:pt idx="4">
                  <c:v>PE 16:0_20:4</c:v>
                </c:pt>
                <c:pt idx="5">
                  <c:v>PE 16:0_20:5</c:v>
                </c:pt>
                <c:pt idx="6">
                  <c:v>PE 16:1_18:1</c:v>
                </c:pt>
                <c:pt idx="7">
                  <c:v>PE 17:0_20:4</c:v>
                </c:pt>
                <c:pt idx="8">
                  <c:v>PE 18:0_20:2</c:v>
                </c:pt>
                <c:pt idx="9">
                  <c:v>PE 18:0_20:3</c:v>
                </c:pt>
                <c:pt idx="10">
                  <c:v>PE 18:0_20:5</c:v>
                </c:pt>
                <c:pt idx="11">
                  <c:v>PE 18:0_22:5</c:v>
                </c:pt>
                <c:pt idx="12">
                  <c:v>PE 18:0_22:6</c:v>
                </c:pt>
                <c:pt idx="13">
                  <c:v>PE 18:1_18:1</c:v>
                </c:pt>
                <c:pt idx="14">
                  <c:v>PE 18:1_18:2</c:v>
                </c:pt>
                <c:pt idx="15">
                  <c:v>PE 18:1_20:0</c:v>
                </c:pt>
                <c:pt idx="16">
                  <c:v>PE 18:1_20:1</c:v>
                </c:pt>
                <c:pt idx="17">
                  <c:v>PE 18:1_20:3</c:v>
                </c:pt>
                <c:pt idx="18">
                  <c:v>PE 18:1_20:5</c:v>
                </c:pt>
                <c:pt idx="19">
                  <c:v>PE 18:1_22:6</c:v>
                </c:pt>
                <c:pt idx="20">
                  <c:v>PE 20:1_20:3</c:v>
                </c:pt>
                <c:pt idx="21">
                  <c:v>PE 20:5_22:6</c:v>
                </c:pt>
                <c:pt idx="22">
                  <c:v>PE P-14:0_16:1</c:v>
                </c:pt>
                <c:pt idx="23">
                  <c:v>PE P-16:0_12:0 </c:v>
                </c:pt>
                <c:pt idx="24">
                  <c:v>PE P-16:0_14:1</c:v>
                </c:pt>
                <c:pt idx="25">
                  <c:v>PE P-16:0_16:0</c:v>
                </c:pt>
                <c:pt idx="26">
                  <c:v>PE P-16:0_16:1</c:v>
                </c:pt>
                <c:pt idx="27">
                  <c:v>PE P-16:0_18:1</c:v>
                </c:pt>
                <c:pt idx="28">
                  <c:v>PE P-16:0_18:2</c:v>
                </c:pt>
                <c:pt idx="29">
                  <c:v>PE P-16:0_20:3</c:v>
                </c:pt>
                <c:pt idx="30">
                  <c:v>PE P-16:0_20:3</c:v>
                </c:pt>
                <c:pt idx="31">
                  <c:v>PE P-16:0_20:4 A</c:v>
                </c:pt>
                <c:pt idx="32">
                  <c:v>PE P-16:0_20:4 B</c:v>
                </c:pt>
                <c:pt idx="33">
                  <c:v>PE P-16:0_20:5</c:v>
                </c:pt>
                <c:pt idx="34">
                  <c:v>PE P-16:0_22:5</c:v>
                </c:pt>
                <c:pt idx="35">
                  <c:v>PE P-16:0_22:6</c:v>
                </c:pt>
                <c:pt idx="36">
                  <c:v>PE P-17:0_18:1</c:v>
                </c:pt>
                <c:pt idx="37">
                  <c:v>PE P-17:0_20:4</c:v>
                </c:pt>
                <c:pt idx="38">
                  <c:v>PE P-17:0_22:6</c:v>
                </c:pt>
                <c:pt idx="39">
                  <c:v>PE P-18:0_16:0</c:v>
                </c:pt>
                <c:pt idx="40">
                  <c:v>PE P-18:0_16:0</c:v>
                </c:pt>
                <c:pt idx="41">
                  <c:v>PE P-18:0_18:1</c:v>
                </c:pt>
                <c:pt idx="42">
                  <c:v>PE P-18:0_18:1</c:v>
                </c:pt>
                <c:pt idx="43">
                  <c:v>PE P-18:0_20:3</c:v>
                </c:pt>
                <c:pt idx="44">
                  <c:v>PE P-18:0_22:4</c:v>
                </c:pt>
                <c:pt idx="45">
                  <c:v>PE P-18:0_22:5</c:v>
                </c:pt>
                <c:pt idx="46">
                  <c:v>PE P-18:0_22:6</c:v>
                </c:pt>
                <c:pt idx="47">
                  <c:v>PE P-20:0_22:6</c:v>
                </c:pt>
                <c:pt idx="48">
                  <c:v>PE P-32:4</c:v>
                </c:pt>
              </c:strCache>
            </c:strRef>
          </c:cat>
          <c:val>
            <c:numRef>
              <c:f>'Interfect species'!$AB$29:$AB$77</c:f>
              <c:numCache>
                <c:formatCode>General</c:formatCode>
                <c:ptCount val="49"/>
                <c:pt idx="0">
                  <c:v>14068.1612065633</c:v>
                </c:pt>
                <c:pt idx="1">
                  <c:v>1.93141518001302E6</c:v>
                </c:pt>
                <c:pt idx="2">
                  <c:v>23792.40431722007</c:v>
                </c:pt>
                <c:pt idx="3">
                  <c:v>3.42972773567708E6</c:v>
                </c:pt>
                <c:pt idx="4">
                  <c:v>714678.5039062503</c:v>
                </c:pt>
                <c:pt idx="5">
                  <c:v>173086.9786783855</c:v>
                </c:pt>
                <c:pt idx="6">
                  <c:v>1.6767372178197E6</c:v>
                </c:pt>
                <c:pt idx="7">
                  <c:v>41593.95458984375</c:v>
                </c:pt>
                <c:pt idx="8">
                  <c:v>93707.6426595052</c:v>
                </c:pt>
                <c:pt idx="9">
                  <c:v>110779.4106445313</c:v>
                </c:pt>
                <c:pt idx="10">
                  <c:v>844261.0866156599</c:v>
                </c:pt>
                <c:pt idx="11">
                  <c:v>204891.4089805715</c:v>
                </c:pt>
                <c:pt idx="12">
                  <c:v>3.90666898412641E6</c:v>
                </c:pt>
                <c:pt idx="13">
                  <c:v>3.80963860652009E6</c:v>
                </c:pt>
                <c:pt idx="14">
                  <c:v>386341.2314183772</c:v>
                </c:pt>
                <c:pt idx="15">
                  <c:v>13783.20703125001</c:v>
                </c:pt>
                <c:pt idx="16">
                  <c:v>88045.19807942715</c:v>
                </c:pt>
                <c:pt idx="17">
                  <c:v>2.17570098741287E6</c:v>
                </c:pt>
                <c:pt idx="18">
                  <c:v>472183.6108620625</c:v>
                </c:pt>
                <c:pt idx="19">
                  <c:v>1.37368614370234E6</c:v>
                </c:pt>
                <c:pt idx="20">
                  <c:v>32991.5174153646</c:v>
                </c:pt>
                <c:pt idx="21">
                  <c:v>6196.46160888672</c:v>
                </c:pt>
                <c:pt idx="22">
                  <c:v>28849.77770996096</c:v>
                </c:pt>
                <c:pt idx="23">
                  <c:v>16288.59927368163</c:v>
                </c:pt>
                <c:pt idx="24">
                  <c:v>27426.70271809895</c:v>
                </c:pt>
                <c:pt idx="25">
                  <c:v>81718.74558512375</c:v>
                </c:pt>
                <c:pt idx="26">
                  <c:v>262265.6938476565</c:v>
                </c:pt>
                <c:pt idx="27">
                  <c:v>1.00423469669311E6</c:v>
                </c:pt>
                <c:pt idx="28">
                  <c:v>169983.00390625</c:v>
                </c:pt>
                <c:pt idx="29">
                  <c:v>85802.29752604167</c:v>
                </c:pt>
                <c:pt idx="30">
                  <c:v>48578.2451985677</c:v>
                </c:pt>
                <c:pt idx="31">
                  <c:v>2.631854859375E6</c:v>
                </c:pt>
                <c:pt idx="32">
                  <c:v>2.631854859375E6</c:v>
                </c:pt>
                <c:pt idx="33">
                  <c:v>3.78650757682292E6</c:v>
                </c:pt>
                <c:pt idx="34">
                  <c:v>1.78836629752604E6</c:v>
                </c:pt>
                <c:pt idx="35">
                  <c:v>2.01466197914176E6</c:v>
                </c:pt>
                <c:pt idx="36">
                  <c:v>11944.5283203125</c:v>
                </c:pt>
                <c:pt idx="37">
                  <c:v>240714.0838216148</c:v>
                </c:pt>
                <c:pt idx="38">
                  <c:v>112479.9967447917</c:v>
                </c:pt>
                <c:pt idx="39">
                  <c:v>17783.50216674806</c:v>
                </c:pt>
                <c:pt idx="40">
                  <c:v>17444.71444702152</c:v>
                </c:pt>
                <c:pt idx="41">
                  <c:v>150882.2923990885</c:v>
                </c:pt>
                <c:pt idx="42">
                  <c:v>27498.49226888021</c:v>
                </c:pt>
                <c:pt idx="43">
                  <c:v>66431.40185546874</c:v>
                </c:pt>
                <c:pt idx="44">
                  <c:v>26539.70638020838</c:v>
                </c:pt>
                <c:pt idx="45">
                  <c:v>73184.82877604168</c:v>
                </c:pt>
                <c:pt idx="46">
                  <c:v>269543.0481242763</c:v>
                </c:pt>
                <c:pt idx="47">
                  <c:v>12378.52436574299</c:v>
                </c:pt>
                <c:pt idx="48">
                  <c:v>55068.651936848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7A4-402C-A809-8F439675AB1F}"/>
            </c:ext>
          </c:extLst>
        </c:ser>
        <c:ser>
          <c:idx val="2"/>
          <c:order val="2"/>
          <c:tx>
            <c:strRef>
              <c:f>'Interfect species'!$AC$28</c:f>
              <c:strCache>
                <c:ptCount val="1"/>
                <c:pt idx="0">
                  <c:v>INTERFERin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29:$AH$77</c:f>
                <c:numCache>
                  <c:formatCode>General</c:formatCode>
                  <c:ptCount val="49"/>
                  <c:pt idx="0">
                    <c:v>1412.869397352265</c:v>
                  </c:pt>
                  <c:pt idx="1">
                    <c:v>253230.1863877778</c:v>
                  </c:pt>
                  <c:pt idx="2">
                    <c:v>7112.528702634529</c:v>
                  </c:pt>
                  <c:pt idx="3">
                    <c:v>398844.8700716369</c:v>
                  </c:pt>
                  <c:pt idx="4">
                    <c:v>76748.22272258836</c:v>
                  </c:pt>
                  <c:pt idx="5">
                    <c:v>15631.91065997821</c:v>
                  </c:pt>
                  <c:pt idx="6">
                    <c:v>223173.5147259539</c:v>
                  </c:pt>
                  <c:pt idx="7">
                    <c:v>5596.355529605247</c:v>
                  </c:pt>
                  <c:pt idx="8">
                    <c:v>13325.87211762501</c:v>
                  </c:pt>
                  <c:pt idx="9">
                    <c:v>13113.99042046525</c:v>
                  </c:pt>
                  <c:pt idx="10">
                    <c:v>96323.0749871812</c:v>
                  </c:pt>
                  <c:pt idx="11">
                    <c:v>20292.63458790196</c:v>
                  </c:pt>
                  <c:pt idx="12">
                    <c:v>390497.3701021522</c:v>
                  </c:pt>
                  <c:pt idx="13">
                    <c:v>397018.7481327538</c:v>
                  </c:pt>
                  <c:pt idx="14">
                    <c:v>42318.697579195</c:v>
                  </c:pt>
                  <c:pt idx="15">
                    <c:v>2204.514396152398</c:v>
                  </c:pt>
                  <c:pt idx="16">
                    <c:v>12552.22843570663</c:v>
                  </c:pt>
                  <c:pt idx="17">
                    <c:v>175342.2312506437</c:v>
                  </c:pt>
                  <c:pt idx="18">
                    <c:v>50446.653315781</c:v>
                  </c:pt>
                  <c:pt idx="19">
                    <c:v>167538.3267256827</c:v>
                  </c:pt>
                  <c:pt idx="20">
                    <c:v>2438.542973448948</c:v>
                  </c:pt>
                  <c:pt idx="21">
                    <c:v>663.4668645122466</c:v>
                  </c:pt>
                  <c:pt idx="22">
                    <c:v>2721.589509122998</c:v>
                  </c:pt>
                  <c:pt idx="23">
                    <c:v>2386.784104847383</c:v>
                  </c:pt>
                  <c:pt idx="24">
                    <c:v>2731.29654693304</c:v>
                  </c:pt>
                  <c:pt idx="25">
                    <c:v>11081.7375488686</c:v>
                  </c:pt>
                  <c:pt idx="26">
                    <c:v>37201.14053105575</c:v>
                  </c:pt>
                  <c:pt idx="27">
                    <c:v>136672.2783721658</c:v>
                  </c:pt>
                  <c:pt idx="28">
                    <c:v>22284.34999994064</c:v>
                  </c:pt>
                  <c:pt idx="29">
                    <c:v>17394.47092466232</c:v>
                  </c:pt>
                  <c:pt idx="30">
                    <c:v>4923.18360938493</c:v>
                  </c:pt>
                  <c:pt idx="31">
                    <c:v>227597.9740447044</c:v>
                  </c:pt>
                  <c:pt idx="32">
                    <c:v>227682.4994764639</c:v>
                  </c:pt>
                  <c:pt idx="33">
                    <c:v>375275.5161937089</c:v>
                  </c:pt>
                  <c:pt idx="34">
                    <c:v>223758.5952077151</c:v>
                  </c:pt>
                  <c:pt idx="35">
                    <c:v>200800.6924540745</c:v>
                  </c:pt>
                  <c:pt idx="36">
                    <c:v>1778.065632238978</c:v>
                  </c:pt>
                  <c:pt idx="37">
                    <c:v>20133.73646739273</c:v>
                  </c:pt>
                  <c:pt idx="38">
                    <c:v>14098.10216804096</c:v>
                  </c:pt>
                  <c:pt idx="39">
                    <c:v>2792.164779634875</c:v>
                  </c:pt>
                  <c:pt idx="40">
                    <c:v>2558.446904087091</c:v>
                  </c:pt>
                  <c:pt idx="41">
                    <c:v>14177.00498871025</c:v>
                  </c:pt>
                  <c:pt idx="42">
                    <c:v>3279.634921208452</c:v>
                  </c:pt>
                  <c:pt idx="43">
                    <c:v>9893.754106918417</c:v>
                  </c:pt>
                  <c:pt idx="44">
                    <c:v>1400.123080281173</c:v>
                  </c:pt>
                  <c:pt idx="45">
                    <c:v>11954.33053507899</c:v>
                  </c:pt>
                  <c:pt idx="46">
                    <c:v>32212.47107912609</c:v>
                  </c:pt>
                  <c:pt idx="47">
                    <c:v>886.1633604963913</c:v>
                  </c:pt>
                  <c:pt idx="48">
                    <c:v>5738.518175146628</c:v>
                  </c:pt>
                </c:numCache>
              </c:numRef>
            </c:plus>
            <c:minus>
              <c:numRef>
                <c:f>'Interfect species'!$AH$29:$AH$77</c:f>
                <c:numCache>
                  <c:formatCode>General</c:formatCode>
                  <c:ptCount val="49"/>
                  <c:pt idx="0">
                    <c:v>1412.869397352265</c:v>
                  </c:pt>
                  <c:pt idx="1">
                    <c:v>253230.1863877778</c:v>
                  </c:pt>
                  <c:pt idx="2">
                    <c:v>7112.528702634529</c:v>
                  </c:pt>
                  <c:pt idx="3">
                    <c:v>398844.8700716369</c:v>
                  </c:pt>
                  <c:pt idx="4">
                    <c:v>76748.22272258836</c:v>
                  </c:pt>
                  <c:pt idx="5">
                    <c:v>15631.91065997821</c:v>
                  </c:pt>
                  <c:pt idx="6">
                    <c:v>223173.5147259539</c:v>
                  </c:pt>
                  <c:pt idx="7">
                    <c:v>5596.355529605247</c:v>
                  </c:pt>
                  <c:pt idx="8">
                    <c:v>13325.87211762501</c:v>
                  </c:pt>
                  <c:pt idx="9">
                    <c:v>13113.99042046525</c:v>
                  </c:pt>
                  <c:pt idx="10">
                    <c:v>96323.0749871812</c:v>
                  </c:pt>
                  <c:pt idx="11">
                    <c:v>20292.63458790196</c:v>
                  </c:pt>
                  <c:pt idx="12">
                    <c:v>390497.3701021522</c:v>
                  </c:pt>
                  <c:pt idx="13">
                    <c:v>397018.7481327538</c:v>
                  </c:pt>
                  <c:pt idx="14">
                    <c:v>42318.697579195</c:v>
                  </c:pt>
                  <c:pt idx="15">
                    <c:v>2204.514396152398</c:v>
                  </c:pt>
                  <c:pt idx="16">
                    <c:v>12552.22843570663</c:v>
                  </c:pt>
                  <c:pt idx="17">
                    <c:v>175342.2312506437</c:v>
                  </c:pt>
                  <c:pt idx="18">
                    <c:v>50446.653315781</c:v>
                  </c:pt>
                  <c:pt idx="19">
                    <c:v>167538.3267256827</c:v>
                  </c:pt>
                  <c:pt idx="20">
                    <c:v>2438.542973448948</c:v>
                  </c:pt>
                  <c:pt idx="21">
                    <c:v>663.4668645122466</c:v>
                  </c:pt>
                  <c:pt idx="22">
                    <c:v>2721.589509122998</c:v>
                  </c:pt>
                  <c:pt idx="23">
                    <c:v>2386.784104847383</c:v>
                  </c:pt>
                  <c:pt idx="24">
                    <c:v>2731.29654693304</c:v>
                  </c:pt>
                  <c:pt idx="25">
                    <c:v>11081.7375488686</c:v>
                  </c:pt>
                  <c:pt idx="26">
                    <c:v>37201.14053105575</c:v>
                  </c:pt>
                  <c:pt idx="27">
                    <c:v>136672.2783721658</c:v>
                  </c:pt>
                  <c:pt idx="28">
                    <c:v>22284.34999994064</c:v>
                  </c:pt>
                  <c:pt idx="29">
                    <c:v>17394.47092466232</c:v>
                  </c:pt>
                  <c:pt idx="30">
                    <c:v>4923.18360938493</c:v>
                  </c:pt>
                  <c:pt idx="31">
                    <c:v>227597.9740447044</c:v>
                  </c:pt>
                  <c:pt idx="32">
                    <c:v>227682.4994764639</c:v>
                  </c:pt>
                  <c:pt idx="33">
                    <c:v>375275.5161937089</c:v>
                  </c:pt>
                  <c:pt idx="34">
                    <c:v>223758.5952077151</c:v>
                  </c:pt>
                  <c:pt idx="35">
                    <c:v>200800.6924540745</c:v>
                  </c:pt>
                  <c:pt idx="36">
                    <c:v>1778.065632238978</c:v>
                  </c:pt>
                  <c:pt idx="37">
                    <c:v>20133.73646739273</c:v>
                  </c:pt>
                  <c:pt idx="38">
                    <c:v>14098.10216804096</c:v>
                  </c:pt>
                  <c:pt idx="39">
                    <c:v>2792.164779634875</c:v>
                  </c:pt>
                  <c:pt idx="40">
                    <c:v>2558.446904087091</c:v>
                  </c:pt>
                  <c:pt idx="41">
                    <c:v>14177.00498871025</c:v>
                  </c:pt>
                  <c:pt idx="42">
                    <c:v>3279.634921208452</c:v>
                  </c:pt>
                  <c:pt idx="43">
                    <c:v>9893.754106918417</c:v>
                  </c:pt>
                  <c:pt idx="44">
                    <c:v>1400.123080281173</c:v>
                  </c:pt>
                  <c:pt idx="45">
                    <c:v>11954.33053507899</c:v>
                  </c:pt>
                  <c:pt idx="46">
                    <c:v>32212.47107912609</c:v>
                  </c:pt>
                  <c:pt idx="47">
                    <c:v>886.1633604963913</c:v>
                  </c:pt>
                  <c:pt idx="48">
                    <c:v>5738.5181751466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Z$29:$Z$77</c:f>
              <c:strCache>
                <c:ptCount val="49"/>
                <c:pt idx="0">
                  <c:v>LPE 16:0</c:v>
                </c:pt>
                <c:pt idx="1">
                  <c:v>PE 16:0_16:1</c:v>
                </c:pt>
                <c:pt idx="2">
                  <c:v>PE 16:0_18:0</c:v>
                </c:pt>
                <c:pt idx="3">
                  <c:v>PE 16:0_18:1</c:v>
                </c:pt>
                <c:pt idx="4">
                  <c:v>PE 16:0_20:4</c:v>
                </c:pt>
                <c:pt idx="5">
                  <c:v>PE 16:0_20:5</c:v>
                </c:pt>
                <c:pt idx="6">
                  <c:v>PE 16:1_18:1</c:v>
                </c:pt>
                <c:pt idx="7">
                  <c:v>PE 17:0_20:4</c:v>
                </c:pt>
                <c:pt idx="8">
                  <c:v>PE 18:0_20:2</c:v>
                </c:pt>
                <c:pt idx="9">
                  <c:v>PE 18:0_20:3</c:v>
                </c:pt>
                <c:pt idx="10">
                  <c:v>PE 18:0_20:5</c:v>
                </c:pt>
                <c:pt idx="11">
                  <c:v>PE 18:0_22:5</c:v>
                </c:pt>
                <c:pt idx="12">
                  <c:v>PE 18:0_22:6</c:v>
                </c:pt>
                <c:pt idx="13">
                  <c:v>PE 18:1_18:1</c:v>
                </c:pt>
                <c:pt idx="14">
                  <c:v>PE 18:1_18:2</c:v>
                </c:pt>
                <c:pt idx="15">
                  <c:v>PE 18:1_20:0</c:v>
                </c:pt>
                <c:pt idx="16">
                  <c:v>PE 18:1_20:1</c:v>
                </c:pt>
                <c:pt idx="17">
                  <c:v>PE 18:1_20:3</c:v>
                </c:pt>
                <c:pt idx="18">
                  <c:v>PE 18:1_20:5</c:v>
                </c:pt>
                <c:pt idx="19">
                  <c:v>PE 18:1_22:6</c:v>
                </c:pt>
                <c:pt idx="20">
                  <c:v>PE 20:1_20:3</c:v>
                </c:pt>
                <c:pt idx="21">
                  <c:v>PE 20:5_22:6</c:v>
                </c:pt>
                <c:pt idx="22">
                  <c:v>PE P-14:0_16:1</c:v>
                </c:pt>
                <c:pt idx="23">
                  <c:v>PE P-16:0_12:0 </c:v>
                </c:pt>
                <c:pt idx="24">
                  <c:v>PE P-16:0_14:1</c:v>
                </c:pt>
                <c:pt idx="25">
                  <c:v>PE P-16:0_16:0</c:v>
                </c:pt>
                <c:pt idx="26">
                  <c:v>PE P-16:0_16:1</c:v>
                </c:pt>
                <c:pt idx="27">
                  <c:v>PE P-16:0_18:1</c:v>
                </c:pt>
                <c:pt idx="28">
                  <c:v>PE P-16:0_18:2</c:v>
                </c:pt>
                <c:pt idx="29">
                  <c:v>PE P-16:0_20:3</c:v>
                </c:pt>
                <c:pt idx="30">
                  <c:v>PE P-16:0_20:3</c:v>
                </c:pt>
                <c:pt idx="31">
                  <c:v>PE P-16:0_20:4 A</c:v>
                </c:pt>
                <c:pt idx="32">
                  <c:v>PE P-16:0_20:4 B</c:v>
                </c:pt>
                <c:pt idx="33">
                  <c:v>PE P-16:0_20:5</c:v>
                </c:pt>
                <c:pt idx="34">
                  <c:v>PE P-16:0_22:5</c:v>
                </c:pt>
                <c:pt idx="35">
                  <c:v>PE P-16:0_22:6</c:v>
                </c:pt>
                <c:pt idx="36">
                  <c:v>PE P-17:0_18:1</c:v>
                </c:pt>
                <c:pt idx="37">
                  <c:v>PE P-17:0_20:4</c:v>
                </c:pt>
                <c:pt idx="38">
                  <c:v>PE P-17:0_22:6</c:v>
                </c:pt>
                <c:pt idx="39">
                  <c:v>PE P-18:0_16:0</c:v>
                </c:pt>
                <c:pt idx="40">
                  <c:v>PE P-18:0_16:0</c:v>
                </c:pt>
                <c:pt idx="41">
                  <c:v>PE P-18:0_18:1</c:v>
                </c:pt>
                <c:pt idx="42">
                  <c:v>PE P-18:0_18:1</c:v>
                </c:pt>
                <c:pt idx="43">
                  <c:v>PE P-18:0_20:3</c:v>
                </c:pt>
                <c:pt idx="44">
                  <c:v>PE P-18:0_22:4</c:v>
                </c:pt>
                <c:pt idx="45">
                  <c:v>PE P-18:0_22:5</c:v>
                </c:pt>
                <c:pt idx="46">
                  <c:v>PE P-18:0_22:6</c:v>
                </c:pt>
                <c:pt idx="47">
                  <c:v>PE P-20:0_22:6</c:v>
                </c:pt>
                <c:pt idx="48">
                  <c:v>PE P-32:4</c:v>
                </c:pt>
              </c:strCache>
            </c:strRef>
          </c:cat>
          <c:val>
            <c:numRef>
              <c:f>'Interfect species'!$AC$29:$AC$77</c:f>
              <c:numCache>
                <c:formatCode>General</c:formatCode>
                <c:ptCount val="49"/>
                <c:pt idx="0">
                  <c:v>11052.74262746176</c:v>
                </c:pt>
                <c:pt idx="1">
                  <c:v>1.47063635001628E6</c:v>
                </c:pt>
                <c:pt idx="2">
                  <c:v>27392.56689453125</c:v>
                </c:pt>
                <c:pt idx="3">
                  <c:v>2.80987917708333E6</c:v>
                </c:pt>
                <c:pt idx="4">
                  <c:v>604745.463541667</c:v>
                </c:pt>
                <c:pt idx="5">
                  <c:v>159053.6891276041</c:v>
                </c:pt>
                <c:pt idx="6">
                  <c:v>1.29713609755769E6</c:v>
                </c:pt>
                <c:pt idx="7">
                  <c:v>40773.3642578125</c:v>
                </c:pt>
                <c:pt idx="8">
                  <c:v>76857.13362630218</c:v>
                </c:pt>
                <c:pt idx="9">
                  <c:v>100111.8470052084</c:v>
                </c:pt>
                <c:pt idx="10">
                  <c:v>719372.1965917883</c:v>
                </c:pt>
                <c:pt idx="11">
                  <c:v>177532.7178180208</c:v>
                </c:pt>
                <c:pt idx="12">
                  <c:v>3.5577230057615E6</c:v>
                </c:pt>
                <c:pt idx="13">
                  <c:v>3.61816940412903E6</c:v>
                </c:pt>
                <c:pt idx="14">
                  <c:v>329540.4426721973</c:v>
                </c:pt>
                <c:pt idx="15">
                  <c:v>15900.45312500001</c:v>
                </c:pt>
                <c:pt idx="16">
                  <c:v>70793.26725260417</c:v>
                </c:pt>
                <c:pt idx="17">
                  <c:v>2.01609788142764E6</c:v>
                </c:pt>
                <c:pt idx="18">
                  <c:v>436233.0920144425</c:v>
                </c:pt>
                <c:pt idx="19">
                  <c:v>1.16078532440825E6</c:v>
                </c:pt>
                <c:pt idx="20">
                  <c:v>31711.3818359375</c:v>
                </c:pt>
                <c:pt idx="21">
                  <c:v>8034.728464762372</c:v>
                </c:pt>
                <c:pt idx="22">
                  <c:v>21089.63774617513</c:v>
                </c:pt>
                <c:pt idx="23">
                  <c:v>17261.04320271812</c:v>
                </c:pt>
                <c:pt idx="24">
                  <c:v>20282.24287923178</c:v>
                </c:pt>
                <c:pt idx="25">
                  <c:v>58150.68328857421</c:v>
                </c:pt>
                <c:pt idx="26">
                  <c:v>177939.6459147137</c:v>
                </c:pt>
                <c:pt idx="27">
                  <c:v>831408.846724122</c:v>
                </c:pt>
                <c:pt idx="28">
                  <c:v>146551.828125</c:v>
                </c:pt>
                <c:pt idx="29">
                  <c:v>66303.15690104167</c:v>
                </c:pt>
                <c:pt idx="30">
                  <c:v>34538.90478515627</c:v>
                </c:pt>
                <c:pt idx="31">
                  <c:v>2.37508501171875E6</c:v>
                </c:pt>
                <c:pt idx="32">
                  <c:v>2.37520027929688E6</c:v>
                </c:pt>
                <c:pt idx="33">
                  <c:v>3.38039652473958E6</c:v>
                </c:pt>
                <c:pt idx="34">
                  <c:v>1.65784615983073E6</c:v>
                </c:pt>
                <c:pt idx="35">
                  <c:v>1.83484723142123E6</c:v>
                </c:pt>
                <c:pt idx="36">
                  <c:v>10831.17643229167</c:v>
                </c:pt>
                <c:pt idx="37">
                  <c:v>235214.9408365889</c:v>
                </c:pt>
                <c:pt idx="38">
                  <c:v>122732.2469075523</c:v>
                </c:pt>
                <c:pt idx="39">
                  <c:v>18874.85072835286</c:v>
                </c:pt>
                <c:pt idx="40">
                  <c:v>18731.8462931315</c:v>
                </c:pt>
                <c:pt idx="41">
                  <c:v>141724.8661295573</c:v>
                </c:pt>
                <c:pt idx="42">
                  <c:v>24980.68652343751</c:v>
                </c:pt>
                <c:pt idx="43">
                  <c:v>40253.6845703125</c:v>
                </c:pt>
                <c:pt idx="44">
                  <c:v>21033.21728515627</c:v>
                </c:pt>
                <c:pt idx="45">
                  <c:v>71846.03190104167</c:v>
                </c:pt>
                <c:pt idx="46">
                  <c:v>275643.1150390869</c:v>
                </c:pt>
                <c:pt idx="47">
                  <c:v>12880.68158721925</c:v>
                </c:pt>
                <c:pt idx="48">
                  <c:v>42914.547363281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7A4-402C-A809-8F439675AB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45637480"/>
        <c:axId val="-2145677160"/>
      </c:barChart>
      <c:catAx>
        <c:axId val="-2145637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45677160"/>
        <c:crosses val="autoZero"/>
        <c:auto val="1"/>
        <c:lblAlgn val="ctr"/>
        <c:lblOffset val="100"/>
        <c:noMultiLvlLbl val="0"/>
      </c:catAx>
      <c:valAx>
        <c:axId val="-21456771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45637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terfect species'!$AA$81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F$82:$AF$112</c:f>
                <c:numCache>
                  <c:formatCode>General</c:formatCode>
                  <c:ptCount val="31"/>
                  <c:pt idx="0">
                    <c:v>8937.160604690409</c:v>
                  </c:pt>
                  <c:pt idx="1">
                    <c:v>3282.01374811367</c:v>
                  </c:pt>
                  <c:pt idx="2">
                    <c:v>7088.12458474903</c:v>
                  </c:pt>
                  <c:pt idx="3">
                    <c:v>44324.99813612578</c:v>
                  </c:pt>
                  <c:pt idx="4">
                    <c:v>270783.7489547859</c:v>
                  </c:pt>
                  <c:pt idx="5">
                    <c:v>669124.4564262727</c:v>
                  </c:pt>
                  <c:pt idx="6">
                    <c:v>14799.07725941834</c:v>
                  </c:pt>
                  <c:pt idx="7">
                    <c:v>82555.99677129109</c:v>
                  </c:pt>
                  <c:pt idx="8">
                    <c:v>439691.679231494</c:v>
                  </c:pt>
                  <c:pt idx="9">
                    <c:v>18945.16493894641</c:v>
                  </c:pt>
                  <c:pt idx="10">
                    <c:v>11165.34214706052</c:v>
                  </c:pt>
                  <c:pt idx="11">
                    <c:v>303737.7913544034</c:v>
                  </c:pt>
                  <c:pt idx="12">
                    <c:v>27613.79129887504</c:v>
                  </c:pt>
                  <c:pt idx="13">
                    <c:v>2976.938274672946</c:v>
                  </c:pt>
                  <c:pt idx="14">
                    <c:v>17771.91056788933</c:v>
                  </c:pt>
                  <c:pt idx="15">
                    <c:v>33086.94357424357</c:v>
                  </c:pt>
                  <c:pt idx="16">
                    <c:v>14232.9380678684</c:v>
                  </c:pt>
                  <c:pt idx="17">
                    <c:v>27687.33253183537</c:v>
                  </c:pt>
                  <c:pt idx="18">
                    <c:v>1078.890192265868</c:v>
                  </c:pt>
                  <c:pt idx="19">
                    <c:v>6652.29628694923</c:v>
                  </c:pt>
                  <c:pt idx="20">
                    <c:v>9638.284625171205</c:v>
                  </c:pt>
                  <c:pt idx="21">
                    <c:v>8449.968295027349</c:v>
                  </c:pt>
                  <c:pt idx="22">
                    <c:v>798.6899991074462</c:v>
                  </c:pt>
                  <c:pt idx="23">
                    <c:v>793.1106450521188</c:v>
                  </c:pt>
                  <c:pt idx="24">
                    <c:v>176433.497038769</c:v>
                  </c:pt>
                  <c:pt idx="25">
                    <c:v>5962.977326412361</c:v>
                  </c:pt>
                  <c:pt idx="26">
                    <c:v>8413.46038838077</c:v>
                  </c:pt>
                  <c:pt idx="27">
                    <c:v>12871.27161787044</c:v>
                  </c:pt>
                  <c:pt idx="28">
                    <c:v>8500.68982162917</c:v>
                  </c:pt>
                  <c:pt idx="29">
                    <c:v>6719.506043870908</c:v>
                  </c:pt>
                  <c:pt idx="30">
                    <c:v>8763.682693853274</c:v>
                  </c:pt>
                </c:numCache>
              </c:numRef>
            </c:plus>
            <c:minus>
              <c:numRef>
                <c:f>'Interfect species'!$AF$82:$AF$112</c:f>
                <c:numCache>
                  <c:formatCode>General</c:formatCode>
                  <c:ptCount val="31"/>
                  <c:pt idx="0">
                    <c:v>8937.160604690409</c:v>
                  </c:pt>
                  <c:pt idx="1">
                    <c:v>3282.01374811367</c:v>
                  </c:pt>
                  <c:pt idx="2">
                    <c:v>7088.12458474903</c:v>
                  </c:pt>
                  <c:pt idx="3">
                    <c:v>44324.99813612578</c:v>
                  </c:pt>
                  <c:pt idx="4">
                    <c:v>270783.7489547859</c:v>
                  </c:pt>
                  <c:pt idx="5">
                    <c:v>669124.4564262727</c:v>
                  </c:pt>
                  <c:pt idx="6">
                    <c:v>14799.07725941834</c:v>
                  </c:pt>
                  <c:pt idx="7">
                    <c:v>82555.99677129109</c:v>
                  </c:pt>
                  <c:pt idx="8">
                    <c:v>439691.679231494</c:v>
                  </c:pt>
                  <c:pt idx="9">
                    <c:v>18945.16493894641</c:v>
                  </c:pt>
                  <c:pt idx="10">
                    <c:v>11165.34214706052</c:v>
                  </c:pt>
                  <c:pt idx="11">
                    <c:v>303737.7913544034</c:v>
                  </c:pt>
                  <c:pt idx="12">
                    <c:v>27613.79129887504</c:v>
                  </c:pt>
                  <c:pt idx="13">
                    <c:v>2976.938274672946</c:v>
                  </c:pt>
                  <c:pt idx="14">
                    <c:v>17771.91056788933</c:v>
                  </c:pt>
                  <c:pt idx="15">
                    <c:v>33086.94357424357</c:v>
                  </c:pt>
                  <c:pt idx="16">
                    <c:v>14232.9380678684</c:v>
                  </c:pt>
                  <c:pt idx="17">
                    <c:v>27687.33253183537</c:v>
                  </c:pt>
                  <c:pt idx="18">
                    <c:v>1078.890192265868</c:v>
                  </c:pt>
                  <c:pt idx="19">
                    <c:v>6652.29628694923</c:v>
                  </c:pt>
                  <c:pt idx="20">
                    <c:v>9638.284625171205</c:v>
                  </c:pt>
                  <c:pt idx="21">
                    <c:v>8449.968295027349</c:v>
                  </c:pt>
                  <c:pt idx="22">
                    <c:v>798.6899991074462</c:v>
                  </c:pt>
                  <c:pt idx="23">
                    <c:v>793.1106450521188</c:v>
                  </c:pt>
                  <c:pt idx="24">
                    <c:v>176433.497038769</c:v>
                  </c:pt>
                  <c:pt idx="25">
                    <c:v>5962.977326412361</c:v>
                  </c:pt>
                  <c:pt idx="26">
                    <c:v>8413.46038838077</c:v>
                  </c:pt>
                  <c:pt idx="27">
                    <c:v>12871.27161787044</c:v>
                  </c:pt>
                  <c:pt idx="28">
                    <c:v>8500.68982162917</c:v>
                  </c:pt>
                  <c:pt idx="29">
                    <c:v>6719.506043870908</c:v>
                  </c:pt>
                  <c:pt idx="30">
                    <c:v>8763.6826938532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Z$82:$Z$112</c:f>
              <c:strCache>
                <c:ptCount val="31"/>
                <c:pt idx="0">
                  <c:v>LPC 16:0</c:v>
                </c:pt>
                <c:pt idx="1">
                  <c:v>LPC 18:1A</c:v>
                </c:pt>
                <c:pt idx="2">
                  <c:v>LPC 18:1B</c:v>
                </c:pt>
                <c:pt idx="3">
                  <c:v>PC 14:0_14:0</c:v>
                </c:pt>
                <c:pt idx="4">
                  <c:v>PC 14:0_16:0</c:v>
                </c:pt>
                <c:pt idx="5">
                  <c:v>PC 14:0_16:1</c:v>
                </c:pt>
                <c:pt idx="6">
                  <c:v>PC 14:0_20:4</c:v>
                </c:pt>
                <c:pt idx="7">
                  <c:v>PC 16:0_16:0</c:v>
                </c:pt>
                <c:pt idx="8">
                  <c:v>PC 16:0_16:1</c:v>
                </c:pt>
                <c:pt idx="9">
                  <c:v>PC 16:0_17:1</c:v>
                </c:pt>
                <c:pt idx="10">
                  <c:v>PC 16:0_18:0</c:v>
                </c:pt>
                <c:pt idx="11">
                  <c:v>PC 16:0_18:1</c:v>
                </c:pt>
                <c:pt idx="12">
                  <c:v>PC 16:0_20:1</c:v>
                </c:pt>
                <c:pt idx="13">
                  <c:v>PC 16:0_20:4</c:v>
                </c:pt>
                <c:pt idx="14">
                  <c:v>PC 16:0_20:5</c:v>
                </c:pt>
                <c:pt idx="15">
                  <c:v>PC 16:0_22:2</c:v>
                </c:pt>
                <c:pt idx="16">
                  <c:v>PC 16:0_22:6</c:v>
                </c:pt>
                <c:pt idx="17">
                  <c:v>PC 18:0_18:1</c:v>
                </c:pt>
                <c:pt idx="18">
                  <c:v>PC 18:0_20:3</c:v>
                </c:pt>
                <c:pt idx="19">
                  <c:v>PC 18:1_20:1</c:v>
                </c:pt>
                <c:pt idx="20">
                  <c:v>PC 18:1_20:5</c:v>
                </c:pt>
                <c:pt idx="21">
                  <c:v>PC 18:1_20:6</c:v>
                </c:pt>
                <c:pt idx="22">
                  <c:v>PC 18:1_22:4</c:v>
                </c:pt>
                <c:pt idx="23">
                  <c:v>PC 18:1_22:5</c:v>
                </c:pt>
                <c:pt idx="24">
                  <c:v>PC 18:2_16:0</c:v>
                </c:pt>
                <c:pt idx="25">
                  <c:v>PC 20:0_16:0</c:v>
                </c:pt>
                <c:pt idx="26">
                  <c:v>PC P-16:0_14:0</c:v>
                </c:pt>
                <c:pt idx="27">
                  <c:v>PC P-16:0_16:0</c:v>
                </c:pt>
                <c:pt idx="28">
                  <c:v>PC P-16:0_18:1</c:v>
                </c:pt>
                <c:pt idx="29">
                  <c:v>PC P-16:0_20:3</c:v>
                </c:pt>
                <c:pt idx="30">
                  <c:v>PC P-18:0_18:0</c:v>
                </c:pt>
              </c:strCache>
            </c:strRef>
          </c:cat>
          <c:val>
            <c:numRef>
              <c:f>'Interfect species'!$AA$82:$AA$112</c:f>
              <c:numCache>
                <c:formatCode>General</c:formatCode>
                <c:ptCount val="31"/>
                <c:pt idx="0">
                  <c:v>73942.47220865889</c:v>
                </c:pt>
                <c:pt idx="1">
                  <c:v>9268.26896158855</c:v>
                </c:pt>
                <c:pt idx="2">
                  <c:v>33763.42951456704</c:v>
                </c:pt>
                <c:pt idx="3">
                  <c:v>347983.8337166666</c:v>
                </c:pt>
                <c:pt idx="4">
                  <c:v>1.66733209783333E6</c:v>
                </c:pt>
                <c:pt idx="5">
                  <c:v>1.1691684916E6</c:v>
                </c:pt>
                <c:pt idx="6">
                  <c:v>19841.67504749999</c:v>
                </c:pt>
                <c:pt idx="7">
                  <c:v>881403.5143166664</c:v>
                </c:pt>
                <c:pt idx="8">
                  <c:v>2.1664512475E6</c:v>
                </c:pt>
                <c:pt idx="9">
                  <c:v>212230.4459833333</c:v>
                </c:pt>
                <c:pt idx="10">
                  <c:v>67789.12141833336</c:v>
                </c:pt>
                <c:pt idx="11">
                  <c:v>2.8445808145E6</c:v>
                </c:pt>
                <c:pt idx="12">
                  <c:v>219351.8219333333</c:v>
                </c:pt>
                <c:pt idx="13">
                  <c:v>34814.90364666666</c:v>
                </c:pt>
                <c:pt idx="14">
                  <c:v>137767.9210666666</c:v>
                </c:pt>
                <c:pt idx="15">
                  <c:v>129061.06846</c:v>
                </c:pt>
                <c:pt idx="16">
                  <c:v>76086.48990833334</c:v>
                </c:pt>
                <c:pt idx="17">
                  <c:v>250239.2712</c:v>
                </c:pt>
                <c:pt idx="18">
                  <c:v>9509.496133833329</c:v>
                </c:pt>
                <c:pt idx="19">
                  <c:v>99986.65998166664</c:v>
                </c:pt>
                <c:pt idx="20">
                  <c:v>93276.40055833333</c:v>
                </c:pt>
                <c:pt idx="21">
                  <c:v>64133.40104333332</c:v>
                </c:pt>
                <c:pt idx="22">
                  <c:v>5121.754679500001</c:v>
                </c:pt>
                <c:pt idx="23">
                  <c:v>7792.215820333334</c:v>
                </c:pt>
                <c:pt idx="24">
                  <c:v>1.06556445576667E6</c:v>
                </c:pt>
                <c:pt idx="25">
                  <c:v>24318.10196833332</c:v>
                </c:pt>
                <c:pt idx="26">
                  <c:v>50041.197835</c:v>
                </c:pt>
                <c:pt idx="27">
                  <c:v>86962.51041166665</c:v>
                </c:pt>
                <c:pt idx="28">
                  <c:v>107997.1454466667</c:v>
                </c:pt>
                <c:pt idx="29">
                  <c:v>64553.77189166665</c:v>
                </c:pt>
                <c:pt idx="30">
                  <c:v>60280.1938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AAA-4CAD-8A75-38DA34F0B623}"/>
            </c:ext>
          </c:extLst>
        </c:ser>
        <c:ser>
          <c:idx val="1"/>
          <c:order val="1"/>
          <c:tx>
            <c:strRef>
              <c:f>'Interfect species'!$AB$81</c:f>
              <c:strCache>
                <c:ptCount val="1"/>
                <c:pt idx="0">
                  <c:v>INTERFER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G$82:$AG$112</c:f>
                <c:numCache>
                  <c:formatCode>General</c:formatCode>
                  <c:ptCount val="31"/>
                  <c:pt idx="0">
                    <c:v>8381.504734145062</c:v>
                  </c:pt>
                  <c:pt idx="1">
                    <c:v>1147.626763205815</c:v>
                  </c:pt>
                  <c:pt idx="2">
                    <c:v>3195.707092034208</c:v>
                  </c:pt>
                  <c:pt idx="3">
                    <c:v>61957.84319415469</c:v>
                  </c:pt>
                  <c:pt idx="4">
                    <c:v>325654.6445122286</c:v>
                  </c:pt>
                  <c:pt idx="5">
                    <c:v>80228.9679535964</c:v>
                  </c:pt>
                  <c:pt idx="6">
                    <c:v>1016.328120221966</c:v>
                  </c:pt>
                  <c:pt idx="7">
                    <c:v>91552.48833912225</c:v>
                  </c:pt>
                  <c:pt idx="8">
                    <c:v>166162.6752739546</c:v>
                  </c:pt>
                  <c:pt idx="9">
                    <c:v>20811.59280767732</c:v>
                  </c:pt>
                  <c:pt idx="10">
                    <c:v>5218.715937771475</c:v>
                  </c:pt>
                  <c:pt idx="11">
                    <c:v>318133.191437336</c:v>
                  </c:pt>
                  <c:pt idx="12">
                    <c:v>26127.72646599311</c:v>
                  </c:pt>
                  <c:pt idx="13">
                    <c:v>2852.328519865816</c:v>
                  </c:pt>
                  <c:pt idx="14">
                    <c:v>12842.10804847269</c:v>
                  </c:pt>
                  <c:pt idx="15">
                    <c:v>17457.35593200476</c:v>
                  </c:pt>
                  <c:pt idx="16">
                    <c:v>11069.46101779626</c:v>
                  </c:pt>
                  <c:pt idx="17">
                    <c:v>30995.65003668782</c:v>
                  </c:pt>
                  <c:pt idx="18">
                    <c:v>1277.363855248018</c:v>
                  </c:pt>
                  <c:pt idx="19">
                    <c:v>16409.02814762148</c:v>
                  </c:pt>
                  <c:pt idx="20">
                    <c:v>7206.352429013435</c:v>
                  </c:pt>
                  <c:pt idx="21">
                    <c:v>6289.018641916234</c:v>
                  </c:pt>
                  <c:pt idx="22">
                    <c:v>614.5197460462865</c:v>
                  </c:pt>
                  <c:pt idx="23">
                    <c:v>591.3078906416647</c:v>
                  </c:pt>
                  <c:pt idx="24">
                    <c:v>134887.9598261727</c:v>
                  </c:pt>
                  <c:pt idx="25">
                    <c:v>2475.531071322571</c:v>
                  </c:pt>
                  <c:pt idx="26">
                    <c:v>10455.93524772715</c:v>
                  </c:pt>
                  <c:pt idx="27">
                    <c:v>8642.929649426251</c:v>
                  </c:pt>
                  <c:pt idx="28">
                    <c:v>15194.43792671656</c:v>
                  </c:pt>
                  <c:pt idx="29">
                    <c:v>6375.976871811094</c:v>
                  </c:pt>
                  <c:pt idx="30">
                    <c:v>9743.428859591417</c:v>
                  </c:pt>
                </c:numCache>
              </c:numRef>
            </c:plus>
            <c:minus>
              <c:numRef>
                <c:f>'Interfect species'!$AG$82:$AG$112</c:f>
                <c:numCache>
                  <c:formatCode>General</c:formatCode>
                  <c:ptCount val="31"/>
                  <c:pt idx="0">
                    <c:v>8381.504734145062</c:v>
                  </c:pt>
                  <c:pt idx="1">
                    <c:v>1147.626763205815</c:v>
                  </c:pt>
                  <c:pt idx="2">
                    <c:v>3195.707092034208</c:v>
                  </c:pt>
                  <c:pt idx="3">
                    <c:v>61957.84319415469</c:v>
                  </c:pt>
                  <c:pt idx="4">
                    <c:v>325654.6445122286</c:v>
                  </c:pt>
                  <c:pt idx="5">
                    <c:v>80228.9679535964</c:v>
                  </c:pt>
                  <c:pt idx="6">
                    <c:v>1016.328120221966</c:v>
                  </c:pt>
                  <c:pt idx="7">
                    <c:v>91552.48833912225</c:v>
                  </c:pt>
                  <c:pt idx="8">
                    <c:v>166162.6752739546</c:v>
                  </c:pt>
                  <c:pt idx="9">
                    <c:v>20811.59280767732</c:v>
                  </c:pt>
                  <c:pt idx="10">
                    <c:v>5218.715937771475</c:v>
                  </c:pt>
                  <c:pt idx="11">
                    <c:v>318133.191437336</c:v>
                  </c:pt>
                  <c:pt idx="12">
                    <c:v>26127.72646599311</c:v>
                  </c:pt>
                  <c:pt idx="13">
                    <c:v>2852.328519865816</c:v>
                  </c:pt>
                  <c:pt idx="14">
                    <c:v>12842.10804847269</c:v>
                  </c:pt>
                  <c:pt idx="15">
                    <c:v>17457.35593200476</c:v>
                  </c:pt>
                  <c:pt idx="16">
                    <c:v>11069.46101779626</c:v>
                  </c:pt>
                  <c:pt idx="17">
                    <c:v>30995.65003668782</c:v>
                  </c:pt>
                  <c:pt idx="18">
                    <c:v>1277.363855248018</c:v>
                  </c:pt>
                  <c:pt idx="19">
                    <c:v>16409.02814762148</c:v>
                  </c:pt>
                  <c:pt idx="20">
                    <c:v>7206.352429013435</c:v>
                  </c:pt>
                  <c:pt idx="21">
                    <c:v>6289.018641916234</c:v>
                  </c:pt>
                  <c:pt idx="22">
                    <c:v>614.5197460462865</c:v>
                  </c:pt>
                  <c:pt idx="23">
                    <c:v>591.3078906416647</c:v>
                  </c:pt>
                  <c:pt idx="24">
                    <c:v>134887.9598261727</c:v>
                  </c:pt>
                  <c:pt idx="25">
                    <c:v>2475.531071322571</c:v>
                  </c:pt>
                  <c:pt idx="26">
                    <c:v>10455.93524772715</c:v>
                  </c:pt>
                  <c:pt idx="27">
                    <c:v>8642.929649426251</c:v>
                  </c:pt>
                  <c:pt idx="28">
                    <c:v>15194.43792671656</c:v>
                  </c:pt>
                  <c:pt idx="29">
                    <c:v>6375.976871811094</c:v>
                  </c:pt>
                  <c:pt idx="30">
                    <c:v>9743.4288595914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Z$82:$Z$112</c:f>
              <c:strCache>
                <c:ptCount val="31"/>
                <c:pt idx="0">
                  <c:v>LPC 16:0</c:v>
                </c:pt>
                <c:pt idx="1">
                  <c:v>LPC 18:1A</c:v>
                </c:pt>
                <c:pt idx="2">
                  <c:v>LPC 18:1B</c:v>
                </c:pt>
                <c:pt idx="3">
                  <c:v>PC 14:0_14:0</c:v>
                </c:pt>
                <c:pt idx="4">
                  <c:v>PC 14:0_16:0</c:v>
                </c:pt>
                <c:pt idx="5">
                  <c:v>PC 14:0_16:1</c:v>
                </c:pt>
                <c:pt idx="6">
                  <c:v>PC 14:0_20:4</c:v>
                </c:pt>
                <c:pt idx="7">
                  <c:v>PC 16:0_16:0</c:v>
                </c:pt>
                <c:pt idx="8">
                  <c:v>PC 16:0_16:1</c:v>
                </c:pt>
                <c:pt idx="9">
                  <c:v>PC 16:0_17:1</c:v>
                </c:pt>
                <c:pt idx="10">
                  <c:v>PC 16:0_18:0</c:v>
                </c:pt>
                <c:pt idx="11">
                  <c:v>PC 16:0_18:1</c:v>
                </c:pt>
                <c:pt idx="12">
                  <c:v>PC 16:0_20:1</c:v>
                </c:pt>
                <c:pt idx="13">
                  <c:v>PC 16:0_20:4</c:v>
                </c:pt>
                <c:pt idx="14">
                  <c:v>PC 16:0_20:5</c:v>
                </c:pt>
                <c:pt idx="15">
                  <c:v>PC 16:0_22:2</c:v>
                </c:pt>
                <c:pt idx="16">
                  <c:v>PC 16:0_22:6</c:v>
                </c:pt>
                <c:pt idx="17">
                  <c:v>PC 18:0_18:1</c:v>
                </c:pt>
                <c:pt idx="18">
                  <c:v>PC 18:0_20:3</c:v>
                </c:pt>
                <c:pt idx="19">
                  <c:v>PC 18:1_20:1</c:v>
                </c:pt>
                <c:pt idx="20">
                  <c:v>PC 18:1_20:5</c:v>
                </c:pt>
                <c:pt idx="21">
                  <c:v>PC 18:1_20:6</c:v>
                </c:pt>
                <c:pt idx="22">
                  <c:v>PC 18:1_22:4</c:v>
                </c:pt>
                <c:pt idx="23">
                  <c:v>PC 18:1_22:5</c:v>
                </c:pt>
                <c:pt idx="24">
                  <c:v>PC 18:2_16:0</c:v>
                </c:pt>
                <c:pt idx="25">
                  <c:v>PC 20:0_16:0</c:v>
                </c:pt>
                <c:pt idx="26">
                  <c:v>PC P-16:0_14:0</c:v>
                </c:pt>
                <c:pt idx="27">
                  <c:v>PC P-16:0_16:0</c:v>
                </c:pt>
                <c:pt idx="28">
                  <c:v>PC P-16:0_18:1</c:v>
                </c:pt>
                <c:pt idx="29">
                  <c:v>PC P-16:0_20:3</c:v>
                </c:pt>
                <c:pt idx="30">
                  <c:v>PC P-18:0_18:0</c:v>
                </c:pt>
              </c:strCache>
            </c:strRef>
          </c:cat>
          <c:val>
            <c:numRef>
              <c:f>'Interfect species'!$AB$82:$AB$112</c:f>
              <c:numCache>
                <c:formatCode>General</c:formatCode>
                <c:ptCount val="31"/>
                <c:pt idx="0">
                  <c:v>60722.80289713543</c:v>
                </c:pt>
                <c:pt idx="1">
                  <c:v>8060.152669270847</c:v>
                </c:pt>
                <c:pt idx="2">
                  <c:v>29061.85926310221</c:v>
                </c:pt>
                <c:pt idx="3">
                  <c:v>342175.41605</c:v>
                </c:pt>
                <c:pt idx="4">
                  <c:v>1.64786214816667E6</c:v>
                </c:pt>
                <c:pt idx="5">
                  <c:v>792746.2591333333</c:v>
                </c:pt>
                <c:pt idx="6">
                  <c:v>7930.429850333333</c:v>
                </c:pt>
                <c:pt idx="7">
                  <c:v>900228.3001833334</c:v>
                </c:pt>
                <c:pt idx="8">
                  <c:v>2.0259642395E6</c:v>
                </c:pt>
                <c:pt idx="9">
                  <c:v>194911.7011666667</c:v>
                </c:pt>
                <c:pt idx="10">
                  <c:v>66797.44140666665</c:v>
                </c:pt>
                <c:pt idx="11">
                  <c:v>2.6777762475E6</c:v>
                </c:pt>
                <c:pt idx="12">
                  <c:v>200541.9736333333</c:v>
                </c:pt>
                <c:pt idx="13">
                  <c:v>35990.52238</c:v>
                </c:pt>
                <c:pt idx="14">
                  <c:v>111821.9081983333</c:v>
                </c:pt>
                <c:pt idx="15">
                  <c:v>102010.1958766667</c:v>
                </c:pt>
                <c:pt idx="16">
                  <c:v>62894.238605</c:v>
                </c:pt>
                <c:pt idx="17">
                  <c:v>230628.0802333333</c:v>
                </c:pt>
                <c:pt idx="18">
                  <c:v>8857.895914166664</c:v>
                </c:pt>
                <c:pt idx="19">
                  <c:v>90741.79638166663</c:v>
                </c:pt>
                <c:pt idx="20">
                  <c:v>81481.34554000001</c:v>
                </c:pt>
                <c:pt idx="21">
                  <c:v>56730.924805</c:v>
                </c:pt>
                <c:pt idx="22">
                  <c:v>5144.582479</c:v>
                </c:pt>
                <c:pt idx="23">
                  <c:v>7363.147745666666</c:v>
                </c:pt>
                <c:pt idx="24">
                  <c:v>1.13596509633333E6</c:v>
                </c:pt>
                <c:pt idx="25">
                  <c:v>24211.98335833333</c:v>
                </c:pt>
                <c:pt idx="26">
                  <c:v>72949.61108333333</c:v>
                </c:pt>
                <c:pt idx="27">
                  <c:v>81760.43066333333</c:v>
                </c:pt>
                <c:pt idx="28">
                  <c:v>97361.07597499998</c:v>
                </c:pt>
                <c:pt idx="29">
                  <c:v>54726.43668666665</c:v>
                </c:pt>
                <c:pt idx="30">
                  <c:v>57132.53727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AAA-4CAD-8A75-38DA34F0B623}"/>
            </c:ext>
          </c:extLst>
        </c:ser>
        <c:ser>
          <c:idx val="2"/>
          <c:order val="2"/>
          <c:tx>
            <c:strRef>
              <c:f>'Interfect species'!$AC$81</c:f>
              <c:strCache>
                <c:ptCount val="1"/>
                <c:pt idx="0">
                  <c:v>INTERFERin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82:$AH$112</c:f>
                <c:numCache>
                  <c:formatCode>General</c:formatCode>
                  <c:ptCount val="31"/>
                  <c:pt idx="0">
                    <c:v>4134.255888460158</c:v>
                  </c:pt>
                  <c:pt idx="1">
                    <c:v>433.6083631912547</c:v>
                  </c:pt>
                  <c:pt idx="2">
                    <c:v>1515.727059202896</c:v>
                  </c:pt>
                  <c:pt idx="3">
                    <c:v>42588.55565824027</c:v>
                  </c:pt>
                  <c:pt idx="4">
                    <c:v>194225.0318828993</c:v>
                  </c:pt>
                  <c:pt idx="5">
                    <c:v>94597.64323101861</c:v>
                  </c:pt>
                  <c:pt idx="6">
                    <c:v>1157.333244334291</c:v>
                  </c:pt>
                  <c:pt idx="7">
                    <c:v>74104.22740557266</c:v>
                  </c:pt>
                  <c:pt idx="8">
                    <c:v>176284.5441344294</c:v>
                  </c:pt>
                  <c:pt idx="9">
                    <c:v>16451.59301517246</c:v>
                  </c:pt>
                  <c:pt idx="10">
                    <c:v>6365.089590857913</c:v>
                  </c:pt>
                  <c:pt idx="11">
                    <c:v>186466.63837211</c:v>
                  </c:pt>
                  <c:pt idx="12">
                    <c:v>8352.326315333752</c:v>
                  </c:pt>
                  <c:pt idx="13">
                    <c:v>2949.668727483746</c:v>
                  </c:pt>
                  <c:pt idx="14">
                    <c:v>9315.491510197727</c:v>
                  </c:pt>
                  <c:pt idx="15">
                    <c:v>15255.31909079142</c:v>
                  </c:pt>
                  <c:pt idx="16">
                    <c:v>7589.975115184651</c:v>
                  </c:pt>
                  <c:pt idx="17">
                    <c:v>10759.50601418464</c:v>
                  </c:pt>
                  <c:pt idx="18">
                    <c:v>1072.777524206459</c:v>
                  </c:pt>
                  <c:pt idx="19">
                    <c:v>14656.43788987353</c:v>
                  </c:pt>
                  <c:pt idx="20">
                    <c:v>7243.680482106387</c:v>
                  </c:pt>
                  <c:pt idx="21">
                    <c:v>7570.340987458316</c:v>
                  </c:pt>
                  <c:pt idx="22">
                    <c:v>666.4832885856049</c:v>
                  </c:pt>
                  <c:pt idx="23">
                    <c:v>1134.866960073405</c:v>
                  </c:pt>
                  <c:pt idx="24">
                    <c:v>103338.3634362176</c:v>
                  </c:pt>
                  <c:pt idx="25">
                    <c:v>2226.420673101021</c:v>
                  </c:pt>
                  <c:pt idx="26">
                    <c:v>5328.745224028293</c:v>
                  </c:pt>
                  <c:pt idx="27">
                    <c:v>9759.412965583078</c:v>
                  </c:pt>
                  <c:pt idx="28">
                    <c:v>11587.17351725745</c:v>
                  </c:pt>
                  <c:pt idx="29">
                    <c:v>3788.377448460302</c:v>
                  </c:pt>
                  <c:pt idx="30">
                    <c:v>6709.303807499142</c:v>
                  </c:pt>
                </c:numCache>
              </c:numRef>
            </c:plus>
            <c:minus>
              <c:numRef>
                <c:f>'Interfect species'!$AH$82:$AH$112</c:f>
                <c:numCache>
                  <c:formatCode>General</c:formatCode>
                  <c:ptCount val="31"/>
                  <c:pt idx="0">
                    <c:v>4134.255888460158</c:v>
                  </c:pt>
                  <c:pt idx="1">
                    <c:v>433.6083631912547</c:v>
                  </c:pt>
                  <c:pt idx="2">
                    <c:v>1515.727059202896</c:v>
                  </c:pt>
                  <c:pt idx="3">
                    <c:v>42588.55565824027</c:v>
                  </c:pt>
                  <c:pt idx="4">
                    <c:v>194225.0318828993</c:v>
                  </c:pt>
                  <c:pt idx="5">
                    <c:v>94597.64323101861</c:v>
                  </c:pt>
                  <c:pt idx="6">
                    <c:v>1157.333244334291</c:v>
                  </c:pt>
                  <c:pt idx="7">
                    <c:v>74104.22740557266</c:v>
                  </c:pt>
                  <c:pt idx="8">
                    <c:v>176284.5441344294</c:v>
                  </c:pt>
                  <c:pt idx="9">
                    <c:v>16451.59301517246</c:v>
                  </c:pt>
                  <c:pt idx="10">
                    <c:v>6365.089590857913</c:v>
                  </c:pt>
                  <c:pt idx="11">
                    <c:v>186466.63837211</c:v>
                  </c:pt>
                  <c:pt idx="12">
                    <c:v>8352.326315333752</c:v>
                  </c:pt>
                  <c:pt idx="13">
                    <c:v>2949.668727483746</c:v>
                  </c:pt>
                  <c:pt idx="14">
                    <c:v>9315.491510197727</c:v>
                  </c:pt>
                  <c:pt idx="15">
                    <c:v>15255.31909079142</c:v>
                  </c:pt>
                  <c:pt idx="16">
                    <c:v>7589.975115184651</c:v>
                  </c:pt>
                  <c:pt idx="17">
                    <c:v>10759.50601418464</c:v>
                  </c:pt>
                  <c:pt idx="18">
                    <c:v>1072.777524206459</c:v>
                  </c:pt>
                  <c:pt idx="19">
                    <c:v>14656.43788987353</c:v>
                  </c:pt>
                  <c:pt idx="20">
                    <c:v>7243.680482106387</c:v>
                  </c:pt>
                  <c:pt idx="21">
                    <c:v>7570.340987458316</c:v>
                  </c:pt>
                  <c:pt idx="22">
                    <c:v>666.4832885856049</c:v>
                  </c:pt>
                  <c:pt idx="23">
                    <c:v>1134.866960073405</c:v>
                  </c:pt>
                  <c:pt idx="24">
                    <c:v>103338.3634362176</c:v>
                  </c:pt>
                  <c:pt idx="25">
                    <c:v>2226.420673101021</c:v>
                  </c:pt>
                  <c:pt idx="26">
                    <c:v>5328.745224028293</c:v>
                  </c:pt>
                  <c:pt idx="27">
                    <c:v>9759.412965583078</c:v>
                  </c:pt>
                  <c:pt idx="28">
                    <c:v>11587.17351725745</c:v>
                  </c:pt>
                  <c:pt idx="29">
                    <c:v>3788.377448460302</c:v>
                  </c:pt>
                  <c:pt idx="30">
                    <c:v>6709.3038074991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Z$82:$Z$112</c:f>
              <c:strCache>
                <c:ptCount val="31"/>
                <c:pt idx="0">
                  <c:v>LPC 16:0</c:v>
                </c:pt>
                <c:pt idx="1">
                  <c:v>LPC 18:1A</c:v>
                </c:pt>
                <c:pt idx="2">
                  <c:v>LPC 18:1B</c:v>
                </c:pt>
                <c:pt idx="3">
                  <c:v>PC 14:0_14:0</c:v>
                </c:pt>
                <c:pt idx="4">
                  <c:v>PC 14:0_16:0</c:v>
                </c:pt>
                <c:pt idx="5">
                  <c:v>PC 14:0_16:1</c:v>
                </c:pt>
                <c:pt idx="6">
                  <c:v>PC 14:0_20:4</c:v>
                </c:pt>
                <c:pt idx="7">
                  <c:v>PC 16:0_16:0</c:v>
                </c:pt>
                <c:pt idx="8">
                  <c:v>PC 16:0_16:1</c:v>
                </c:pt>
                <c:pt idx="9">
                  <c:v>PC 16:0_17:1</c:v>
                </c:pt>
                <c:pt idx="10">
                  <c:v>PC 16:0_18:0</c:v>
                </c:pt>
                <c:pt idx="11">
                  <c:v>PC 16:0_18:1</c:v>
                </c:pt>
                <c:pt idx="12">
                  <c:v>PC 16:0_20:1</c:v>
                </c:pt>
                <c:pt idx="13">
                  <c:v>PC 16:0_20:4</c:v>
                </c:pt>
                <c:pt idx="14">
                  <c:v>PC 16:0_20:5</c:v>
                </c:pt>
                <c:pt idx="15">
                  <c:v>PC 16:0_22:2</c:v>
                </c:pt>
                <c:pt idx="16">
                  <c:v>PC 16:0_22:6</c:v>
                </c:pt>
                <c:pt idx="17">
                  <c:v>PC 18:0_18:1</c:v>
                </c:pt>
                <c:pt idx="18">
                  <c:v>PC 18:0_20:3</c:v>
                </c:pt>
                <c:pt idx="19">
                  <c:v>PC 18:1_20:1</c:v>
                </c:pt>
                <c:pt idx="20">
                  <c:v>PC 18:1_20:5</c:v>
                </c:pt>
                <c:pt idx="21">
                  <c:v>PC 18:1_20:6</c:v>
                </c:pt>
                <c:pt idx="22">
                  <c:v>PC 18:1_22:4</c:v>
                </c:pt>
                <c:pt idx="23">
                  <c:v>PC 18:1_22:5</c:v>
                </c:pt>
                <c:pt idx="24">
                  <c:v>PC 18:2_16:0</c:v>
                </c:pt>
                <c:pt idx="25">
                  <c:v>PC 20:0_16:0</c:v>
                </c:pt>
                <c:pt idx="26">
                  <c:v>PC P-16:0_14:0</c:v>
                </c:pt>
                <c:pt idx="27">
                  <c:v>PC P-16:0_16:0</c:v>
                </c:pt>
                <c:pt idx="28">
                  <c:v>PC P-16:0_18:1</c:v>
                </c:pt>
                <c:pt idx="29">
                  <c:v>PC P-16:0_20:3</c:v>
                </c:pt>
                <c:pt idx="30">
                  <c:v>PC P-18:0_18:0</c:v>
                </c:pt>
              </c:strCache>
            </c:strRef>
          </c:cat>
          <c:val>
            <c:numRef>
              <c:f>'Interfect species'!$AC$82:$AC$112</c:f>
              <c:numCache>
                <c:formatCode>General</c:formatCode>
                <c:ptCount val="31"/>
                <c:pt idx="0">
                  <c:v>54349.06795247401</c:v>
                </c:pt>
                <c:pt idx="1">
                  <c:v>7310.140401204427</c:v>
                </c:pt>
                <c:pt idx="2">
                  <c:v>26965.54232788086</c:v>
                </c:pt>
                <c:pt idx="3">
                  <c:v>303131.9974000001</c:v>
                </c:pt>
                <c:pt idx="4">
                  <c:v>1.43594516366667E6</c:v>
                </c:pt>
                <c:pt idx="5">
                  <c:v>702209.9767333334</c:v>
                </c:pt>
                <c:pt idx="6">
                  <c:v>9225.861653166663</c:v>
                </c:pt>
                <c:pt idx="7">
                  <c:v>843670.41015</c:v>
                </c:pt>
                <c:pt idx="8">
                  <c:v>1.88748369283333E6</c:v>
                </c:pt>
                <c:pt idx="9">
                  <c:v>194494.6888</c:v>
                </c:pt>
                <c:pt idx="10">
                  <c:v>75560.314455</c:v>
                </c:pt>
                <c:pt idx="11">
                  <c:v>2.520869232E6</c:v>
                </c:pt>
                <c:pt idx="12">
                  <c:v>203669.4502</c:v>
                </c:pt>
                <c:pt idx="13">
                  <c:v>38495.75960166666</c:v>
                </c:pt>
                <c:pt idx="14">
                  <c:v>120700.4576833333</c:v>
                </c:pt>
                <c:pt idx="15">
                  <c:v>89469.27775833336</c:v>
                </c:pt>
                <c:pt idx="16">
                  <c:v>69285.48209833333</c:v>
                </c:pt>
                <c:pt idx="17">
                  <c:v>227945.7924666666</c:v>
                </c:pt>
                <c:pt idx="18">
                  <c:v>9837.595662666665</c:v>
                </c:pt>
                <c:pt idx="19">
                  <c:v>81416.91894999999</c:v>
                </c:pt>
                <c:pt idx="20">
                  <c:v>94396.90982666664</c:v>
                </c:pt>
                <c:pt idx="21">
                  <c:v>68965.277345</c:v>
                </c:pt>
                <c:pt idx="22">
                  <c:v>6876.500529</c:v>
                </c:pt>
                <c:pt idx="23">
                  <c:v>8797.5525715</c:v>
                </c:pt>
                <c:pt idx="24">
                  <c:v>1.02604369408333E6</c:v>
                </c:pt>
                <c:pt idx="25">
                  <c:v>18046.32942833333</c:v>
                </c:pt>
                <c:pt idx="26">
                  <c:v>70834.26660166663</c:v>
                </c:pt>
                <c:pt idx="27">
                  <c:v>75060.00423166664</c:v>
                </c:pt>
                <c:pt idx="28">
                  <c:v>85523.81452833334</c:v>
                </c:pt>
                <c:pt idx="29">
                  <c:v>51854.94181333334</c:v>
                </c:pt>
                <c:pt idx="30">
                  <c:v>54549.778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AAA-4CAD-8A75-38DA34F0B6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053193384"/>
        <c:axId val="2053197032"/>
      </c:barChart>
      <c:catAx>
        <c:axId val="2053193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53197032"/>
        <c:crosses val="autoZero"/>
        <c:auto val="1"/>
        <c:lblAlgn val="ctr"/>
        <c:lblOffset val="100"/>
        <c:noMultiLvlLbl val="0"/>
      </c:catAx>
      <c:valAx>
        <c:axId val="20531970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531933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terfect species'!$Z$117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F$118:$AF$138</c:f>
                <c:numCache>
                  <c:formatCode>General</c:formatCode>
                  <c:ptCount val="21"/>
                  <c:pt idx="0">
                    <c:v>1863.4787522793</c:v>
                  </c:pt>
                  <c:pt idx="1">
                    <c:v>391.9143938775046</c:v>
                  </c:pt>
                  <c:pt idx="2">
                    <c:v>1260.250747148256</c:v>
                  </c:pt>
                  <c:pt idx="3">
                    <c:v>3299.008526627162</c:v>
                  </c:pt>
                  <c:pt idx="4">
                    <c:v>46937.58998000393</c:v>
                  </c:pt>
                  <c:pt idx="5">
                    <c:v>81773.88201396748</c:v>
                  </c:pt>
                  <c:pt idx="6">
                    <c:v>20567.84440806392</c:v>
                  </c:pt>
                  <c:pt idx="7">
                    <c:v>1309.834309056893</c:v>
                  </c:pt>
                  <c:pt idx="8">
                    <c:v>657.8115614734525</c:v>
                  </c:pt>
                  <c:pt idx="9">
                    <c:v>9888.588741591755</c:v>
                  </c:pt>
                  <c:pt idx="10">
                    <c:v>977.7073688115947</c:v>
                  </c:pt>
                  <c:pt idx="11">
                    <c:v>877.2930509973157</c:v>
                  </c:pt>
                  <c:pt idx="12">
                    <c:v>30654.8886481169</c:v>
                  </c:pt>
                  <c:pt idx="13">
                    <c:v>858.360846356114</c:v>
                  </c:pt>
                  <c:pt idx="14">
                    <c:v>9363.71569033104</c:v>
                  </c:pt>
                  <c:pt idx="15">
                    <c:v>590.2658288257677</c:v>
                  </c:pt>
                  <c:pt idx="16">
                    <c:v>258.6499230676844</c:v>
                  </c:pt>
                  <c:pt idx="17">
                    <c:v>126.2062897542007</c:v>
                  </c:pt>
                  <c:pt idx="18">
                    <c:v>166.3132394861498</c:v>
                  </c:pt>
                  <c:pt idx="19">
                    <c:v>651.081635810221</c:v>
                  </c:pt>
                  <c:pt idx="20">
                    <c:v>4784.886259326757</c:v>
                  </c:pt>
                </c:numCache>
              </c:numRef>
            </c:plus>
            <c:minus>
              <c:numRef>
                <c:f>'Interfect species'!$AF$118:$AF$138</c:f>
                <c:numCache>
                  <c:formatCode>General</c:formatCode>
                  <c:ptCount val="21"/>
                  <c:pt idx="0">
                    <c:v>1863.4787522793</c:v>
                  </c:pt>
                  <c:pt idx="1">
                    <c:v>391.9143938775046</c:v>
                  </c:pt>
                  <c:pt idx="2">
                    <c:v>1260.250747148256</c:v>
                  </c:pt>
                  <c:pt idx="3">
                    <c:v>3299.008526627162</c:v>
                  </c:pt>
                  <c:pt idx="4">
                    <c:v>46937.58998000393</c:v>
                  </c:pt>
                  <c:pt idx="5">
                    <c:v>81773.88201396748</c:v>
                  </c:pt>
                  <c:pt idx="6">
                    <c:v>20567.84440806392</c:v>
                  </c:pt>
                  <c:pt idx="7">
                    <c:v>1309.834309056893</c:v>
                  </c:pt>
                  <c:pt idx="8">
                    <c:v>657.8115614734525</c:v>
                  </c:pt>
                  <c:pt idx="9">
                    <c:v>9888.588741591755</c:v>
                  </c:pt>
                  <c:pt idx="10">
                    <c:v>977.7073688115947</c:v>
                  </c:pt>
                  <c:pt idx="11">
                    <c:v>877.2930509973157</c:v>
                  </c:pt>
                  <c:pt idx="12">
                    <c:v>30654.8886481169</c:v>
                  </c:pt>
                  <c:pt idx="13">
                    <c:v>858.360846356114</c:v>
                  </c:pt>
                  <c:pt idx="14">
                    <c:v>9363.71569033104</c:v>
                  </c:pt>
                  <c:pt idx="15">
                    <c:v>590.2658288257677</c:v>
                  </c:pt>
                  <c:pt idx="16">
                    <c:v>258.6499230676844</c:v>
                  </c:pt>
                  <c:pt idx="17">
                    <c:v>126.2062897542007</c:v>
                  </c:pt>
                  <c:pt idx="18">
                    <c:v>166.3132394861498</c:v>
                  </c:pt>
                  <c:pt idx="19">
                    <c:v>651.081635810221</c:v>
                  </c:pt>
                  <c:pt idx="20">
                    <c:v>4784.8862593267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18:$Y$138</c:f>
              <c:strCache>
                <c:ptCount val="21"/>
                <c:pt idx="0">
                  <c:v>PG 14:0_16:0</c:v>
                </c:pt>
                <c:pt idx="1">
                  <c:v>PG 14:0_18:2</c:v>
                </c:pt>
                <c:pt idx="2">
                  <c:v>PG 16:0_16:0</c:v>
                </c:pt>
                <c:pt idx="3">
                  <c:v>PG 16:0_16:1</c:v>
                </c:pt>
                <c:pt idx="4">
                  <c:v>PG 16:0_18:0</c:v>
                </c:pt>
                <c:pt idx="5">
                  <c:v>PG 16:0_18:1</c:v>
                </c:pt>
                <c:pt idx="6">
                  <c:v>PG 16:0_20:1</c:v>
                </c:pt>
                <c:pt idx="7">
                  <c:v>PG 16:0_22:6</c:v>
                </c:pt>
                <c:pt idx="8">
                  <c:v>PG 16:0_22:6</c:v>
                </c:pt>
                <c:pt idx="9">
                  <c:v>PG 16:1_18:1</c:v>
                </c:pt>
                <c:pt idx="10">
                  <c:v>PG 16:1_22:6</c:v>
                </c:pt>
                <c:pt idx="11">
                  <c:v>PG 18:0_22:6</c:v>
                </c:pt>
                <c:pt idx="12">
                  <c:v>PG 18:1_18:1</c:v>
                </c:pt>
                <c:pt idx="13">
                  <c:v>PG 18:1_22:5</c:v>
                </c:pt>
                <c:pt idx="14">
                  <c:v>PG 18:1_22:6</c:v>
                </c:pt>
                <c:pt idx="15">
                  <c:v>PG 18:2_22:6</c:v>
                </c:pt>
                <c:pt idx="16">
                  <c:v>PG 20:3_22:6</c:v>
                </c:pt>
                <c:pt idx="17">
                  <c:v>PG 20:5_22:6</c:v>
                </c:pt>
                <c:pt idx="18">
                  <c:v>PG 22:4_22:6</c:v>
                </c:pt>
                <c:pt idx="19">
                  <c:v>PG 22:5_22:6</c:v>
                </c:pt>
                <c:pt idx="20">
                  <c:v>PG 22:6_22:6</c:v>
                </c:pt>
              </c:strCache>
            </c:strRef>
          </c:cat>
          <c:val>
            <c:numRef>
              <c:f>'Interfect species'!$Z$118:$Z$138</c:f>
              <c:numCache>
                <c:formatCode>General</c:formatCode>
                <c:ptCount val="21"/>
                <c:pt idx="0">
                  <c:v>9824.205764770507</c:v>
                </c:pt>
                <c:pt idx="1">
                  <c:v>5157.03210449219</c:v>
                </c:pt>
                <c:pt idx="2">
                  <c:v>4569.669433593752</c:v>
                </c:pt>
                <c:pt idx="3">
                  <c:v>41546.935546875</c:v>
                </c:pt>
                <c:pt idx="4">
                  <c:v>236036.1309254247</c:v>
                </c:pt>
                <c:pt idx="5">
                  <c:v>707924.9044290186</c:v>
                </c:pt>
                <c:pt idx="6">
                  <c:v>161876.4934082034</c:v>
                </c:pt>
                <c:pt idx="7">
                  <c:v>5465.35971069336</c:v>
                </c:pt>
                <c:pt idx="8">
                  <c:v>2814.91343688965</c:v>
                </c:pt>
                <c:pt idx="9">
                  <c:v>28935.1745223999</c:v>
                </c:pt>
                <c:pt idx="10">
                  <c:v>8161.079399108889</c:v>
                </c:pt>
                <c:pt idx="11">
                  <c:v>5200.576182047526</c:v>
                </c:pt>
                <c:pt idx="12">
                  <c:v>110589.8548177085</c:v>
                </c:pt>
                <c:pt idx="13">
                  <c:v>4992.963022867841</c:v>
                </c:pt>
                <c:pt idx="14">
                  <c:v>46441.87338256836</c:v>
                </c:pt>
                <c:pt idx="15">
                  <c:v>2151.46863301595</c:v>
                </c:pt>
                <c:pt idx="16">
                  <c:v>1964.297083536783</c:v>
                </c:pt>
                <c:pt idx="17">
                  <c:v>954.7708638509121</c:v>
                </c:pt>
                <c:pt idx="18">
                  <c:v>949.9395345052093</c:v>
                </c:pt>
                <c:pt idx="19">
                  <c:v>3359.506490071615</c:v>
                </c:pt>
                <c:pt idx="20">
                  <c:v>14204.3439331054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A4C-4EE3-9730-D6A4D5AC159C}"/>
            </c:ext>
          </c:extLst>
        </c:ser>
        <c:ser>
          <c:idx val="1"/>
          <c:order val="1"/>
          <c:tx>
            <c:strRef>
              <c:f>'Interfect species'!$AA$117</c:f>
              <c:strCache>
                <c:ptCount val="1"/>
                <c:pt idx="0">
                  <c:v>INTERFER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G$118:$AG$138</c:f>
                <c:numCache>
                  <c:formatCode>General</c:formatCode>
                  <c:ptCount val="21"/>
                  <c:pt idx="0">
                    <c:v>4379.145374318431</c:v>
                  </c:pt>
                  <c:pt idx="1">
                    <c:v>2160.186151941349</c:v>
                  </c:pt>
                  <c:pt idx="2">
                    <c:v>2038.932645622241</c:v>
                  </c:pt>
                  <c:pt idx="3">
                    <c:v>19127.59284123325</c:v>
                  </c:pt>
                  <c:pt idx="4">
                    <c:v>50430.36357362617</c:v>
                  </c:pt>
                  <c:pt idx="5">
                    <c:v>255206.7410397055</c:v>
                  </c:pt>
                  <c:pt idx="6">
                    <c:v>65882.15313022634</c:v>
                  </c:pt>
                  <c:pt idx="7">
                    <c:v>1068.68911549004</c:v>
                  </c:pt>
                  <c:pt idx="8">
                    <c:v>1120.825138028607</c:v>
                  </c:pt>
                  <c:pt idx="9">
                    <c:v>7879.87133992986</c:v>
                  </c:pt>
                  <c:pt idx="10">
                    <c:v>2525.916936568686</c:v>
                  </c:pt>
                  <c:pt idx="11">
                    <c:v>1537.920625994045</c:v>
                  </c:pt>
                  <c:pt idx="12">
                    <c:v>57534.49872162106</c:v>
                  </c:pt>
                  <c:pt idx="13">
                    <c:v>1325.689061729243</c:v>
                  </c:pt>
                  <c:pt idx="14">
                    <c:v>9431.387865618875</c:v>
                  </c:pt>
                  <c:pt idx="15">
                    <c:v>513.075526300326</c:v>
                  </c:pt>
                  <c:pt idx="16">
                    <c:v>524.2816080450126</c:v>
                  </c:pt>
                  <c:pt idx="17">
                    <c:v>235.0455761726359</c:v>
                  </c:pt>
                  <c:pt idx="18">
                    <c:v>184.275654513716</c:v>
                  </c:pt>
                  <c:pt idx="19">
                    <c:v>935.942097249529</c:v>
                  </c:pt>
                  <c:pt idx="20">
                    <c:v>3535.986439946875</c:v>
                  </c:pt>
                </c:numCache>
              </c:numRef>
            </c:plus>
            <c:minus>
              <c:numRef>
                <c:f>'Interfect species'!$AG$118:$AG$138</c:f>
                <c:numCache>
                  <c:formatCode>General</c:formatCode>
                  <c:ptCount val="21"/>
                  <c:pt idx="0">
                    <c:v>4379.145374318431</c:v>
                  </c:pt>
                  <c:pt idx="1">
                    <c:v>2160.186151941349</c:v>
                  </c:pt>
                  <c:pt idx="2">
                    <c:v>2038.932645622241</c:v>
                  </c:pt>
                  <c:pt idx="3">
                    <c:v>19127.59284123325</c:v>
                  </c:pt>
                  <c:pt idx="4">
                    <c:v>50430.36357362617</c:v>
                  </c:pt>
                  <c:pt idx="5">
                    <c:v>255206.7410397055</c:v>
                  </c:pt>
                  <c:pt idx="6">
                    <c:v>65882.15313022634</c:v>
                  </c:pt>
                  <c:pt idx="7">
                    <c:v>1068.68911549004</c:v>
                  </c:pt>
                  <c:pt idx="8">
                    <c:v>1120.825138028607</c:v>
                  </c:pt>
                  <c:pt idx="9">
                    <c:v>7879.87133992986</c:v>
                  </c:pt>
                  <c:pt idx="10">
                    <c:v>2525.916936568686</c:v>
                  </c:pt>
                  <c:pt idx="11">
                    <c:v>1537.920625994045</c:v>
                  </c:pt>
                  <c:pt idx="12">
                    <c:v>57534.49872162106</c:v>
                  </c:pt>
                  <c:pt idx="13">
                    <c:v>1325.689061729243</c:v>
                  </c:pt>
                  <c:pt idx="14">
                    <c:v>9431.387865618875</c:v>
                  </c:pt>
                  <c:pt idx="15">
                    <c:v>513.075526300326</c:v>
                  </c:pt>
                  <c:pt idx="16">
                    <c:v>524.2816080450126</c:v>
                  </c:pt>
                  <c:pt idx="17">
                    <c:v>235.0455761726359</c:v>
                  </c:pt>
                  <c:pt idx="18">
                    <c:v>184.275654513716</c:v>
                  </c:pt>
                  <c:pt idx="19">
                    <c:v>935.942097249529</c:v>
                  </c:pt>
                  <c:pt idx="20">
                    <c:v>3535.9864399468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18:$Y$138</c:f>
              <c:strCache>
                <c:ptCount val="21"/>
                <c:pt idx="0">
                  <c:v>PG 14:0_16:0</c:v>
                </c:pt>
                <c:pt idx="1">
                  <c:v>PG 14:0_18:2</c:v>
                </c:pt>
                <c:pt idx="2">
                  <c:v>PG 16:0_16:0</c:v>
                </c:pt>
                <c:pt idx="3">
                  <c:v>PG 16:0_16:1</c:v>
                </c:pt>
                <c:pt idx="4">
                  <c:v>PG 16:0_18:0</c:v>
                </c:pt>
                <c:pt idx="5">
                  <c:v>PG 16:0_18:1</c:v>
                </c:pt>
                <c:pt idx="6">
                  <c:v>PG 16:0_20:1</c:v>
                </c:pt>
                <c:pt idx="7">
                  <c:v>PG 16:0_22:6</c:v>
                </c:pt>
                <c:pt idx="8">
                  <c:v>PG 16:0_22:6</c:v>
                </c:pt>
                <c:pt idx="9">
                  <c:v>PG 16:1_18:1</c:v>
                </c:pt>
                <c:pt idx="10">
                  <c:v>PG 16:1_22:6</c:v>
                </c:pt>
                <c:pt idx="11">
                  <c:v>PG 18:0_22:6</c:v>
                </c:pt>
                <c:pt idx="12">
                  <c:v>PG 18:1_18:1</c:v>
                </c:pt>
                <c:pt idx="13">
                  <c:v>PG 18:1_22:5</c:v>
                </c:pt>
                <c:pt idx="14">
                  <c:v>PG 18:1_22:6</c:v>
                </c:pt>
                <c:pt idx="15">
                  <c:v>PG 18:2_22:6</c:v>
                </c:pt>
                <c:pt idx="16">
                  <c:v>PG 20:3_22:6</c:v>
                </c:pt>
                <c:pt idx="17">
                  <c:v>PG 20:5_22:6</c:v>
                </c:pt>
                <c:pt idx="18">
                  <c:v>PG 22:4_22:6</c:v>
                </c:pt>
                <c:pt idx="19">
                  <c:v>PG 22:5_22:6</c:v>
                </c:pt>
                <c:pt idx="20">
                  <c:v>PG 22:6_22:6</c:v>
                </c:pt>
              </c:strCache>
            </c:strRef>
          </c:cat>
          <c:val>
            <c:numRef>
              <c:f>'Interfect species'!$AA$118:$AA$138</c:f>
              <c:numCache>
                <c:formatCode>General</c:formatCode>
                <c:ptCount val="21"/>
                <c:pt idx="0">
                  <c:v>12181.43323771159</c:v>
                </c:pt>
                <c:pt idx="1">
                  <c:v>7061.111546834312</c:v>
                </c:pt>
                <c:pt idx="2">
                  <c:v>7881.797017415372</c:v>
                </c:pt>
                <c:pt idx="3">
                  <c:v>49699.17781575523</c:v>
                </c:pt>
                <c:pt idx="4">
                  <c:v>230713.107656959</c:v>
                </c:pt>
                <c:pt idx="5">
                  <c:v>724938.0233573133</c:v>
                </c:pt>
                <c:pt idx="6">
                  <c:v>161863.1064453127</c:v>
                </c:pt>
                <c:pt idx="7">
                  <c:v>7444.137919108074</c:v>
                </c:pt>
                <c:pt idx="8">
                  <c:v>2881.360590616862</c:v>
                </c:pt>
                <c:pt idx="9">
                  <c:v>28172.0129699707</c:v>
                </c:pt>
                <c:pt idx="10">
                  <c:v>14071.96001688638</c:v>
                </c:pt>
                <c:pt idx="11">
                  <c:v>7216.232686360677</c:v>
                </c:pt>
                <c:pt idx="12">
                  <c:v>110379.7035319011</c:v>
                </c:pt>
                <c:pt idx="13">
                  <c:v>6841.503153483071</c:v>
                </c:pt>
                <c:pt idx="14">
                  <c:v>61857.33666483562</c:v>
                </c:pt>
                <c:pt idx="15">
                  <c:v>3121.300404866537</c:v>
                </c:pt>
                <c:pt idx="16">
                  <c:v>2348.818237304689</c:v>
                </c:pt>
                <c:pt idx="17">
                  <c:v>1702.453852335613</c:v>
                </c:pt>
                <c:pt idx="18">
                  <c:v>1306.179026285808</c:v>
                </c:pt>
                <c:pt idx="19">
                  <c:v>8565.356160481773</c:v>
                </c:pt>
                <c:pt idx="20">
                  <c:v>32797.265706380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A4C-4EE3-9730-D6A4D5AC159C}"/>
            </c:ext>
          </c:extLst>
        </c:ser>
        <c:ser>
          <c:idx val="2"/>
          <c:order val="2"/>
          <c:tx>
            <c:strRef>
              <c:f>'Interfect species'!$AB$117</c:f>
              <c:strCache>
                <c:ptCount val="1"/>
                <c:pt idx="0">
                  <c:v>INTERFERin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118:$AH$138</c:f>
                <c:numCache>
                  <c:formatCode>General</c:formatCode>
                  <c:ptCount val="21"/>
                  <c:pt idx="0">
                    <c:v>1289.469326805726</c:v>
                  </c:pt>
                  <c:pt idx="1">
                    <c:v>1414.264668386603</c:v>
                  </c:pt>
                  <c:pt idx="2">
                    <c:v>1389.821331742002</c:v>
                  </c:pt>
                  <c:pt idx="3">
                    <c:v>8318.792688084033</c:v>
                  </c:pt>
                  <c:pt idx="4">
                    <c:v>31022.26321093093</c:v>
                  </c:pt>
                  <c:pt idx="5">
                    <c:v>127903.5783246474</c:v>
                  </c:pt>
                  <c:pt idx="6">
                    <c:v>27670.34933258926</c:v>
                  </c:pt>
                  <c:pt idx="7">
                    <c:v>1167.30192919073</c:v>
                  </c:pt>
                  <c:pt idx="8">
                    <c:v>424.6762296982988</c:v>
                  </c:pt>
                  <c:pt idx="9">
                    <c:v>5233.310462927847</c:v>
                  </c:pt>
                  <c:pt idx="10">
                    <c:v>1955.347148536025</c:v>
                  </c:pt>
                  <c:pt idx="11">
                    <c:v>831.6733743487758</c:v>
                  </c:pt>
                  <c:pt idx="12">
                    <c:v>28018.41581015896</c:v>
                  </c:pt>
                  <c:pt idx="13">
                    <c:v>613.0430274534683</c:v>
                  </c:pt>
                  <c:pt idx="14">
                    <c:v>10765.94878312805</c:v>
                  </c:pt>
                  <c:pt idx="15">
                    <c:v>350.8935877438298</c:v>
                  </c:pt>
                  <c:pt idx="16">
                    <c:v>421.0852592818961</c:v>
                  </c:pt>
                  <c:pt idx="17">
                    <c:v>270.178765855656</c:v>
                  </c:pt>
                  <c:pt idx="18">
                    <c:v>297.184788390882</c:v>
                  </c:pt>
                  <c:pt idx="19">
                    <c:v>1764.09786716881</c:v>
                  </c:pt>
                  <c:pt idx="20">
                    <c:v>6020.260936394543</c:v>
                  </c:pt>
                </c:numCache>
              </c:numRef>
            </c:plus>
            <c:minus>
              <c:numRef>
                <c:f>'Interfect species'!$AH$118:$AH$138</c:f>
                <c:numCache>
                  <c:formatCode>General</c:formatCode>
                  <c:ptCount val="21"/>
                  <c:pt idx="0">
                    <c:v>1289.469326805726</c:v>
                  </c:pt>
                  <c:pt idx="1">
                    <c:v>1414.264668386603</c:v>
                  </c:pt>
                  <c:pt idx="2">
                    <c:v>1389.821331742002</c:v>
                  </c:pt>
                  <c:pt idx="3">
                    <c:v>8318.792688084033</c:v>
                  </c:pt>
                  <c:pt idx="4">
                    <c:v>31022.26321093093</c:v>
                  </c:pt>
                  <c:pt idx="5">
                    <c:v>127903.5783246474</c:v>
                  </c:pt>
                  <c:pt idx="6">
                    <c:v>27670.34933258926</c:v>
                  </c:pt>
                  <c:pt idx="7">
                    <c:v>1167.30192919073</c:v>
                  </c:pt>
                  <c:pt idx="8">
                    <c:v>424.6762296982988</c:v>
                  </c:pt>
                  <c:pt idx="9">
                    <c:v>5233.310462927847</c:v>
                  </c:pt>
                  <c:pt idx="10">
                    <c:v>1955.347148536025</c:v>
                  </c:pt>
                  <c:pt idx="11">
                    <c:v>831.6733743487758</c:v>
                  </c:pt>
                  <c:pt idx="12">
                    <c:v>28018.41581015896</c:v>
                  </c:pt>
                  <c:pt idx="13">
                    <c:v>613.0430274534683</c:v>
                  </c:pt>
                  <c:pt idx="14">
                    <c:v>10765.94878312805</c:v>
                  </c:pt>
                  <c:pt idx="15">
                    <c:v>350.8935877438298</c:v>
                  </c:pt>
                  <c:pt idx="16">
                    <c:v>421.0852592818961</c:v>
                  </c:pt>
                  <c:pt idx="17">
                    <c:v>270.178765855656</c:v>
                  </c:pt>
                  <c:pt idx="18">
                    <c:v>297.184788390882</c:v>
                  </c:pt>
                  <c:pt idx="19">
                    <c:v>1764.09786716881</c:v>
                  </c:pt>
                  <c:pt idx="20">
                    <c:v>6020.2609363945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18:$Y$138</c:f>
              <c:strCache>
                <c:ptCount val="21"/>
                <c:pt idx="0">
                  <c:v>PG 14:0_16:0</c:v>
                </c:pt>
                <c:pt idx="1">
                  <c:v>PG 14:0_18:2</c:v>
                </c:pt>
                <c:pt idx="2">
                  <c:v>PG 16:0_16:0</c:v>
                </c:pt>
                <c:pt idx="3">
                  <c:v>PG 16:0_16:1</c:v>
                </c:pt>
                <c:pt idx="4">
                  <c:v>PG 16:0_18:0</c:v>
                </c:pt>
                <c:pt idx="5">
                  <c:v>PG 16:0_18:1</c:v>
                </c:pt>
                <c:pt idx="6">
                  <c:v>PG 16:0_20:1</c:v>
                </c:pt>
                <c:pt idx="7">
                  <c:v>PG 16:0_22:6</c:v>
                </c:pt>
                <c:pt idx="8">
                  <c:v>PG 16:0_22:6</c:v>
                </c:pt>
                <c:pt idx="9">
                  <c:v>PG 16:1_18:1</c:v>
                </c:pt>
                <c:pt idx="10">
                  <c:v>PG 16:1_22:6</c:v>
                </c:pt>
                <c:pt idx="11">
                  <c:v>PG 18:0_22:6</c:v>
                </c:pt>
                <c:pt idx="12">
                  <c:v>PG 18:1_18:1</c:v>
                </c:pt>
                <c:pt idx="13">
                  <c:v>PG 18:1_22:5</c:v>
                </c:pt>
                <c:pt idx="14">
                  <c:v>PG 18:1_22:6</c:v>
                </c:pt>
                <c:pt idx="15">
                  <c:v>PG 18:2_22:6</c:v>
                </c:pt>
                <c:pt idx="16">
                  <c:v>PG 20:3_22:6</c:v>
                </c:pt>
                <c:pt idx="17">
                  <c:v>PG 20:5_22:6</c:v>
                </c:pt>
                <c:pt idx="18">
                  <c:v>PG 22:4_22:6</c:v>
                </c:pt>
                <c:pt idx="19">
                  <c:v>PG 22:5_22:6</c:v>
                </c:pt>
                <c:pt idx="20">
                  <c:v>PG 22:6_22:6</c:v>
                </c:pt>
              </c:strCache>
            </c:strRef>
          </c:cat>
          <c:val>
            <c:numRef>
              <c:f>'Interfect species'!$AB$118:$AB$138</c:f>
              <c:numCache>
                <c:formatCode>General</c:formatCode>
                <c:ptCount val="21"/>
                <c:pt idx="0">
                  <c:v>9601.958343505865</c:v>
                </c:pt>
                <c:pt idx="1">
                  <c:v>6114.05487060547</c:v>
                </c:pt>
                <c:pt idx="2">
                  <c:v>6109.338724772136</c:v>
                </c:pt>
                <c:pt idx="3">
                  <c:v>38049.99259440106</c:v>
                </c:pt>
                <c:pt idx="4">
                  <c:v>204120.3703951648</c:v>
                </c:pt>
                <c:pt idx="5">
                  <c:v>587160.5209913574</c:v>
                </c:pt>
                <c:pt idx="6">
                  <c:v>137150.9711100263</c:v>
                </c:pt>
                <c:pt idx="7">
                  <c:v>8825.831370035808</c:v>
                </c:pt>
                <c:pt idx="8">
                  <c:v>3327.38375854492</c:v>
                </c:pt>
                <c:pt idx="9">
                  <c:v>22245.51516723633</c:v>
                </c:pt>
                <c:pt idx="10">
                  <c:v>15222.77424621582</c:v>
                </c:pt>
                <c:pt idx="11">
                  <c:v>8304.752583821617</c:v>
                </c:pt>
                <c:pt idx="12">
                  <c:v>81868.61234537762</c:v>
                </c:pt>
                <c:pt idx="13">
                  <c:v>7914.36334228516</c:v>
                </c:pt>
                <c:pt idx="14">
                  <c:v>70426.07859039305</c:v>
                </c:pt>
                <c:pt idx="15">
                  <c:v>3333.555984497072</c:v>
                </c:pt>
                <c:pt idx="16">
                  <c:v>2736.080647786457</c:v>
                </c:pt>
                <c:pt idx="17">
                  <c:v>2162.792747497558</c:v>
                </c:pt>
                <c:pt idx="18">
                  <c:v>1737.728515625002</c:v>
                </c:pt>
                <c:pt idx="19">
                  <c:v>12309.62280273439</c:v>
                </c:pt>
                <c:pt idx="20">
                  <c:v>47195.8581949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A4C-4EE3-9730-D6A4D5AC15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101806744"/>
        <c:axId val="2101810392"/>
      </c:barChart>
      <c:catAx>
        <c:axId val="2101806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1810392"/>
        <c:crosses val="autoZero"/>
        <c:auto val="1"/>
        <c:lblAlgn val="ctr"/>
        <c:lblOffset val="100"/>
        <c:noMultiLvlLbl val="0"/>
      </c:catAx>
      <c:valAx>
        <c:axId val="21018103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18067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terfect species'!$Z$145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F$146:$AF$153</c:f>
                <c:numCache>
                  <c:formatCode>General</c:formatCode>
                  <c:ptCount val="8"/>
                  <c:pt idx="0">
                    <c:v>254685.162422624</c:v>
                  </c:pt>
                  <c:pt idx="1">
                    <c:v>24144.66648131614</c:v>
                  </c:pt>
                  <c:pt idx="2">
                    <c:v>13928.35932996834</c:v>
                  </c:pt>
                  <c:pt idx="3">
                    <c:v>10141.56561200386</c:v>
                  </c:pt>
                  <c:pt idx="4">
                    <c:v>4177.991018835184</c:v>
                  </c:pt>
                  <c:pt idx="5">
                    <c:v>9455.198864439877</c:v>
                  </c:pt>
                  <c:pt idx="6">
                    <c:v>81219.3734026389</c:v>
                  </c:pt>
                  <c:pt idx="7">
                    <c:v>11149.4935144119</c:v>
                  </c:pt>
                </c:numCache>
              </c:numRef>
            </c:plus>
            <c:minus>
              <c:numRef>
                <c:f>'Interfect species'!$AF$146:$AF$153</c:f>
                <c:numCache>
                  <c:formatCode>General</c:formatCode>
                  <c:ptCount val="8"/>
                  <c:pt idx="0">
                    <c:v>254685.162422624</c:v>
                  </c:pt>
                  <c:pt idx="1">
                    <c:v>24144.66648131614</c:v>
                  </c:pt>
                  <c:pt idx="2">
                    <c:v>13928.35932996834</c:v>
                  </c:pt>
                  <c:pt idx="3">
                    <c:v>10141.56561200386</c:v>
                  </c:pt>
                  <c:pt idx="4">
                    <c:v>4177.991018835184</c:v>
                  </c:pt>
                  <c:pt idx="5">
                    <c:v>9455.198864439877</c:v>
                  </c:pt>
                  <c:pt idx="6">
                    <c:v>81219.3734026389</c:v>
                  </c:pt>
                  <c:pt idx="7">
                    <c:v>11149.49351441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46:$Y$153</c:f>
              <c:strCache>
                <c:ptCount val="8"/>
                <c:pt idx="0">
                  <c:v>SM d34:1</c:v>
                </c:pt>
                <c:pt idx="1">
                  <c:v>SM d36:1</c:v>
                </c:pt>
                <c:pt idx="2">
                  <c:v>SM d40:1</c:v>
                </c:pt>
                <c:pt idx="3">
                  <c:v>SM d40:2</c:v>
                </c:pt>
                <c:pt idx="4">
                  <c:v>SM d41:1</c:v>
                </c:pt>
                <c:pt idx="5">
                  <c:v>SM d41:2</c:v>
                </c:pt>
                <c:pt idx="6">
                  <c:v>SM d42:2</c:v>
                </c:pt>
                <c:pt idx="7">
                  <c:v>SM d42:3</c:v>
                </c:pt>
              </c:strCache>
            </c:strRef>
          </c:cat>
          <c:val>
            <c:numRef>
              <c:f>'Interfect species'!$Z$146:$Z$153</c:f>
              <c:numCache>
                <c:formatCode>General</c:formatCode>
                <c:ptCount val="8"/>
                <c:pt idx="0">
                  <c:v>543916.1362266405</c:v>
                </c:pt>
                <c:pt idx="1">
                  <c:v>112018.8136698406</c:v>
                </c:pt>
                <c:pt idx="2">
                  <c:v>81706.73860677083</c:v>
                </c:pt>
                <c:pt idx="3">
                  <c:v>85018.77055314946</c:v>
                </c:pt>
                <c:pt idx="4">
                  <c:v>25386.62174479167</c:v>
                </c:pt>
                <c:pt idx="5">
                  <c:v>93027.39897212916</c:v>
                </c:pt>
                <c:pt idx="6">
                  <c:v>605987.6627139584</c:v>
                </c:pt>
                <c:pt idx="7">
                  <c:v>112411.57902018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9CD-4CF5-92A5-171F477232A1}"/>
            </c:ext>
          </c:extLst>
        </c:ser>
        <c:ser>
          <c:idx val="1"/>
          <c:order val="1"/>
          <c:tx>
            <c:strRef>
              <c:f>'Interfect species'!$AA$145</c:f>
              <c:strCache>
                <c:ptCount val="1"/>
                <c:pt idx="0">
                  <c:v>INTERFER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G$146:$AG$153</c:f>
                <c:numCache>
                  <c:formatCode>General</c:formatCode>
                  <c:ptCount val="8"/>
                  <c:pt idx="0">
                    <c:v>60586.8816086791</c:v>
                  </c:pt>
                  <c:pt idx="1">
                    <c:v>15392.36795985549</c:v>
                  </c:pt>
                  <c:pt idx="2">
                    <c:v>9749.51023883572</c:v>
                  </c:pt>
                  <c:pt idx="3">
                    <c:v>9927.761890229521</c:v>
                  </c:pt>
                  <c:pt idx="4">
                    <c:v>3469.740567069497</c:v>
                  </c:pt>
                  <c:pt idx="5">
                    <c:v>13952.66197409333</c:v>
                  </c:pt>
                  <c:pt idx="6">
                    <c:v>88137.53231325388</c:v>
                  </c:pt>
                  <c:pt idx="7">
                    <c:v>11663.9139745431</c:v>
                  </c:pt>
                </c:numCache>
              </c:numRef>
            </c:plus>
            <c:minus>
              <c:numRef>
                <c:f>'Interfect species'!$AG$146:$AG$153</c:f>
                <c:numCache>
                  <c:formatCode>General</c:formatCode>
                  <c:ptCount val="8"/>
                  <c:pt idx="0">
                    <c:v>60586.8816086791</c:v>
                  </c:pt>
                  <c:pt idx="1">
                    <c:v>15392.36795985549</c:v>
                  </c:pt>
                  <c:pt idx="2">
                    <c:v>9749.51023883572</c:v>
                  </c:pt>
                  <c:pt idx="3">
                    <c:v>9927.761890229521</c:v>
                  </c:pt>
                  <c:pt idx="4">
                    <c:v>3469.740567069497</c:v>
                  </c:pt>
                  <c:pt idx="5">
                    <c:v>13952.66197409333</c:v>
                  </c:pt>
                  <c:pt idx="6">
                    <c:v>88137.53231325388</c:v>
                  </c:pt>
                  <c:pt idx="7">
                    <c:v>11663.91397454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46:$Y$153</c:f>
              <c:strCache>
                <c:ptCount val="8"/>
                <c:pt idx="0">
                  <c:v>SM d34:1</c:v>
                </c:pt>
                <c:pt idx="1">
                  <c:v>SM d36:1</c:v>
                </c:pt>
                <c:pt idx="2">
                  <c:v>SM d40:1</c:v>
                </c:pt>
                <c:pt idx="3">
                  <c:v>SM d40:2</c:v>
                </c:pt>
                <c:pt idx="4">
                  <c:v>SM d41:1</c:v>
                </c:pt>
                <c:pt idx="5">
                  <c:v>SM d41:2</c:v>
                </c:pt>
                <c:pt idx="6">
                  <c:v>SM d42:2</c:v>
                </c:pt>
                <c:pt idx="7">
                  <c:v>SM d42:3</c:v>
                </c:pt>
              </c:strCache>
            </c:strRef>
          </c:cat>
          <c:val>
            <c:numRef>
              <c:f>'Interfect species'!$AA$146:$AA$153</c:f>
              <c:numCache>
                <c:formatCode>General</c:formatCode>
                <c:ptCount val="8"/>
                <c:pt idx="0">
                  <c:v>656013.8643165288</c:v>
                </c:pt>
                <c:pt idx="1">
                  <c:v>103558.4870198568</c:v>
                </c:pt>
                <c:pt idx="2">
                  <c:v>89845.47037760417</c:v>
                </c:pt>
                <c:pt idx="3">
                  <c:v>88400.68120054605</c:v>
                </c:pt>
                <c:pt idx="4">
                  <c:v>26801.30192057291</c:v>
                </c:pt>
                <c:pt idx="5">
                  <c:v>91616.61686129925</c:v>
                </c:pt>
                <c:pt idx="6">
                  <c:v>590267.5319369622</c:v>
                </c:pt>
                <c:pt idx="7">
                  <c:v>107837.87516276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9CD-4CF5-92A5-171F477232A1}"/>
            </c:ext>
          </c:extLst>
        </c:ser>
        <c:ser>
          <c:idx val="2"/>
          <c:order val="2"/>
          <c:tx>
            <c:strRef>
              <c:f>'Interfect species'!$AB$145</c:f>
              <c:strCache>
                <c:ptCount val="1"/>
                <c:pt idx="0">
                  <c:v>INTERFERin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146:$AH$153</c:f>
                <c:numCache>
                  <c:formatCode>General</c:formatCode>
                  <c:ptCount val="8"/>
                  <c:pt idx="0">
                    <c:v>44436.60179727154</c:v>
                  </c:pt>
                  <c:pt idx="1">
                    <c:v>9906.935703130551</c:v>
                  </c:pt>
                  <c:pt idx="2">
                    <c:v>13612.21017573294</c:v>
                  </c:pt>
                  <c:pt idx="3">
                    <c:v>7978.65708555665</c:v>
                  </c:pt>
                  <c:pt idx="4">
                    <c:v>1935.094550187928</c:v>
                  </c:pt>
                  <c:pt idx="5">
                    <c:v>7613.20644021242</c:v>
                  </c:pt>
                  <c:pt idx="6">
                    <c:v>55812.75179209657</c:v>
                  </c:pt>
                  <c:pt idx="7">
                    <c:v>7530.932813085784</c:v>
                  </c:pt>
                </c:numCache>
              </c:numRef>
            </c:plus>
            <c:minus>
              <c:numRef>
                <c:f>'Interfect species'!$AH$146:$AH$153</c:f>
                <c:numCache>
                  <c:formatCode>General</c:formatCode>
                  <c:ptCount val="8"/>
                  <c:pt idx="0">
                    <c:v>44436.60179727154</c:v>
                  </c:pt>
                  <c:pt idx="1">
                    <c:v>9906.935703130551</c:v>
                  </c:pt>
                  <c:pt idx="2">
                    <c:v>13612.21017573294</c:v>
                  </c:pt>
                  <c:pt idx="3">
                    <c:v>7978.65708555665</c:v>
                  </c:pt>
                  <c:pt idx="4">
                    <c:v>1935.094550187928</c:v>
                  </c:pt>
                  <c:pt idx="5">
                    <c:v>7613.20644021242</c:v>
                  </c:pt>
                  <c:pt idx="6">
                    <c:v>55812.75179209657</c:v>
                  </c:pt>
                  <c:pt idx="7">
                    <c:v>7530.9328130857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46:$Y$153</c:f>
              <c:strCache>
                <c:ptCount val="8"/>
                <c:pt idx="0">
                  <c:v>SM d34:1</c:v>
                </c:pt>
                <c:pt idx="1">
                  <c:v>SM d36:1</c:v>
                </c:pt>
                <c:pt idx="2">
                  <c:v>SM d40:1</c:v>
                </c:pt>
                <c:pt idx="3">
                  <c:v>SM d40:2</c:v>
                </c:pt>
                <c:pt idx="4">
                  <c:v>SM d41:1</c:v>
                </c:pt>
                <c:pt idx="5">
                  <c:v>SM d41:2</c:v>
                </c:pt>
                <c:pt idx="6">
                  <c:v>SM d42:2</c:v>
                </c:pt>
                <c:pt idx="7">
                  <c:v>SM d42:3</c:v>
                </c:pt>
              </c:strCache>
            </c:strRef>
          </c:cat>
          <c:val>
            <c:numRef>
              <c:f>'Interfect species'!$AB$146:$AB$153</c:f>
              <c:numCache>
                <c:formatCode>General</c:formatCode>
                <c:ptCount val="8"/>
                <c:pt idx="0">
                  <c:v>651215.7800084186</c:v>
                </c:pt>
                <c:pt idx="1">
                  <c:v>83537.380607605</c:v>
                </c:pt>
                <c:pt idx="2">
                  <c:v>93534.23535156249</c:v>
                </c:pt>
                <c:pt idx="3">
                  <c:v>86811.06098182146</c:v>
                </c:pt>
                <c:pt idx="4">
                  <c:v>28274.19482421875</c:v>
                </c:pt>
                <c:pt idx="5">
                  <c:v>92430.07848887804</c:v>
                </c:pt>
                <c:pt idx="6">
                  <c:v>583874.0866371374</c:v>
                </c:pt>
                <c:pt idx="7">
                  <c:v>106354.20210774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9CD-4CF5-92A5-171F477232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101882904"/>
        <c:axId val="2101886600"/>
      </c:barChart>
      <c:catAx>
        <c:axId val="2101882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1886600"/>
        <c:crosses val="autoZero"/>
        <c:auto val="1"/>
        <c:lblAlgn val="ctr"/>
        <c:lblOffset val="100"/>
        <c:noMultiLvlLbl val="0"/>
      </c:catAx>
      <c:valAx>
        <c:axId val="21018866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1882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terfect species'!$Z$157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F$158:$AF$165</c:f>
                <c:numCache>
                  <c:formatCode>General</c:formatCode>
                  <c:ptCount val="8"/>
                  <c:pt idx="0">
                    <c:v>6957.03440166516</c:v>
                  </c:pt>
                  <c:pt idx="1">
                    <c:v>1390.810525559352</c:v>
                  </c:pt>
                  <c:pt idx="2">
                    <c:v>10291.09419758782</c:v>
                  </c:pt>
                  <c:pt idx="3">
                    <c:v>8685.788249049814</c:v>
                  </c:pt>
                  <c:pt idx="4">
                    <c:v>502.0484667182258</c:v>
                  </c:pt>
                  <c:pt idx="5">
                    <c:v>1391.999537142465</c:v>
                  </c:pt>
                  <c:pt idx="6">
                    <c:v>662.4010065767508</c:v>
                  </c:pt>
                  <c:pt idx="7">
                    <c:v>770.6106006942124</c:v>
                  </c:pt>
                </c:numCache>
              </c:numRef>
            </c:plus>
            <c:minus>
              <c:numRef>
                <c:f>'Interfect species'!$AF$158:$AF$165</c:f>
                <c:numCache>
                  <c:formatCode>General</c:formatCode>
                  <c:ptCount val="8"/>
                  <c:pt idx="0">
                    <c:v>6957.03440166516</c:v>
                  </c:pt>
                  <c:pt idx="1">
                    <c:v>1390.810525559352</c:v>
                  </c:pt>
                  <c:pt idx="2">
                    <c:v>10291.09419758782</c:v>
                  </c:pt>
                  <c:pt idx="3">
                    <c:v>8685.788249049814</c:v>
                  </c:pt>
                  <c:pt idx="4">
                    <c:v>502.0484667182258</c:v>
                  </c:pt>
                  <c:pt idx="5">
                    <c:v>1391.999537142465</c:v>
                  </c:pt>
                  <c:pt idx="6">
                    <c:v>662.4010065767508</c:v>
                  </c:pt>
                  <c:pt idx="7">
                    <c:v>770.61060069421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58:$Y$165</c:f>
              <c:strCache>
                <c:ptCount val="8"/>
                <c:pt idx="0">
                  <c:v>FA 22:2</c:v>
                </c:pt>
                <c:pt idx="1">
                  <c:v>FA 24:5</c:v>
                </c:pt>
                <c:pt idx="2">
                  <c:v>FA 22:6</c:v>
                </c:pt>
                <c:pt idx="3">
                  <c:v>FA 22:5</c:v>
                </c:pt>
                <c:pt idx="4">
                  <c:v>FA 24:6</c:v>
                </c:pt>
                <c:pt idx="5">
                  <c:v>FA 24:5</c:v>
                </c:pt>
                <c:pt idx="6">
                  <c:v>FA 26:6</c:v>
                </c:pt>
                <c:pt idx="7">
                  <c:v>FA 26:5</c:v>
                </c:pt>
              </c:strCache>
            </c:strRef>
          </c:cat>
          <c:val>
            <c:numRef>
              <c:f>'Interfect species'!$Z$158:$Z$165</c:f>
              <c:numCache>
                <c:formatCode>General</c:formatCode>
                <c:ptCount val="8"/>
                <c:pt idx="0">
                  <c:v>23720.05323678684</c:v>
                </c:pt>
                <c:pt idx="1">
                  <c:v>8062.206817525625</c:v>
                </c:pt>
                <c:pt idx="2">
                  <c:v>60408.26750370203</c:v>
                </c:pt>
                <c:pt idx="3">
                  <c:v>60452.26723056265</c:v>
                </c:pt>
                <c:pt idx="4">
                  <c:v>3503.832773000388</c:v>
                </c:pt>
                <c:pt idx="5">
                  <c:v>8063.824577681813</c:v>
                </c:pt>
                <c:pt idx="6">
                  <c:v>2620.657972373664</c:v>
                </c:pt>
                <c:pt idx="7">
                  <c:v>4442.9921871991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808-44D0-9013-067B34336E02}"/>
            </c:ext>
          </c:extLst>
        </c:ser>
        <c:ser>
          <c:idx val="1"/>
          <c:order val="1"/>
          <c:tx>
            <c:strRef>
              <c:f>'Interfect species'!$AA$157</c:f>
              <c:strCache>
                <c:ptCount val="1"/>
                <c:pt idx="0">
                  <c:v>INTERFER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G$158:$AG$165</c:f>
                <c:numCache>
                  <c:formatCode>General</c:formatCode>
                  <c:ptCount val="8"/>
                  <c:pt idx="0">
                    <c:v>2674.190877724845</c:v>
                  </c:pt>
                  <c:pt idx="1">
                    <c:v>1697.408267853568</c:v>
                  </c:pt>
                  <c:pt idx="2">
                    <c:v>8470.218152750954</c:v>
                  </c:pt>
                  <c:pt idx="3">
                    <c:v>9000.571199489799</c:v>
                  </c:pt>
                  <c:pt idx="4">
                    <c:v>615.4736408289031</c:v>
                  </c:pt>
                  <c:pt idx="5">
                    <c:v>1697.408267853568</c:v>
                  </c:pt>
                  <c:pt idx="6">
                    <c:v>719.7257384735216</c:v>
                  </c:pt>
                  <c:pt idx="7">
                    <c:v>1038.537913111504</c:v>
                  </c:pt>
                </c:numCache>
              </c:numRef>
            </c:plus>
            <c:minus>
              <c:numRef>
                <c:f>'Interfect species'!$AG$158:$AG$165</c:f>
                <c:numCache>
                  <c:formatCode>General</c:formatCode>
                  <c:ptCount val="8"/>
                  <c:pt idx="0">
                    <c:v>2674.190877724845</c:v>
                  </c:pt>
                  <c:pt idx="1">
                    <c:v>1697.408267853568</c:v>
                  </c:pt>
                  <c:pt idx="2">
                    <c:v>8470.218152750954</c:v>
                  </c:pt>
                  <c:pt idx="3">
                    <c:v>9000.571199489799</c:v>
                  </c:pt>
                  <c:pt idx="4">
                    <c:v>615.4736408289031</c:v>
                  </c:pt>
                  <c:pt idx="5">
                    <c:v>1697.408267853568</c:v>
                  </c:pt>
                  <c:pt idx="6">
                    <c:v>719.7257384735216</c:v>
                  </c:pt>
                  <c:pt idx="7">
                    <c:v>1038.5379131115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58:$Y$165</c:f>
              <c:strCache>
                <c:ptCount val="8"/>
                <c:pt idx="0">
                  <c:v>FA 22:2</c:v>
                </c:pt>
                <c:pt idx="1">
                  <c:v>FA 24:5</c:v>
                </c:pt>
                <c:pt idx="2">
                  <c:v>FA 22:6</c:v>
                </c:pt>
                <c:pt idx="3">
                  <c:v>FA 22:5</c:v>
                </c:pt>
                <c:pt idx="4">
                  <c:v>FA 24:6</c:v>
                </c:pt>
                <c:pt idx="5">
                  <c:v>FA 24:5</c:v>
                </c:pt>
                <c:pt idx="6">
                  <c:v>FA 26:6</c:v>
                </c:pt>
                <c:pt idx="7">
                  <c:v>FA 26:5</c:v>
                </c:pt>
              </c:strCache>
            </c:strRef>
          </c:cat>
          <c:val>
            <c:numRef>
              <c:f>'Interfect species'!$AA$158:$AA$165</c:f>
              <c:numCache>
                <c:formatCode>General</c:formatCode>
                <c:ptCount val="8"/>
                <c:pt idx="0">
                  <c:v>16901.99654234436</c:v>
                </c:pt>
                <c:pt idx="1">
                  <c:v>10775.90400390625</c:v>
                </c:pt>
                <c:pt idx="2">
                  <c:v>71241.92437494354</c:v>
                </c:pt>
                <c:pt idx="3">
                  <c:v>70915.24655852189</c:v>
                </c:pt>
                <c:pt idx="4">
                  <c:v>4718.78950750341</c:v>
                </c:pt>
                <c:pt idx="5">
                  <c:v>10775.90400390625</c:v>
                </c:pt>
                <c:pt idx="6">
                  <c:v>3901.116618771718</c:v>
                </c:pt>
                <c:pt idx="7">
                  <c:v>7097.0852706006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808-44D0-9013-067B34336E02}"/>
            </c:ext>
          </c:extLst>
        </c:ser>
        <c:ser>
          <c:idx val="2"/>
          <c:order val="2"/>
          <c:tx>
            <c:strRef>
              <c:f>'Interfect species'!$AB$157</c:f>
              <c:strCache>
                <c:ptCount val="1"/>
                <c:pt idx="0">
                  <c:v>INTERFERin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158:$AH$165</c:f>
                <c:numCache>
                  <c:formatCode>General</c:formatCode>
                  <c:ptCount val="8"/>
                  <c:pt idx="0">
                    <c:v>832.2724724726097</c:v>
                  </c:pt>
                  <c:pt idx="1">
                    <c:v>3587.779809055531</c:v>
                  </c:pt>
                  <c:pt idx="2">
                    <c:v>10794.99034773568</c:v>
                  </c:pt>
                  <c:pt idx="3">
                    <c:v>11215.85885975537</c:v>
                  </c:pt>
                  <c:pt idx="4">
                    <c:v>1366.092890115801</c:v>
                  </c:pt>
                  <c:pt idx="5">
                    <c:v>3588.102804044609</c:v>
                  </c:pt>
                  <c:pt idx="6">
                    <c:v>2256.523586921846</c:v>
                  </c:pt>
                  <c:pt idx="7">
                    <c:v>2997.612319221541</c:v>
                  </c:pt>
                </c:numCache>
              </c:numRef>
            </c:plus>
            <c:minus>
              <c:numRef>
                <c:f>'Interfect species'!$AH$158:$AH$165</c:f>
                <c:numCache>
                  <c:formatCode>General</c:formatCode>
                  <c:ptCount val="8"/>
                  <c:pt idx="0">
                    <c:v>832.2724724726097</c:v>
                  </c:pt>
                  <c:pt idx="1">
                    <c:v>3587.779809055531</c:v>
                  </c:pt>
                  <c:pt idx="2">
                    <c:v>10794.99034773568</c:v>
                  </c:pt>
                  <c:pt idx="3">
                    <c:v>11215.85885975537</c:v>
                  </c:pt>
                  <c:pt idx="4">
                    <c:v>1366.092890115801</c:v>
                  </c:pt>
                  <c:pt idx="5">
                    <c:v>3588.102804044609</c:v>
                  </c:pt>
                  <c:pt idx="6">
                    <c:v>2256.523586921846</c:v>
                  </c:pt>
                  <c:pt idx="7">
                    <c:v>2997.6123192215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58:$Y$165</c:f>
              <c:strCache>
                <c:ptCount val="8"/>
                <c:pt idx="0">
                  <c:v>FA 22:2</c:v>
                </c:pt>
                <c:pt idx="1">
                  <c:v>FA 24:5</c:v>
                </c:pt>
                <c:pt idx="2">
                  <c:v>FA 22:6</c:v>
                </c:pt>
                <c:pt idx="3">
                  <c:v>FA 22:5</c:v>
                </c:pt>
                <c:pt idx="4">
                  <c:v>FA 24:6</c:v>
                </c:pt>
                <c:pt idx="5">
                  <c:v>FA 24:5</c:v>
                </c:pt>
                <c:pt idx="6">
                  <c:v>FA 26:6</c:v>
                </c:pt>
                <c:pt idx="7">
                  <c:v>FA 26:5</c:v>
                </c:pt>
              </c:strCache>
            </c:strRef>
          </c:cat>
          <c:val>
            <c:numRef>
              <c:f>'Interfect species'!$AB$158:$AB$165</c:f>
              <c:numCache>
                <c:formatCode>General</c:formatCode>
                <c:ptCount val="8"/>
                <c:pt idx="0">
                  <c:v>12036.7452295989</c:v>
                </c:pt>
                <c:pt idx="1">
                  <c:v>13447.9548828125</c:v>
                </c:pt>
                <c:pt idx="2">
                  <c:v>71136.5690161762</c:v>
                </c:pt>
                <c:pt idx="3">
                  <c:v>69378.6376159137</c:v>
                </c:pt>
                <c:pt idx="4">
                  <c:v>6069.220905653194</c:v>
                </c:pt>
                <c:pt idx="5">
                  <c:v>13447.9548828125</c:v>
                </c:pt>
                <c:pt idx="6">
                  <c:v>5956.408263986212</c:v>
                </c:pt>
                <c:pt idx="7">
                  <c:v>9864.6855279634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808-44D0-9013-067B34336E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101962664"/>
        <c:axId val="2101966360"/>
      </c:barChart>
      <c:catAx>
        <c:axId val="2101962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1966360"/>
        <c:crosses val="autoZero"/>
        <c:auto val="1"/>
        <c:lblAlgn val="ctr"/>
        <c:lblOffset val="100"/>
        <c:noMultiLvlLbl val="0"/>
      </c:catAx>
      <c:valAx>
        <c:axId val="21019663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19626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terfect species'!$Z$170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F$171:$AF$174</c:f>
                <c:numCache>
                  <c:formatCode>General</c:formatCode>
                  <c:ptCount val="4"/>
                  <c:pt idx="0">
                    <c:v>3030.93089747649</c:v>
                  </c:pt>
                  <c:pt idx="1">
                    <c:v>2046.679367447959</c:v>
                  </c:pt>
                  <c:pt idx="2">
                    <c:v>5169.869259906961</c:v>
                  </c:pt>
                  <c:pt idx="3">
                    <c:v>9605.97851831495</c:v>
                  </c:pt>
                </c:numCache>
              </c:numRef>
            </c:plus>
            <c:minus>
              <c:numRef>
                <c:f>'Interfect species'!$AF$171:$AF$174</c:f>
                <c:numCache>
                  <c:formatCode>General</c:formatCode>
                  <c:ptCount val="4"/>
                  <c:pt idx="0">
                    <c:v>3030.93089747649</c:v>
                  </c:pt>
                  <c:pt idx="1">
                    <c:v>2046.679367447959</c:v>
                  </c:pt>
                  <c:pt idx="2">
                    <c:v>5169.869259906961</c:v>
                  </c:pt>
                  <c:pt idx="3">
                    <c:v>9605.978518314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71:$Y$174</c:f>
              <c:strCache>
                <c:ptCount val="4"/>
                <c:pt idx="0">
                  <c:v>GM3 d18:1_16:0</c:v>
                </c:pt>
                <c:pt idx="1">
                  <c:v>GM3 d18:1_22:0</c:v>
                </c:pt>
                <c:pt idx="2">
                  <c:v>GM3 d18:1_24:0</c:v>
                </c:pt>
                <c:pt idx="3">
                  <c:v>GM3 d18:1_24:1</c:v>
                </c:pt>
              </c:strCache>
            </c:strRef>
          </c:cat>
          <c:val>
            <c:numRef>
              <c:f>'Interfect species'!$Z$171:$Z$174</c:f>
              <c:numCache>
                <c:formatCode>General</c:formatCode>
                <c:ptCount val="4"/>
                <c:pt idx="0">
                  <c:v>21399.83772428033</c:v>
                </c:pt>
                <c:pt idx="1">
                  <c:v>13939.40581211863</c:v>
                </c:pt>
                <c:pt idx="2">
                  <c:v>27339.88179329067</c:v>
                </c:pt>
                <c:pt idx="3">
                  <c:v>59252.685953172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0E1-46C1-B9D9-B2EA562F709E}"/>
            </c:ext>
          </c:extLst>
        </c:ser>
        <c:ser>
          <c:idx val="1"/>
          <c:order val="1"/>
          <c:tx>
            <c:strRef>
              <c:f>'Interfect species'!$AA$170</c:f>
              <c:strCache>
                <c:ptCount val="1"/>
                <c:pt idx="0">
                  <c:v>INTERFER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G$171:$AG$174</c:f>
                <c:numCache>
                  <c:formatCode>General</c:formatCode>
                  <c:ptCount val="4"/>
                  <c:pt idx="0">
                    <c:v>7769.822317334158</c:v>
                  </c:pt>
                  <c:pt idx="1">
                    <c:v>5341.811371289068</c:v>
                  </c:pt>
                  <c:pt idx="2">
                    <c:v>10534.9136414967</c:v>
                  </c:pt>
                  <c:pt idx="3">
                    <c:v>22012.98414908523</c:v>
                  </c:pt>
                </c:numCache>
              </c:numRef>
            </c:plus>
            <c:minus>
              <c:numRef>
                <c:f>'Interfect species'!$AG$171:$AG$174</c:f>
                <c:numCache>
                  <c:formatCode>General</c:formatCode>
                  <c:ptCount val="4"/>
                  <c:pt idx="0">
                    <c:v>7769.822317334158</c:v>
                  </c:pt>
                  <c:pt idx="1">
                    <c:v>5341.811371289068</c:v>
                  </c:pt>
                  <c:pt idx="2">
                    <c:v>10534.9136414967</c:v>
                  </c:pt>
                  <c:pt idx="3">
                    <c:v>22012.984149085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71:$Y$174</c:f>
              <c:strCache>
                <c:ptCount val="4"/>
                <c:pt idx="0">
                  <c:v>GM3 d18:1_16:0</c:v>
                </c:pt>
                <c:pt idx="1">
                  <c:v>GM3 d18:1_22:0</c:v>
                </c:pt>
                <c:pt idx="2">
                  <c:v>GM3 d18:1_24:0</c:v>
                </c:pt>
                <c:pt idx="3">
                  <c:v>GM3 d18:1_24:1</c:v>
                </c:pt>
              </c:strCache>
            </c:strRef>
          </c:cat>
          <c:val>
            <c:numRef>
              <c:f>'Interfect species'!$AA$171:$AA$174</c:f>
              <c:numCache>
                <c:formatCode>General</c:formatCode>
                <c:ptCount val="4"/>
                <c:pt idx="0">
                  <c:v>27280.94009814554</c:v>
                </c:pt>
                <c:pt idx="1">
                  <c:v>19266.40659453229</c:v>
                </c:pt>
                <c:pt idx="2">
                  <c:v>39609.98735070358</c:v>
                </c:pt>
                <c:pt idx="3">
                  <c:v>76449.399134269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0E1-46C1-B9D9-B2EA562F709E}"/>
            </c:ext>
          </c:extLst>
        </c:ser>
        <c:ser>
          <c:idx val="2"/>
          <c:order val="2"/>
          <c:tx>
            <c:strRef>
              <c:f>'Interfect species'!$AB$170</c:f>
              <c:strCache>
                <c:ptCount val="1"/>
                <c:pt idx="0">
                  <c:v>INTERFERin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171:$AH$174</c:f>
                <c:numCache>
                  <c:formatCode>General</c:formatCode>
                  <c:ptCount val="4"/>
                  <c:pt idx="0">
                    <c:v>8328.579647805283</c:v>
                  </c:pt>
                  <c:pt idx="1">
                    <c:v>4794.617495541707</c:v>
                  </c:pt>
                  <c:pt idx="2">
                    <c:v>10615.63428856452</c:v>
                  </c:pt>
                  <c:pt idx="3">
                    <c:v>19833.64430497289</c:v>
                  </c:pt>
                </c:numCache>
              </c:numRef>
            </c:plus>
            <c:minus>
              <c:numRef>
                <c:f>'Interfect species'!$AH$171:$AH$174</c:f>
                <c:numCache>
                  <c:formatCode>General</c:formatCode>
                  <c:ptCount val="4"/>
                  <c:pt idx="0">
                    <c:v>8328.579647805283</c:v>
                  </c:pt>
                  <c:pt idx="1">
                    <c:v>4794.617495541707</c:v>
                  </c:pt>
                  <c:pt idx="2">
                    <c:v>10615.63428856452</c:v>
                  </c:pt>
                  <c:pt idx="3">
                    <c:v>19833.644304972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71:$Y$174</c:f>
              <c:strCache>
                <c:ptCount val="4"/>
                <c:pt idx="0">
                  <c:v>GM3 d18:1_16:0</c:v>
                </c:pt>
                <c:pt idx="1">
                  <c:v>GM3 d18:1_22:0</c:v>
                </c:pt>
                <c:pt idx="2">
                  <c:v>GM3 d18:1_24:0</c:v>
                </c:pt>
                <c:pt idx="3">
                  <c:v>GM3 d18:1_24:1</c:v>
                </c:pt>
              </c:strCache>
            </c:strRef>
          </c:cat>
          <c:val>
            <c:numRef>
              <c:f>'Interfect species'!$AB$171:$AB$174</c:f>
              <c:numCache>
                <c:formatCode>General</c:formatCode>
                <c:ptCount val="4"/>
                <c:pt idx="0">
                  <c:v>29285.12269452552</c:v>
                </c:pt>
                <c:pt idx="1">
                  <c:v>21499.57640332522</c:v>
                </c:pt>
                <c:pt idx="2">
                  <c:v>43296.18156969243</c:v>
                </c:pt>
                <c:pt idx="3">
                  <c:v>77327.848968270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0E1-46C1-B9D9-B2EA562F70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102040360"/>
        <c:axId val="2102044056"/>
      </c:barChart>
      <c:catAx>
        <c:axId val="2102040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2044056"/>
        <c:crosses val="autoZero"/>
        <c:auto val="1"/>
        <c:lblAlgn val="ctr"/>
        <c:lblOffset val="100"/>
        <c:noMultiLvlLbl val="0"/>
      </c:catAx>
      <c:valAx>
        <c:axId val="21020440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>
                    <a:effectLst/>
                  </a:rPr>
                  <a:t>Peak Height (counts) </a:t>
                </a:r>
                <a:endParaRPr lang="en-US" sz="110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20403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terfect species'!$Z$177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F$178:$AF$195</c:f>
                <c:numCache>
                  <c:formatCode>General</c:formatCode>
                  <c:ptCount val="18"/>
                  <c:pt idx="0">
                    <c:v>44350.24906270454</c:v>
                  </c:pt>
                  <c:pt idx="1">
                    <c:v>5916.475215703666</c:v>
                  </c:pt>
                  <c:pt idx="2">
                    <c:v>27153.90683324335</c:v>
                  </c:pt>
                  <c:pt idx="3">
                    <c:v>162495.9846953959</c:v>
                  </c:pt>
                  <c:pt idx="4">
                    <c:v>6980.323281821065</c:v>
                  </c:pt>
                  <c:pt idx="5">
                    <c:v>67794.07166157958</c:v>
                  </c:pt>
                  <c:pt idx="6">
                    <c:v>54580.17201457661</c:v>
                  </c:pt>
                  <c:pt idx="7">
                    <c:v>28518.47702245673</c:v>
                  </c:pt>
                  <c:pt idx="8">
                    <c:v>1158.443801729847</c:v>
                  </c:pt>
                  <c:pt idx="9">
                    <c:v>508924.0639673136</c:v>
                  </c:pt>
                  <c:pt idx="10">
                    <c:v>24626.39262986487</c:v>
                  </c:pt>
                  <c:pt idx="11">
                    <c:v>55466.06092701905</c:v>
                  </c:pt>
                  <c:pt idx="12">
                    <c:v>414869.1352971702</c:v>
                  </c:pt>
                  <c:pt idx="13">
                    <c:v>299030.5623183531</c:v>
                  </c:pt>
                  <c:pt idx="14">
                    <c:v>26938.72665325523</c:v>
                  </c:pt>
                  <c:pt idx="15">
                    <c:v>30650.7222694746</c:v>
                  </c:pt>
                  <c:pt idx="16">
                    <c:v>14206.2721075667</c:v>
                  </c:pt>
                  <c:pt idx="17">
                    <c:v>26008.64679897355</c:v>
                  </c:pt>
                </c:numCache>
              </c:numRef>
            </c:plus>
            <c:minus>
              <c:numRef>
                <c:f>'Interfect species'!$AF$178:$AF$195</c:f>
                <c:numCache>
                  <c:formatCode>General</c:formatCode>
                  <c:ptCount val="18"/>
                  <c:pt idx="0">
                    <c:v>44350.24906270454</c:v>
                  </c:pt>
                  <c:pt idx="1">
                    <c:v>5916.475215703666</c:v>
                  </c:pt>
                  <c:pt idx="2">
                    <c:v>27153.90683324335</c:v>
                  </c:pt>
                  <c:pt idx="3">
                    <c:v>162495.9846953959</c:v>
                  </c:pt>
                  <c:pt idx="4">
                    <c:v>6980.323281821065</c:v>
                  </c:pt>
                  <c:pt idx="5">
                    <c:v>67794.07166157958</c:v>
                  </c:pt>
                  <c:pt idx="6">
                    <c:v>54580.17201457661</c:v>
                  </c:pt>
                  <c:pt idx="7">
                    <c:v>28518.47702245673</c:v>
                  </c:pt>
                  <c:pt idx="8">
                    <c:v>1158.443801729847</c:v>
                  </c:pt>
                  <c:pt idx="9">
                    <c:v>508924.0639673136</c:v>
                  </c:pt>
                  <c:pt idx="10">
                    <c:v>24626.39262986487</c:v>
                  </c:pt>
                  <c:pt idx="11">
                    <c:v>55466.06092701905</c:v>
                  </c:pt>
                  <c:pt idx="12">
                    <c:v>414869.1352971702</c:v>
                  </c:pt>
                  <c:pt idx="13">
                    <c:v>299030.5623183531</c:v>
                  </c:pt>
                  <c:pt idx="14">
                    <c:v>26938.72665325523</c:v>
                  </c:pt>
                  <c:pt idx="15">
                    <c:v>30650.7222694746</c:v>
                  </c:pt>
                  <c:pt idx="16">
                    <c:v>14206.2721075667</c:v>
                  </c:pt>
                  <c:pt idx="17">
                    <c:v>26008.646798973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78:$Y$195</c:f>
              <c:strCache>
                <c:ptCount val="18"/>
                <c:pt idx="0">
                  <c:v>PI 16:0_20:4</c:v>
                </c:pt>
                <c:pt idx="1">
                  <c:v>PI 16:0_20:5</c:v>
                </c:pt>
                <c:pt idx="2">
                  <c:v>PI 16:0_22:6</c:v>
                </c:pt>
                <c:pt idx="3">
                  <c:v>PI 16:1_18:1</c:v>
                </c:pt>
                <c:pt idx="4">
                  <c:v>PI 16:1_20:4</c:v>
                </c:pt>
                <c:pt idx="5">
                  <c:v>PI 18:0_22:4</c:v>
                </c:pt>
                <c:pt idx="6">
                  <c:v>PI 18:0_22:5</c:v>
                </c:pt>
                <c:pt idx="7">
                  <c:v>PI 18:0_22:6_A</c:v>
                </c:pt>
                <c:pt idx="8">
                  <c:v>PI 18:0_22:6_B</c:v>
                </c:pt>
                <c:pt idx="9">
                  <c:v>PI 18:1_18:1</c:v>
                </c:pt>
                <c:pt idx="10">
                  <c:v>PI 18:1_18:2</c:v>
                </c:pt>
                <c:pt idx="11">
                  <c:v>PI 18:1_20:2</c:v>
                </c:pt>
                <c:pt idx="12">
                  <c:v>PI 18:1_20:3</c:v>
                </c:pt>
                <c:pt idx="13">
                  <c:v>PI 18:1_20:4</c:v>
                </c:pt>
                <c:pt idx="14">
                  <c:v>PI 18:1_20:5</c:v>
                </c:pt>
                <c:pt idx="15">
                  <c:v>PI 18:1_22:5</c:v>
                </c:pt>
                <c:pt idx="16">
                  <c:v>PI 18:1_22:6</c:v>
                </c:pt>
                <c:pt idx="17">
                  <c:v>PI 18:3_22:0</c:v>
                </c:pt>
              </c:strCache>
            </c:strRef>
          </c:cat>
          <c:val>
            <c:numRef>
              <c:f>'Interfect species'!$Z$178:$Z$195</c:f>
              <c:numCache>
                <c:formatCode>General</c:formatCode>
                <c:ptCount val="18"/>
                <c:pt idx="0">
                  <c:v>358227.597133201</c:v>
                </c:pt>
                <c:pt idx="1">
                  <c:v>48515.38492838544</c:v>
                </c:pt>
                <c:pt idx="2">
                  <c:v>215643.8873697917</c:v>
                </c:pt>
                <c:pt idx="3">
                  <c:v>1.02952195980813E6</c:v>
                </c:pt>
                <c:pt idx="4">
                  <c:v>51564.38558247356</c:v>
                </c:pt>
                <c:pt idx="5">
                  <c:v>207601.2876610385</c:v>
                </c:pt>
                <c:pt idx="6">
                  <c:v>364474.2060908724</c:v>
                </c:pt>
                <c:pt idx="7">
                  <c:v>128241.3655598961</c:v>
                </c:pt>
                <c:pt idx="8">
                  <c:v>12645.45764160158</c:v>
                </c:pt>
                <c:pt idx="9">
                  <c:v>3.54813240644794E6</c:v>
                </c:pt>
                <c:pt idx="10">
                  <c:v>143641.2954915365</c:v>
                </c:pt>
                <c:pt idx="11">
                  <c:v>398184.6356819682</c:v>
                </c:pt>
                <c:pt idx="12">
                  <c:v>4.16576700097054E6</c:v>
                </c:pt>
                <c:pt idx="13">
                  <c:v>2.14315644463267E6</c:v>
                </c:pt>
                <c:pt idx="14">
                  <c:v>217558.6338663537</c:v>
                </c:pt>
                <c:pt idx="15">
                  <c:v>135381.0026616453</c:v>
                </c:pt>
                <c:pt idx="16">
                  <c:v>105252.7181266538</c:v>
                </c:pt>
                <c:pt idx="17">
                  <c:v>118170.8897129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500-4541-8A2F-F6980B5759CF}"/>
            </c:ext>
          </c:extLst>
        </c:ser>
        <c:ser>
          <c:idx val="1"/>
          <c:order val="1"/>
          <c:tx>
            <c:strRef>
              <c:f>'Interfect species'!$AA$177</c:f>
              <c:strCache>
                <c:ptCount val="1"/>
                <c:pt idx="0">
                  <c:v>INTERFER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G$178:$AG$195</c:f>
                <c:numCache>
                  <c:formatCode>General</c:formatCode>
                  <c:ptCount val="18"/>
                  <c:pt idx="0">
                    <c:v>114198.366439849</c:v>
                  </c:pt>
                  <c:pt idx="1">
                    <c:v>16221.46195953267</c:v>
                  </c:pt>
                  <c:pt idx="2">
                    <c:v>66583.29751130134</c:v>
                  </c:pt>
                  <c:pt idx="3">
                    <c:v>381780.0984095452</c:v>
                  </c:pt>
                  <c:pt idx="4">
                    <c:v>17108.34846538824</c:v>
                  </c:pt>
                  <c:pt idx="5">
                    <c:v>102994.7182733791</c:v>
                  </c:pt>
                  <c:pt idx="6">
                    <c:v>140876.2657015955</c:v>
                  </c:pt>
                  <c:pt idx="7">
                    <c:v>45812.4421069541</c:v>
                  </c:pt>
                  <c:pt idx="8">
                    <c:v>2485.934524159351</c:v>
                  </c:pt>
                  <c:pt idx="9">
                    <c:v>1.14743267497291E6</c:v>
                  </c:pt>
                  <c:pt idx="10">
                    <c:v>48558.72489169813</c:v>
                  </c:pt>
                  <c:pt idx="11">
                    <c:v>121233.3841977423</c:v>
                  </c:pt>
                  <c:pt idx="12">
                    <c:v>1.34231145570233E6</c:v>
                  </c:pt>
                  <c:pt idx="13">
                    <c:v>792476.3080171458</c:v>
                  </c:pt>
                  <c:pt idx="14">
                    <c:v>67563.10598366713</c:v>
                  </c:pt>
                  <c:pt idx="15">
                    <c:v>48078.79719808095</c:v>
                  </c:pt>
                  <c:pt idx="16">
                    <c:v>32460.2224833308</c:v>
                  </c:pt>
                  <c:pt idx="17">
                    <c:v>16428.01295787494</c:v>
                  </c:pt>
                </c:numCache>
              </c:numRef>
            </c:plus>
            <c:minus>
              <c:numRef>
                <c:f>'Interfect species'!$AG$178:$AG$195</c:f>
                <c:numCache>
                  <c:formatCode>General</c:formatCode>
                  <c:ptCount val="18"/>
                  <c:pt idx="0">
                    <c:v>114198.366439849</c:v>
                  </c:pt>
                  <c:pt idx="1">
                    <c:v>16221.46195953267</c:v>
                  </c:pt>
                  <c:pt idx="2">
                    <c:v>66583.29751130134</c:v>
                  </c:pt>
                  <c:pt idx="3">
                    <c:v>381780.0984095452</c:v>
                  </c:pt>
                  <c:pt idx="4">
                    <c:v>17108.34846538824</c:v>
                  </c:pt>
                  <c:pt idx="5">
                    <c:v>102994.7182733791</c:v>
                  </c:pt>
                  <c:pt idx="6">
                    <c:v>140876.2657015955</c:v>
                  </c:pt>
                  <c:pt idx="7">
                    <c:v>45812.4421069541</c:v>
                  </c:pt>
                  <c:pt idx="8">
                    <c:v>2485.934524159351</c:v>
                  </c:pt>
                  <c:pt idx="9">
                    <c:v>1.14743267497291E6</c:v>
                  </c:pt>
                  <c:pt idx="10">
                    <c:v>48558.72489169813</c:v>
                  </c:pt>
                  <c:pt idx="11">
                    <c:v>121233.3841977423</c:v>
                  </c:pt>
                  <c:pt idx="12">
                    <c:v>1.34231145570233E6</c:v>
                  </c:pt>
                  <c:pt idx="13">
                    <c:v>792476.3080171458</c:v>
                  </c:pt>
                  <c:pt idx="14">
                    <c:v>67563.10598366713</c:v>
                  </c:pt>
                  <c:pt idx="15">
                    <c:v>48078.79719808095</c:v>
                  </c:pt>
                  <c:pt idx="16">
                    <c:v>32460.2224833308</c:v>
                  </c:pt>
                  <c:pt idx="17">
                    <c:v>16428.012957874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78:$Y$195</c:f>
              <c:strCache>
                <c:ptCount val="18"/>
                <c:pt idx="0">
                  <c:v>PI 16:0_20:4</c:v>
                </c:pt>
                <c:pt idx="1">
                  <c:v>PI 16:0_20:5</c:v>
                </c:pt>
                <c:pt idx="2">
                  <c:v>PI 16:0_22:6</c:v>
                </c:pt>
                <c:pt idx="3">
                  <c:v>PI 16:1_18:1</c:v>
                </c:pt>
                <c:pt idx="4">
                  <c:v>PI 16:1_20:4</c:v>
                </c:pt>
                <c:pt idx="5">
                  <c:v>PI 18:0_22:4</c:v>
                </c:pt>
                <c:pt idx="6">
                  <c:v>PI 18:0_22:5</c:v>
                </c:pt>
                <c:pt idx="7">
                  <c:v>PI 18:0_22:6_A</c:v>
                </c:pt>
                <c:pt idx="8">
                  <c:v>PI 18:0_22:6_B</c:v>
                </c:pt>
                <c:pt idx="9">
                  <c:v>PI 18:1_18:1</c:v>
                </c:pt>
                <c:pt idx="10">
                  <c:v>PI 18:1_18:2</c:v>
                </c:pt>
                <c:pt idx="11">
                  <c:v>PI 18:1_20:2</c:v>
                </c:pt>
                <c:pt idx="12">
                  <c:v>PI 18:1_20:3</c:v>
                </c:pt>
                <c:pt idx="13">
                  <c:v>PI 18:1_20:4</c:v>
                </c:pt>
                <c:pt idx="14">
                  <c:v>PI 18:1_20:5</c:v>
                </c:pt>
                <c:pt idx="15">
                  <c:v>PI 18:1_22:5</c:v>
                </c:pt>
                <c:pt idx="16">
                  <c:v>PI 18:1_22:6</c:v>
                </c:pt>
                <c:pt idx="17">
                  <c:v>PI 18:3_22:0</c:v>
                </c:pt>
              </c:strCache>
            </c:strRef>
          </c:cat>
          <c:val>
            <c:numRef>
              <c:f>'Interfect species'!$AA$178:$AA$195</c:f>
              <c:numCache>
                <c:formatCode>General</c:formatCode>
                <c:ptCount val="18"/>
                <c:pt idx="0">
                  <c:v>332138.993112401</c:v>
                </c:pt>
                <c:pt idx="1">
                  <c:v>43371.64274088541</c:v>
                </c:pt>
                <c:pt idx="2">
                  <c:v>211371.8698527019</c:v>
                </c:pt>
                <c:pt idx="3">
                  <c:v>1.23662324867164E6</c:v>
                </c:pt>
                <c:pt idx="4">
                  <c:v>46325.75382503812</c:v>
                </c:pt>
                <c:pt idx="5">
                  <c:v>210380.5794976216</c:v>
                </c:pt>
                <c:pt idx="6">
                  <c:v>340134.3948230009</c:v>
                </c:pt>
                <c:pt idx="7">
                  <c:v>148789.8155110678</c:v>
                </c:pt>
                <c:pt idx="8">
                  <c:v>11848.76330566407</c:v>
                </c:pt>
                <c:pt idx="9">
                  <c:v>3.33446980858182E6</c:v>
                </c:pt>
                <c:pt idx="10">
                  <c:v>161119.9074300133</c:v>
                </c:pt>
                <c:pt idx="11">
                  <c:v>365508.4356757992</c:v>
                </c:pt>
                <c:pt idx="12">
                  <c:v>3.63684436764E6</c:v>
                </c:pt>
                <c:pt idx="13">
                  <c:v>2.17101147851106E6</c:v>
                </c:pt>
                <c:pt idx="14">
                  <c:v>213059.0115342462</c:v>
                </c:pt>
                <c:pt idx="15">
                  <c:v>155075.2807227124</c:v>
                </c:pt>
                <c:pt idx="16">
                  <c:v>107526.8005224448</c:v>
                </c:pt>
                <c:pt idx="17">
                  <c:v>127793.361457153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500-4541-8A2F-F6980B5759CF}"/>
            </c:ext>
          </c:extLst>
        </c:ser>
        <c:ser>
          <c:idx val="2"/>
          <c:order val="2"/>
          <c:tx>
            <c:strRef>
              <c:f>'Interfect species'!$AB$177</c:f>
              <c:strCache>
                <c:ptCount val="1"/>
                <c:pt idx="0">
                  <c:v>INTERFERin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178:$AH$195</c:f>
                <c:numCache>
                  <c:formatCode>General</c:formatCode>
                  <c:ptCount val="18"/>
                  <c:pt idx="0">
                    <c:v>97950.31206555618</c:v>
                  </c:pt>
                  <c:pt idx="1">
                    <c:v>12072.37276821041</c:v>
                  </c:pt>
                  <c:pt idx="2">
                    <c:v>60107.76971098832</c:v>
                  </c:pt>
                  <c:pt idx="3">
                    <c:v>299142.0933082481</c:v>
                  </c:pt>
                  <c:pt idx="4">
                    <c:v>13191.58470231951</c:v>
                  </c:pt>
                  <c:pt idx="5">
                    <c:v>114171.8227066184</c:v>
                  </c:pt>
                  <c:pt idx="6">
                    <c:v>154111.2553379192</c:v>
                  </c:pt>
                  <c:pt idx="7">
                    <c:v>50580.46858027164</c:v>
                  </c:pt>
                  <c:pt idx="8">
                    <c:v>3467.076081621266</c:v>
                  </c:pt>
                  <c:pt idx="9">
                    <c:v>964161.819094676</c:v>
                  </c:pt>
                  <c:pt idx="10">
                    <c:v>45207.61483611697</c:v>
                  </c:pt>
                  <c:pt idx="11">
                    <c:v>129573.6550832357</c:v>
                  </c:pt>
                  <c:pt idx="12">
                    <c:v>1.33283686907403E6</c:v>
                  </c:pt>
                  <c:pt idx="13">
                    <c:v>666830.9804579818</c:v>
                  </c:pt>
                  <c:pt idx="14">
                    <c:v>61356.94648274333</c:v>
                  </c:pt>
                  <c:pt idx="15">
                    <c:v>53825.20169087335</c:v>
                  </c:pt>
                  <c:pt idx="16">
                    <c:v>33927.35122026641</c:v>
                  </c:pt>
                  <c:pt idx="17">
                    <c:v>36899.02390372883</c:v>
                  </c:pt>
                </c:numCache>
              </c:numRef>
            </c:plus>
            <c:minus>
              <c:numRef>
                <c:f>'Interfect species'!$AH$178:$AH$195</c:f>
                <c:numCache>
                  <c:formatCode>General</c:formatCode>
                  <c:ptCount val="18"/>
                  <c:pt idx="0">
                    <c:v>97950.31206555618</c:v>
                  </c:pt>
                  <c:pt idx="1">
                    <c:v>12072.37276821041</c:v>
                  </c:pt>
                  <c:pt idx="2">
                    <c:v>60107.76971098832</c:v>
                  </c:pt>
                  <c:pt idx="3">
                    <c:v>299142.0933082481</c:v>
                  </c:pt>
                  <c:pt idx="4">
                    <c:v>13191.58470231951</c:v>
                  </c:pt>
                  <c:pt idx="5">
                    <c:v>114171.8227066184</c:v>
                  </c:pt>
                  <c:pt idx="6">
                    <c:v>154111.2553379192</c:v>
                  </c:pt>
                  <c:pt idx="7">
                    <c:v>50580.46858027164</c:v>
                  </c:pt>
                  <c:pt idx="8">
                    <c:v>3467.076081621266</c:v>
                  </c:pt>
                  <c:pt idx="9">
                    <c:v>964161.819094676</c:v>
                  </c:pt>
                  <c:pt idx="10">
                    <c:v>45207.61483611697</c:v>
                  </c:pt>
                  <c:pt idx="11">
                    <c:v>129573.6550832357</c:v>
                  </c:pt>
                  <c:pt idx="12">
                    <c:v>1.33283686907403E6</c:v>
                  </c:pt>
                  <c:pt idx="13">
                    <c:v>666830.9804579818</c:v>
                  </c:pt>
                  <c:pt idx="14">
                    <c:v>61356.94648274333</c:v>
                  </c:pt>
                  <c:pt idx="15">
                    <c:v>53825.20169087335</c:v>
                  </c:pt>
                  <c:pt idx="16">
                    <c:v>33927.35122026641</c:v>
                  </c:pt>
                  <c:pt idx="17">
                    <c:v>36899.023903728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78:$Y$195</c:f>
              <c:strCache>
                <c:ptCount val="18"/>
                <c:pt idx="0">
                  <c:v>PI 16:0_20:4</c:v>
                </c:pt>
                <c:pt idx="1">
                  <c:v>PI 16:0_20:5</c:v>
                </c:pt>
                <c:pt idx="2">
                  <c:v>PI 16:0_22:6</c:v>
                </c:pt>
                <c:pt idx="3">
                  <c:v>PI 16:1_18:1</c:v>
                </c:pt>
                <c:pt idx="4">
                  <c:v>PI 16:1_20:4</c:v>
                </c:pt>
                <c:pt idx="5">
                  <c:v>PI 18:0_22:4</c:v>
                </c:pt>
                <c:pt idx="6">
                  <c:v>PI 18:0_22:5</c:v>
                </c:pt>
                <c:pt idx="7">
                  <c:v>PI 18:0_22:6_A</c:v>
                </c:pt>
                <c:pt idx="8">
                  <c:v>PI 18:0_22:6_B</c:v>
                </c:pt>
                <c:pt idx="9">
                  <c:v>PI 18:1_18:1</c:v>
                </c:pt>
                <c:pt idx="10">
                  <c:v>PI 18:1_18:2</c:v>
                </c:pt>
                <c:pt idx="11">
                  <c:v>PI 18:1_20:2</c:v>
                </c:pt>
                <c:pt idx="12">
                  <c:v>PI 18:1_20:3</c:v>
                </c:pt>
                <c:pt idx="13">
                  <c:v>PI 18:1_20:4</c:v>
                </c:pt>
                <c:pt idx="14">
                  <c:v>PI 18:1_20:5</c:v>
                </c:pt>
                <c:pt idx="15">
                  <c:v>PI 18:1_22:5</c:v>
                </c:pt>
                <c:pt idx="16">
                  <c:v>PI 18:1_22:6</c:v>
                </c:pt>
                <c:pt idx="17">
                  <c:v>PI 18:3_22:0</c:v>
                </c:pt>
              </c:strCache>
            </c:strRef>
          </c:cat>
          <c:val>
            <c:numRef>
              <c:f>'Interfect species'!$AB$178:$AB$195</c:f>
              <c:numCache>
                <c:formatCode>General</c:formatCode>
                <c:ptCount val="18"/>
                <c:pt idx="0">
                  <c:v>312017.1930355428</c:v>
                </c:pt>
                <c:pt idx="1">
                  <c:v>39899.522257487</c:v>
                </c:pt>
                <c:pt idx="2">
                  <c:v>197796.8169555666</c:v>
                </c:pt>
                <c:pt idx="3">
                  <c:v>991591.0911503216</c:v>
                </c:pt>
                <c:pt idx="4">
                  <c:v>42461.26550553046</c:v>
                </c:pt>
                <c:pt idx="5">
                  <c:v>231361.1525792782</c:v>
                </c:pt>
                <c:pt idx="6">
                  <c:v>390134.467313867</c:v>
                </c:pt>
                <c:pt idx="7">
                  <c:v>150960.0128580733</c:v>
                </c:pt>
                <c:pt idx="8">
                  <c:v>13147.60978190107</c:v>
                </c:pt>
                <c:pt idx="9">
                  <c:v>2.82088181121669E6</c:v>
                </c:pt>
                <c:pt idx="10">
                  <c:v>153020.1744384767</c:v>
                </c:pt>
                <c:pt idx="11">
                  <c:v>384868.5099101427</c:v>
                </c:pt>
                <c:pt idx="12">
                  <c:v>3.83074305687922E6</c:v>
                </c:pt>
                <c:pt idx="13">
                  <c:v>1.97023380186334E6</c:v>
                </c:pt>
                <c:pt idx="14">
                  <c:v>199965.0560601633</c:v>
                </c:pt>
                <c:pt idx="15">
                  <c:v>160189.6796169127</c:v>
                </c:pt>
                <c:pt idx="16">
                  <c:v>115234.4104311508</c:v>
                </c:pt>
                <c:pt idx="17">
                  <c:v>127922.84431894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500-4541-8A2F-F6980B5759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102124568"/>
        <c:axId val="2102128216"/>
      </c:barChart>
      <c:catAx>
        <c:axId val="2102124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2128216"/>
        <c:crosses val="autoZero"/>
        <c:auto val="1"/>
        <c:lblAlgn val="ctr"/>
        <c:lblOffset val="100"/>
        <c:noMultiLvlLbl val="0"/>
      </c:catAx>
      <c:valAx>
        <c:axId val="21021282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21245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terfect species'!$Z$198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F$199:$AF$202</c:f>
                <c:numCache>
                  <c:formatCode>General</c:formatCode>
                  <c:ptCount val="4"/>
                  <c:pt idx="0">
                    <c:v>88641.15571662358</c:v>
                  </c:pt>
                  <c:pt idx="1">
                    <c:v>239188.4870816278</c:v>
                  </c:pt>
                  <c:pt idx="2">
                    <c:v>54416.11776837327</c:v>
                  </c:pt>
                  <c:pt idx="3">
                    <c:v>22235.6700895389</c:v>
                  </c:pt>
                </c:numCache>
              </c:numRef>
            </c:plus>
            <c:minus>
              <c:numRef>
                <c:f>'Interfect species'!$AF$199:$AF$202</c:f>
                <c:numCache>
                  <c:formatCode>General</c:formatCode>
                  <c:ptCount val="4"/>
                  <c:pt idx="0">
                    <c:v>88641.15571662358</c:v>
                  </c:pt>
                  <c:pt idx="1">
                    <c:v>239188.4870816278</c:v>
                  </c:pt>
                  <c:pt idx="2">
                    <c:v>54416.11776837327</c:v>
                  </c:pt>
                  <c:pt idx="3">
                    <c:v>22235.67008953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99:$Y$202</c:f>
              <c:strCache>
                <c:ptCount val="4"/>
                <c:pt idx="0">
                  <c:v>PS 16:1_18:0</c:v>
                </c:pt>
                <c:pt idx="1">
                  <c:v>PS 18:0_18:1</c:v>
                </c:pt>
                <c:pt idx="2">
                  <c:v>PS 18:1_18:1</c:v>
                </c:pt>
                <c:pt idx="3">
                  <c:v>PS 18:1_21:2</c:v>
                </c:pt>
              </c:strCache>
            </c:strRef>
          </c:cat>
          <c:val>
            <c:numRef>
              <c:f>'Interfect species'!$Z$199:$Z$202</c:f>
              <c:numCache>
                <c:formatCode>General</c:formatCode>
                <c:ptCount val="4"/>
                <c:pt idx="0">
                  <c:v>695579.930338542</c:v>
                </c:pt>
                <c:pt idx="1">
                  <c:v>1.14446331901042E6</c:v>
                </c:pt>
                <c:pt idx="2">
                  <c:v>344049.5275065105</c:v>
                </c:pt>
                <c:pt idx="3">
                  <c:v>105396.20876613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1BF-4F70-AA19-0BEC26CF1446}"/>
            </c:ext>
          </c:extLst>
        </c:ser>
        <c:ser>
          <c:idx val="1"/>
          <c:order val="1"/>
          <c:tx>
            <c:strRef>
              <c:f>'Interfect species'!$AA$198</c:f>
              <c:strCache>
                <c:ptCount val="1"/>
                <c:pt idx="0">
                  <c:v>INTERFER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G$199:$AG$202</c:f>
                <c:numCache>
                  <c:formatCode>General</c:formatCode>
                  <c:ptCount val="4"/>
                  <c:pt idx="0">
                    <c:v>234690.51231849</c:v>
                  </c:pt>
                  <c:pt idx="1">
                    <c:v>482659.3851614172</c:v>
                  </c:pt>
                  <c:pt idx="2">
                    <c:v>124340.6767547029</c:v>
                  </c:pt>
                  <c:pt idx="3">
                    <c:v>18870.78305460825</c:v>
                  </c:pt>
                </c:numCache>
              </c:numRef>
            </c:plus>
            <c:minus>
              <c:numRef>
                <c:f>'Interfect species'!$AG$199:$AG$202</c:f>
                <c:numCache>
                  <c:formatCode>General</c:formatCode>
                  <c:ptCount val="4"/>
                  <c:pt idx="0">
                    <c:v>234690.51231849</c:v>
                  </c:pt>
                  <c:pt idx="1">
                    <c:v>482659.3851614172</c:v>
                  </c:pt>
                  <c:pt idx="2">
                    <c:v>124340.6767547029</c:v>
                  </c:pt>
                  <c:pt idx="3">
                    <c:v>18870.783054608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99:$Y$202</c:f>
              <c:strCache>
                <c:ptCount val="4"/>
                <c:pt idx="0">
                  <c:v>PS 16:1_18:0</c:v>
                </c:pt>
                <c:pt idx="1">
                  <c:v>PS 18:0_18:1</c:v>
                </c:pt>
                <c:pt idx="2">
                  <c:v>PS 18:1_18:1</c:v>
                </c:pt>
                <c:pt idx="3">
                  <c:v>PS 18:1_21:2</c:v>
                </c:pt>
              </c:strCache>
            </c:strRef>
          </c:cat>
          <c:val>
            <c:numRef>
              <c:f>'Interfect species'!$AA$199:$AA$202</c:f>
              <c:numCache>
                <c:formatCode>General</c:formatCode>
                <c:ptCount val="4"/>
                <c:pt idx="0">
                  <c:v>671385.4001464844</c:v>
                </c:pt>
                <c:pt idx="1">
                  <c:v>927900.7451171874</c:v>
                </c:pt>
                <c:pt idx="2">
                  <c:v>319097.7773437502</c:v>
                </c:pt>
                <c:pt idx="3">
                  <c:v>40555.031454275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1BF-4F70-AA19-0BEC26CF1446}"/>
            </c:ext>
          </c:extLst>
        </c:ser>
        <c:ser>
          <c:idx val="2"/>
          <c:order val="2"/>
          <c:tx>
            <c:strRef>
              <c:f>'Interfect species'!$AB$198</c:f>
              <c:strCache>
                <c:ptCount val="1"/>
                <c:pt idx="0">
                  <c:v>INTERFERin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nterfect species'!$AH$199:$AH$202</c:f>
                <c:numCache>
                  <c:formatCode>General</c:formatCode>
                  <c:ptCount val="4"/>
                  <c:pt idx="0">
                    <c:v>192614.740038255</c:v>
                  </c:pt>
                  <c:pt idx="1">
                    <c:v>452265.3354376954</c:v>
                  </c:pt>
                  <c:pt idx="2">
                    <c:v>103083.6517871136</c:v>
                  </c:pt>
                  <c:pt idx="3">
                    <c:v>19965.89857459602</c:v>
                  </c:pt>
                </c:numCache>
              </c:numRef>
            </c:plus>
            <c:minus>
              <c:numRef>
                <c:f>'Interfect species'!$AH$199:$AH$202</c:f>
                <c:numCache>
                  <c:formatCode>General</c:formatCode>
                  <c:ptCount val="4"/>
                  <c:pt idx="0">
                    <c:v>192614.740038255</c:v>
                  </c:pt>
                  <c:pt idx="1">
                    <c:v>452265.3354376954</c:v>
                  </c:pt>
                  <c:pt idx="2">
                    <c:v>103083.6517871136</c:v>
                  </c:pt>
                  <c:pt idx="3">
                    <c:v>19965.898574596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nterfect species'!$Y$199:$Y$202</c:f>
              <c:strCache>
                <c:ptCount val="4"/>
                <c:pt idx="0">
                  <c:v>PS 16:1_18:0</c:v>
                </c:pt>
                <c:pt idx="1">
                  <c:v>PS 18:0_18:1</c:v>
                </c:pt>
                <c:pt idx="2">
                  <c:v>PS 18:1_18:1</c:v>
                </c:pt>
                <c:pt idx="3">
                  <c:v>PS 18:1_21:2</c:v>
                </c:pt>
              </c:strCache>
            </c:strRef>
          </c:cat>
          <c:val>
            <c:numRef>
              <c:f>'Interfect species'!$AB$199:$AB$202</c:f>
              <c:numCache>
                <c:formatCode>General</c:formatCode>
                <c:ptCount val="4"/>
                <c:pt idx="0">
                  <c:v>590538.8226318364</c:v>
                </c:pt>
                <c:pt idx="1">
                  <c:v>901669.2408854167</c:v>
                </c:pt>
                <c:pt idx="2">
                  <c:v>285062.4685058595</c:v>
                </c:pt>
                <c:pt idx="3">
                  <c:v>46440.882753763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1BF-4F70-AA19-0BEC26CF14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101698200"/>
        <c:axId val="2101701624"/>
      </c:barChart>
      <c:catAx>
        <c:axId val="2101698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1701624"/>
        <c:crosses val="autoZero"/>
        <c:auto val="1"/>
        <c:lblAlgn val="ctr"/>
        <c:lblOffset val="100"/>
        <c:noMultiLvlLbl val="0"/>
      </c:catAx>
      <c:valAx>
        <c:axId val="21017016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16982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9897</cdr:x>
      <cdr:y>0.11304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2752233" y="90302"/>
          <a:ext cx="1147415" cy="2895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 err="1"/>
            <a:t>Cer</a:t>
          </a:r>
          <a:r>
            <a:rPr lang="en-US" sz="1800" b="1" dirty="0"/>
            <a:t> species</a:t>
          </a: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/>
            <a:t>DG species</a:t>
          </a:r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TG species</a:t>
          </a:r>
        </a:p>
        <a:p xmlns:a="http://schemas.openxmlformats.org/drawingml/2006/main">
          <a:endParaRPr lang="en-US" sz="1800" b="1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PE species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PC species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PG species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SM species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FA species</a:t>
          </a: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GM3 species</a:t>
          </a:r>
        </a:p>
        <a:p xmlns:a="http://schemas.openxmlformats.org/drawingml/2006/main">
          <a:endParaRPr lang="en-US" sz="1800" b="1" dirty="0"/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PI species</a:t>
          </a: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PS species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0536A53-9B07-4406-B3E9-06AA681EAC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1D360F31-E8D8-4606-B279-E0E9E991D8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2E474EB-2A23-4C56-841E-C0135F127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3227D58-9E35-4775-806E-52CAE7830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C7AE0C7-F6DA-4BE1-BC32-69E03155F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701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0A7E793-535A-4A72-B450-ABAD6559D9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23BF33C-B0C2-41EA-AE78-6E340CCA7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EEF2F57-6096-4445-836B-B86D738601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A4A995E-BC47-4C32-856C-FF3FE5211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3AAB115-9DC9-4C9D-AE1B-E9C315DE3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059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51B8CC90-5A95-4FAD-9F17-01FE54CD3F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3F2009AE-4817-4AB0-A48C-EFE2E4C7DA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F2DD61F-4B75-4022-855F-25026B3E9C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70F6002-80F5-411D-98F0-D5AA0A2FF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49D24BC-F7E4-48B9-8A76-E7E7D4CDD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78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59A5203-0AEE-47BF-B7C1-9E30B68EA8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6DC41DF-BE4D-46A5-9C46-6092566E8A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B7FFE43-5497-4D23-9EED-4D74ED278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977DD20-9B5C-4F6C-9A70-8BDDC206D2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7F48AB6-D1A2-40CA-9204-ECB99EA60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043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ECF3C04-FC20-4231-BCA1-D818750BE2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0F00C8E-C877-46CA-8414-B33CA080DF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A533423-3DC0-490C-BE4F-566F96D49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8EF0C49-2DF7-4481-BC1D-1AC9C97C0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C3C8D9F-9EB0-426A-8393-BB25752B7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177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6C49924-B3E1-49A7-9A14-1C04EDFDE0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01005D6-A185-445C-BC4A-A1E86C00B6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4195ABCF-76D2-4B3A-8958-2C5B236FA2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F528C8A-5225-400E-9B5B-54841F13E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F475393-B1FF-4B68-9470-A15C4E930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9582DEE-D824-4228-AAC3-792711A5C9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212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D571BF5-C8F3-48D4-8ACA-8F6D769301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A9CCF7A-668D-47AE-A2CB-9121EFECB3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C4B03F1-3964-477A-8EDA-710ADC482A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C04670FD-C114-45B1-AFA7-A3DF6F8045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46F250AB-8740-471F-AEAF-E1CF3922AA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5783CF6D-47C4-4B32-9F05-740B87EC8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E57B64B7-F6D9-4EC5-BDC0-323A9137C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DA6CCD4F-D6EC-4913-B1BE-025E49005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269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93BC0DA-7098-4287-A43D-DACA8140C9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F22C70A1-7DCF-4858-A357-132754BDE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D011173E-CC69-42CB-9ABD-CE4DE85A8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8B36CB2F-C089-4DA3-8A0E-5B0B3F2F2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236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C82FBD67-D61B-4ABD-B6DC-B85AFEF46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10DDE92E-A842-4C50-85E4-2A3FC49CA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CF7AFA98-8B98-443D-8BB9-598A0E966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191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8A01D21-5287-46F0-9242-7ADF0EDF7B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D3D9C51-D995-4A33-9A8B-F281117753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62C2C247-5A26-47B9-99F9-988E01DC96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98FFE9A-1958-44DF-8AEC-B9D0E116E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0B18CA5-4303-447B-A7E9-DD31A8E84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F9406B6-20F6-483B-98D8-DFCAFF1BF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311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54CF0D2-7DA7-4D5B-8D1B-6E6C0AEDA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977B615A-F93A-4BF3-9499-3E2C0FF9A5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881C4A3F-0BF3-4D03-9C08-1D395C1180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047EEC3-5B62-414B-ABF9-46D3AA8AF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210607C-C242-435E-926D-B6A54F6BE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EADF79D-E603-4790-B62D-B65CC36A3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443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84068AEF-9565-4F26-BB4B-0BD28D050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C6167F1-2A09-4A40-B452-840532CF42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98246BF-F095-4DB3-9646-5ECBFCBEB5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FBBAEED-F1BF-4144-B8A5-8F239094D6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F26857B-80F1-4570-B1AB-AED80F430C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697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0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8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xmlns="" id="{8CF5230F-2287-44C7-9DFD-A3D8C94324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9701940"/>
              </p:ext>
            </p:extLst>
          </p:nvPr>
        </p:nvGraphicFramePr>
        <p:xfrm>
          <a:off x="1548384" y="682752"/>
          <a:ext cx="10009632" cy="54620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2225692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xmlns="" id="{B3531491-B7C7-4D2A-90EB-15633135AA2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5832320"/>
              </p:ext>
            </p:extLst>
          </p:nvPr>
        </p:nvGraphicFramePr>
        <p:xfrm>
          <a:off x="801380" y="1545266"/>
          <a:ext cx="10573755" cy="4501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9948645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xmlns="" id="{5B9D90A0-6980-4ACD-A6F8-E6BB01750ED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8802160"/>
              </p:ext>
            </p:extLst>
          </p:nvPr>
        </p:nvGraphicFramePr>
        <p:xfrm>
          <a:off x="573024" y="560832"/>
          <a:ext cx="11021568" cy="58033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94305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D195F27B-8955-47BC-94D2-004EFF9884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5364155"/>
              </p:ext>
            </p:extLst>
          </p:nvPr>
        </p:nvGraphicFramePr>
        <p:xfrm>
          <a:off x="1072896" y="438912"/>
          <a:ext cx="10241280" cy="59984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426872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886BBD83-FCF3-4DE6-A2CB-667B2384B2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1733241"/>
              </p:ext>
            </p:extLst>
          </p:nvPr>
        </p:nvGraphicFramePr>
        <p:xfrm>
          <a:off x="1816608" y="792480"/>
          <a:ext cx="9729215" cy="5230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8839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9F79027B-7A7F-4CE4-B036-0B051A8D5B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6597504"/>
              </p:ext>
            </p:extLst>
          </p:nvPr>
        </p:nvGraphicFramePr>
        <p:xfrm>
          <a:off x="1926336" y="1057656"/>
          <a:ext cx="9278112" cy="4742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4044318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625DA398-7FA8-4139-9227-1E9DAE2135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3979068"/>
              </p:ext>
            </p:extLst>
          </p:nvPr>
        </p:nvGraphicFramePr>
        <p:xfrm>
          <a:off x="1706880" y="926592"/>
          <a:ext cx="8668512" cy="4730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2494991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0F1BAF3D-82E9-451F-A888-BF288534E7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0799071"/>
              </p:ext>
            </p:extLst>
          </p:nvPr>
        </p:nvGraphicFramePr>
        <p:xfrm>
          <a:off x="1524000" y="256032"/>
          <a:ext cx="8961120" cy="5596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203116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C1F232F7-FF35-48D9-B68B-978FC1715D4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2343568"/>
              </p:ext>
            </p:extLst>
          </p:nvPr>
        </p:nvGraphicFramePr>
        <p:xfrm>
          <a:off x="1633728" y="670560"/>
          <a:ext cx="9034271" cy="5718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226194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6AADD68E-B84E-4A5F-9F2C-B66E23FC1A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481721"/>
              </p:ext>
            </p:extLst>
          </p:nvPr>
        </p:nvGraphicFramePr>
        <p:xfrm>
          <a:off x="999744" y="633984"/>
          <a:ext cx="10582656" cy="5230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1831476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9E4193E3-0049-4EBF-9FEA-50A5B6E968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0702434"/>
              </p:ext>
            </p:extLst>
          </p:nvPr>
        </p:nvGraphicFramePr>
        <p:xfrm>
          <a:off x="2232953" y="984504"/>
          <a:ext cx="7726093" cy="43312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23793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996</TotalTime>
  <Words>87</Words>
  <Application>Microsoft Macintosh PowerPoint</Application>
  <PresentationFormat>Custom</PresentationFormat>
  <Paragraphs>22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ggert</dc:creator>
  <cp:lastModifiedBy>Riki Eggert</cp:lastModifiedBy>
  <cp:revision>10</cp:revision>
  <dcterms:created xsi:type="dcterms:W3CDTF">2019-04-18T13:17:57Z</dcterms:created>
  <dcterms:modified xsi:type="dcterms:W3CDTF">2019-04-29T14:02:27Z</dcterms:modified>
</cp:coreProperties>
</file>